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notesSlides/notesSlide1.xml" ContentType="application/vnd.openxmlformats-officedocument.presentationml.notesSlid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drawings/drawing1.xml" ContentType="application/vnd.openxmlformats-officedocument.drawingml.chartshapes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notesSlides/notesSlide2.xml" ContentType="application/vnd.openxmlformats-officedocument.presentationml.notesSlid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drawings/drawing2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83" r:id="rId2"/>
    <p:sldId id="258" r:id="rId3"/>
    <p:sldId id="284" r:id="rId4"/>
    <p:sldId id="287" r:id="rId5"/>
    <p:sldId id="269" r:id="rId6"/>
    <p:sldId id="285" r:id="rId7"/>
    <p:sldId id="286" r:id="rId8"/>
    <p:sldId id="262" r:id="rId9"/>
  </p:sldIdLst>
  <p:sldSz cx="12192000" cy="6858000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93D81CF-94F2-401A-BA57-92F5A7B2D0C5}" styleName="スタイル (中間)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FABFCF23-3B69-468F-B69F-88F6DE6A72F2}" styleName="中間スタイル 1 - アクセント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5">
              <a:tint val="20000"/>
            </a:schemeClr>
          </a:solidFill>
        </a:fill>
      </a:tcStyle>
    </a:band1H>
    <a:band1V>
      <a:tcStyle>
        <a:tcBdr/>
        <a:fill>
          <a:solidFill>
            <a:schemeClr val="accent5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20" autoAdjust="0"/>
    <p:restoredTop sz="89601" autoAdjust="0"/>
  </p:normalViewPr>
  <p:slideViewPr>
    <p:cSldViewPr snapToGrid="0">
      <p:cViewPr varScale="1">
        <p:scale>
          <a:sx n="107" d="100"/>
          <a:sy n="107" d="100"/>
        </p:scale>
        <p:origin x="384" y="102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15500\&#36960;&#38548;&#21307;&#30274;_&#21402;&#21172;&#31185;&#30740;\&#12450;&#12531;&#12465;&#12540;&#12488;&#35519;&#26619;\&#24739;&#32773;&#12539;&#20581;&#24120;&#32773;&#23550;&#35937;\Freeasy&#26412;&#35519;&#26619;\&#36960;&#38548;&#35386;&#30274;_freeasy&#26412;&#35519;&#26619;_&#38598;&#35336;_ALL_Background_20231115.ods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D:\15500\&#36960;&#38548;&#21307;&#30274;_&#21402;&#21172;&#31185;&#30740;\&#12450;&#12531;&#12465;&#12540;&#12488;&#35519;&#26619;\&#21307;&#30274;&#24467;&#20107;&#32773;&#12539;&#20107;&#21209;&#25285;&#24403;&#32773;&#23550;&#35937;\&#9733;&#9733;&#12450;&#12531;&#12465;&#12540;&#12488;&#22238;&#31572;\&#12458;&#12531;&#12521;&#12452;&#12531;&#35386;&#30274;&#12398;&#26222;&#21450;&#12434;&#38459;&#23475;&#12377;&#12427;&#22240;&#23376;&#12398;&#35519;&#26619;&#65288;&#22238;&#31572;&#65289;_&#36890;&#12375;&#30058;&#21495;&#20184;&#12365;_20240323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15500\&#36960;&#38548;&#21307;&#30274;_&#21402;&#21172;&#31185;&#30740;\&#12450;&#12531;&#12465;&#12540;&#12488;&#35519;&#26619;\&#21307;&#30274;&#24467;&#20107;&#32773;&#12539;&#20107;&#21209;&#25285;&#24403;&#32773;&#23550;&#35937;\&#9733;&#9733;&#12450;&#12531;&#12465;&#12540;&#12488;&#22238;&#31572;\&#12458;&#12531;&#12521;&#12452;&#12531;&#35386;&#30274;&#12398;&#26222;&#21450;&#12434;&#38459;&#23475;&#12377;&#12427;&#22240;&#23376;&#12398;&#35519;&#26619;&#65288;&#22238;&#31572;&#65289;_&#36890;&#12375;&#30058;&#21495;&#20184;&#12365;_20240323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15500\&#36960;&#38548;&#21307;&#30274;_&#21402;&#21172;&#31185;&#30740;\&#12450;&#12531;&#12465;&#12540;&#12488;&#35519;&#26619;\&#21307;&#30274;&#24467;&#20107;&#32773;&#12539;&#20107;&#21209;&#25285;&#24403;&#32773;&#23550;&#35937;\&#9733;&#9733;&#12450;&#12531;&#12465;&#12540;&#12488;&#22238;&#31572;\&#12458;&#12531;&#12521;&#12452;&#12531;&#35386;&#30274;&#12398;&#26222;&#21450;&#12434;&#38459;&#23475;&#12377;&#12427;&#22240;&#23376;&#12398;&#35519;&#26619;&#65288;&#22238;&#31572;&#65289;_&#36890;&#12375;&#30058;&#21495;&#20184;&#12365;_20240326_2.xlsx" TargetMode="External"/><Relationship Id="rId2" Type="http://schemas.microsoft.com/office/2011/relationships/chartColorStyle" Target="colors12.xml"/><Relationship Id="rId1" Type="http://schemas.microsoft.com/office/2011/relationships/chartStyle" Target="style12.xml"/><Relationship Id="rId4" Type="http://schemas.openxmlformats.org/officeDocument/2006/relationships/chartUserShapes" Target="../drawings/drawing2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15500\&#36960;&#38548;&#21307;&#30274;_&#21402;&#21172;&#31185;&#30740;\&#12450;&#12531;&#12465;&#12540;&#12488;&#35519;&#26619;\&#24739;&#32773;&#12539;&#20581;&#24120;&#32773;&#23550;&#35937;\Freeasy&#26412;&#35519;&#26619;\&#36960;&#38548;&#35386;&#30274;_freeasy&#26412;&#35519;&#26619;_&#38598;&#35336;_ALL_Background_20231115.ods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F:\15500\&#36960;&#38548;&#21307;&#30274;_&#21402;&#21172;&#31185;&#30740;\&#12450;&#12531;&#12465;&#12540;&#12488;&#35519;&#26619;\&#24739;&#32773;&#12539;&#20581;&#24120;&#32773;&#23550;&#35937;\Freeasy&#26412;&#35519;&#26619;\&#36960;&#38548;&#35386;&#30274;_freeasy&#26412;&#35519;&#26619;_&#38598;&#35336;.ods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F:\15500\&#36960;&#38548;&#21307;&#30274;_&#21402;&#21172;&#31185;&#30740;\&#12450;&#12531;&#12465;&#12540;&#12488;&#35519;&#26619;\&#24739;&#32773;&#12539;&#20581;&#24120;&#32773;&#23550;&#35937;\Freeasy&#26412;&#35519;&#26619;\&#36960;&#38548;&#35386;&#30274;_freeasy&#26412;&#35519;&#26619;_&#38598;&#35336;.ods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F:\15500\&#36960;&#38548;&#21307;&#30274;_&#21402;&#21172;&#31185;&#30740;\&#12450;&#12531;&#12465;&#12540;&#12488;&#35519;&#26619;\&#24739;&#32773;&#12539;&#20581;&#24120;&#32773;&#23550;&#35937;\Freeasy&#26412;&#35519;&#26619;\&#36960;&#38548;&#35386;&#30274;_freeasy&#26412;&#35519;&#26619;_&#38598;&#35336;_ALL_20231114.ods" TargetMode="External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chartUserShapes" Target="../drawings/drawing1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F:\15500\&#36960;&#38548;&#21307;&#30274;_&#21402;&#21172;&#31185;&#30740;\&#12450;&#12531;&#12465;&#12540;&#12488;&#35519;&#26619;\&#24739;&#32773;&#12539;&#20581;&#24120;&#32773;&#23550;&#35937;\Freeasy&#26412;&#35519;&#26619;\&#36960;&#38548;&#35386;&#30274;_freeasy&#26412;&#35519;&#26619;_&#38598;&#35336;_ALL_20231114.ods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F:\15500\&#36960;&#38548;&#21307;&#30274;_&#21402;&#21172;&#31185;&#30740;\&#12450;&#12531;&#12465;&#12540;&#12488;&#35519;&#26619;\&#24739;&#32773;&#12539;&#20581;&#24120;&#32773;&#23550;&#35937;\Freeasy&#26412;&#35519;&#26619;\&#36960;&#38548;&#35386;&#30274;_freeasy&#26412;&#35519;&#26619;_&#38598;&#35336;.ods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F:\15500\&#36960;&#38548;&#21307;&#30274;_&#21402;&#21172;&#31185;&#30740;\&#12450;&#12531;&#12465;&#12540;&#12488;&#35519;&#26619;\&#24739;&#32773;&#12539;&#20581;&#24120;&#32773;&#23550;&#35937;\Freeasy&#26412;&#35519;&#26619;\&#36960;&#38548;&#35386;&#30274;_freeasy&#26412;&#35519;&#26619;_&#38598;&#35336;.ods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D:\15500\&#36960;&#38548;&#21307;&#30274;_&#21402;&#21172;&#31185;&#30740;\&#12450;&#12531;&#12465;&#12540;&#12488;&#35519;&#26619;\&#21307;&#30274;&#24467;&#20107;&#32773;&#12539;&#20107;&#21209;&#25285;&#24403;&#32773;&#23550;&#35937;\&#9733;&#9733;&#12450;&#12531;&#12465;&#12540;&#12488;&#22238;&#31572;\&#12458;&#12531;&#12521;&#12452;&#12531;&#35386;&#30274;&#12398;&#26222;&#21450;&#12434;&#38459;&#23475;&#12377;&#12427;&#22240;&#23376;&#12398;&#35519;&#26619;&#65288;&#22238;&#31572;&#65289;_&#36890;&#12375;&#30058;&#21495;&#20184;&#12365;_20240323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5.95416290785434E-2"/>
          <c:y val="0.23863455747276874"/>
          <c:w val="0.9145272063764307"/>
          <c:h val="0.4388465460178818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age_sex!$Y$5</c:f>
              <c:strCache>
                <c:ptCount val="1"/>
                <c:pt idx="0">
                  <c:v>女性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age_sex!$X$6:$X$13</c:f>
              <c:strCache>
                <c:ptCount val="8"/>
                <c:pt idx="0">
                  <c:v>20歳代</c:v>
                </c:pt>
                <c:pt idx="1">
                  <c:v>30歳代</c:v>
                </c:pt>
                <c:pt idx="2">
                  <c:v>40歳代</c:v>
                </c:pt>
                <c:pt idx="3">
                  <c:v>50歳代</c:v>
                </c:pt>
                <c:pt idx="4">
                  <c:v>60歳代</c:v>
                </c:pt>
                <c:pt idx="5">
                  <c:v>70歳代</c:v>
                </c:pt>
                <c:pt idx="6">
                  <c:v>80歳代</c:v>
                </c:pt>
                <c:pt idx="7">
                  <c:v>90歳代以上</c:v>
                </c:pt>
              </c:strCache>
            </c:strRef>
          </c:cat>
          <c:val>
            <c:numRef>
              <c:f>age_sex!$Y$6:$Y$13</c:f>
              <c:numCache>
                <c:formatCode>General</c:formatCode>
                <c:ptCount val="8"/>
                <c:pt idx="0">
                  <c:v>80</c:v>
                </c:pt>
                <c:pt idx="1">
                  <c:v>40</c:v>
                </c:pt>
                <c:pt idx="2">
                  <c:v>36</c:v>
                </c:pt>
                <c:pt idx="3">
                  <c:v>22</c:v>
                </c:pt>
                <c:pt idx="4">
                  <c:v>10</c:v>
                </c:pt>
                <c:pt idx="5">
                  <c:v>8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026-4601-87E4-1E41DCB247C5}"/>
            </c:ext>
          </c:extLst>
        </c:ser>
        <c:ser>
          <c:idx val="1"/>
          <c:order val="1"/>
          <c:tx>
            <c:strRef>
              <c:f>age_sex!$Z$5</c:f>
              <c:strCache>
                <c:ptCount val="1"/>
                <c:pt idx="0">
                  <c:v>男性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age_sex!$X$6:$X$13</c:f>
              <c:strCache>
                <c:ptCount val="8"/>
                <c:pt idx="0">
                  <c:v>20歳代</c:v>
                </c:pt>
                <c:pt idx="1">
                  <c:v>30歳代</c:v>
                </c:pt>
                <c:pt idx="2">
                  <c:v>40歳代</c:v>
                </c:pt>
                <c:pt idx="3">
                  <c:v>50歳代</c:v>
                </c:pt>
                <c:pt idx="4">
                  <c:v>60歳代</c:v>
                </c:pt>
                <c:pt idx="5">
                  <c:v>70歳代</c:v>
                </c:pt>
                <c:pt idx="6">
                  <c:v>80歳代</c:v>
                </c:pt>
                <c:pt idx="7">
                  <c:v>90歳代以上</c:v>
                </c:pt>
              </c:strCache>
            </c:strRef>
          </c:cat>
          <c:val>
            <c:numRef>
              <c:f>age_sex!$Z$6:$Z$13</c:f>
              <c:numCache>
                <c:formatCode>General</c:formatCode>
                <c:ptCount val="8"/>
                <c:pt idx="0">
                  <c:v>42</c:v>
                </c:pt>
                <c:pt idx="1">
                  <c:v>59</c:v>
                </c:pt>
                <c:pt idx="2">
                  <c:v>49</c:v>
                </c:pt>
                <c:pt idx="3">
                  <c:v>26</c:v>
                </c:pt>
                <c:pt idx="4">
                  <c:v>15</c:v>
                </c:pt>
                <c:pt idx="5">
                  <c:v>14</c:v>
                </c:pt>
                <c:pt idx="6">
                  <c:v>2</c:v>
                </c:pt>
                <c:pt idx="7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026-4601-87E4-1E41DCB247C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58740616"/>
        <c:axId val="388359992"/>
      </c:barChart>
      <c:catAx>
        <c:axId val="5587406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388359992"/>
        <c:crosses val="autoZero"/>
        <c:auto val="1"/>
        <c:lblAlgn val="ctr"/>
        <c:lblOffset val="100"/>
        <c:noMultiLvlLbl val="0"/>
      </c:catAx>
      <c:valAx>
        <c:axId val="38835999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5874061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0480051379716149"/>
          <c:y val="0.84217377609084543"/>
          <c:w val="0.57153975802529633"/>
          <c:h val="0.1089033421943705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percentStacked"/>
        <c:varyColors val="0"/>
        <c:ser>
          <c:idx val="0"/>
          <c:order val="0"/>
          <c:tx>
            <c:strRef>
              <c:f>Sheet1!$P$2</c:f>
              <c:strCache>
                <c:ptCount val="1"/>
                <c:pt idx="0">
                  <c:v>0%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Q$1:$S$1</c:f>
              <c:strCache>
                <c:ptCount val="3"/>
                <c:pt idx="0">
                  <c:v>行っていない</c:v>
                </c:pt>
                <c:pt idx="1">
                  <c:v>自身は行っていない</c:v>
                </c:pt>
                <c:pt idx="2">
                  <c:v>自身も行っている</c:v>
                </c:pt>
              </c:strCache>
            </c:strRef>
          </c:cat>
          <c:val>
            <c:numRef>
              <c:f>Sheet1!$Q$2:$S$2</c:f>
              <c:numCache>
                <c:formatCode>General</c:formatCode>
                <c:ptCount val="3"/>
                <c:pt idx="0">
                  <c:v>161</c:v>
                </c:pt>
                <c:pt idx="1">
                  <c:v>18</c:v>
                </c:pt>
                <c:pt idx="2">
                  <c:v>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91F-467A-82D9-D0127261EF08}"/>
            </c:ext>
          </c:extLst>
        </c:ser>
        <c:ser>
          <c:idx val="1"/>
          <c:order val="1"/>
          <c:tx>
            <c:strRef>
              <c:f>Sheet1!$P$3</c:f>
              <c:strCache>
                <c:ptCount val="1"/>
                <c:pt idx="0">
                  <c:v>10%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Q$1:$S$1</c:f>
              <c:strCache>
                <c:ptCount val="3"/>
                <c:pt idx="0">
                  <c:v>行っていない</c:v>
                </c:pt>
                <c:pt idx="1">
                  <c:v>自身は行っていない</c:v>
                </c:pt>
                <c:pt idx="2">
                  <c:v>自身も行っている</c:v>
                </c:pt>
              </c:strCache>
            </c:strRef>
          </c:cat>
          <c:val>
            <c:numRef>
              <c:f>Sheet1!$Q$3:$S$3</c:f>
              <c:numCache>
                <c:formatCode>General</c:formatCode>
                <c:ptCount val="3"/>
                <c:pt idx="0">
                  <c:v>470</c:v>
                </c:pt>
                <c:pt idx="1">
                  <c:v>67</c:v>
                </c:pt>
                <c:pt idx="2">
                  <c:v>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91F-467A-82D9-D0127261EF08}"/>
            </c:ext>
          </c:extLst>
        </c:ser>
        <c:ser>
          <c:idx val="2"/>
          <c:order val="2"/>
          <c:tx>
            <c:strRef>
              <c:f>Sheet1!$P$4</c:f>
              <c:strCache>
                <c:ptCount val="1"/>
                <c:pt idx="0">
                  <c:v>20%</c:v>
                </c:pt>
              </c:strCache>
            </c:strRef>
          </c:tx>
          <c:spPr>
            <a:solidFill>
              <a:schemeClr val="bg2">
                <a:lumMod val="10000"/>
                <a:lumOff val="9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Q$1:$S$1</c:f>
              <c:strCache>
                <c:ptCount val="3"/>
                <c:pt idx="0">
                  <c:v>行っていない</c:v>
                </c:pt>
                <c:pt idx="1">
                  <c:v>自身は行っていない</c:v>
                </c:pt>
                <c:pt idx="2">
                  <c:v>自身も行っている</c:v>
                </c:pt>
              </c:strCache>
            </c:strRef>
          </c:cat>
          <c:val>
            <c:numRef>
              <c:f>Sheet1!$Q$4:$S$4</c:f>
              <c:numCache>
                <c:formatCode>General</c:formatCode>
                <c:ptCount val="3"/>
                <c:pt idx="0">
                  <c:v>232</c:v>
                </c:pt>
                <c:pt idx="1">
                  <c:v>23</c:v>
                </c:pt>
                <c:pt idx="2">
                  <c:v>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91F-467A-82D9-D0127261EF08}"/>
            </c:ext>
          </c:extLst>
        </c:ser>
        <c:ser>
          <c:idx val="3"/>
          <c:order val="3"/>
          <c:tx>
            <c:strRef>
              <c:f>Sheet1!$P$5</c:f>
              <c:strCache>
                <c:ptCount val="1"/>
                <c:pt idx="0">
                  <c:v>30%</c:v>
                </c:pt>
              </c:strCache>
            </c:strRef>
          </c:tx>
          <c:spPr>
            <a:solidFill>
              <a:schemeClr val="accent1">
                <a:lumMod val="40000"/>
                <a:lumOff val="6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Q$1:$S$1</c:f>
              <c:strCache>
                <c:ptCount val="3"/>
                <c:pt idx="0">
                  <c:v>行っていない</c:v>
                </c:pt>
                <c:pt idx="1">
                  <c:v>自身は行っていない</c:v>
                </c:pt>
                <c:pt idx="2">
                  <c:v>自身も行っている</c:v>
                </c:pt>
              </c:strCache>
            </c:strRef>
          </c:cat>
          <c:val>
            <c:numRef>
              <c:f>Sheet1!$Q$5:$S$5</c:f>
              <c:numCache>
                <c:formatCode>General</c:formatCode>
                <c:ptCount val="3"/>
                <c:pt idx="0">
                  <c:v>188</c:v>
                </c:pt>
                <c:pt idx="1">
                  <c:v>18</c:v>
                </c:pt>
                <c:pt idx="2">
                  <c:v>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091F-467A-82D9-D0127261EF08}"/>
            </c:ext>
          </c:extLst>
        </c:ser>
        <c:ser>
          <c:idx val="4"/>
          <c:order val="4"/>
          <c:tx>
            <c:strRef>
              <c:f>Sheet1!$P$6</c:f>
              <c:strCache>
                <c:ptCount val="1"/>
                <c:pt idx="0">
                  <c:v>40%</c:v>
                </c:pt>
              </c:strCache>
            </c:strRef>
          </c:tx>
          <c:spPr>
            <a:solidFill>
              <a:schemeClr val="bg2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Q$1:$S$1</c:f>
              <c:strCache>
                <c:ptCount val="3"/>
                <c:pt idx="0">
                  <c:v>行っていない</c:v>
                </c:pt>
                <c:pt idx="1">
                  <c:v>自身は行っていない</c:v>
                </c:pt>
                <c:pt idx="2">
                  <c:v>自身も行っている</c:v>
                </c:pt>
              </c:strCache>
            </c:strRef>
          </c:cat>
          <c:val>
            <c:numRef>
              <c:f>Sheet1!$Q$6:$S$6</c:f>
              <c:numCache>
                <c:formatCode>General</c:formatCode>
                <c:ptCount val="3"/>
                <c:pt idx="0">
                  <c:v>43</c:v>
                </c:pt>
                <c:pt idx="1">
                  <c:v>4</c:v>
                </c:pt>
                <c:pt idx="2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091F-467A-82D9-D0127261EF08}"/>
            </c:ext>
          </c:extLst>
        </c:ser>
        <c:ser>
          <c:idx val="5"/>
          <c:order val="5"/>
          <c:tx>
            <c:strRef>
              <c:f>Sheet1!$P$7</c:f>
              <c:strCache>
                <c:ptCount val="1"/>
                <c:pt idx="0">
                  <c:v>50%</c:v>
                </c:pt>
              </c:strCache>
            </c:strRef>
          </c:tx>
          <c:spPr>
            <a:solidFill>
              <a:srgbClr val="0070C0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Q$1:$S$1</c:f>
              <c:strCache>
                <c:ptCount val="3"/>
                <c:pt idx="0">
                  <c:v>行っていない</c:v>
                </c:pt>
                <c:pt idx="1">
                  <c:v>自身は行っていない</c:v>
                </c:pt>
                <c:pt idx="2">
                  <c:v>自身も行っている</c:v>
                </c:pt>
              </c:strCache>
            </c:strRef>
          </c:cat>
          <c:val>
            <c:numRef>
              <c:f>Sheet1!$Q$7:$S$7</c:f>
              <c:numCache>
                <c:formatCode>General</c:formatCode>
                <c:ptCount val="3"/>
                <c:pt idx="0">
                  <c:v>101</c:v>
                </c:pt>
                <c:pt idx="1">
                  <c:v>10</c:v>
                </c:pt>
                <c:pt idx="2">
                  <c:v>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091F-467A-82D9-D0127261EF08}"/>
            </c:ext>
          </c:extLst>
        </c:ser>
        <c:ser>
          <c:idx val="6"/>
          <c:order val="6"/>
          <c:tx>
            <c:strRef>
              <c:f>Sheet1!$P$8</c:f>
              <c:strCache>
                <c:ptCount val="1"/>
                <c:pt idx="0">
                  <c:v>60%</c:v>
                </c:pt>
              </c:strCache>
            </c:strRef>
          </c:tx>
          <c:spPr>
            <a:solidFill>
              <a:srgbClr val="FFFF00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Q$1:$S$1</c:f>
              <c:strCache>
                <c:ptCount val="3"/>
                <c:pt idx="0">
                  <c:v>行っていない</c:v>
                </c:pt>
                <c:pt idx="1">
                  <c:v>自身は行っていない</c:v>
                </c:pt>
                <c:pt idx="2">
                  <c:v>自身も行っている</c:v>
                </c:pt>
              </c:strCache>
            </c:strRef>
          </c:cat>
          <c:val>
            <c:numRef>
              <c:f>Sheet1!$Q$8:$S$8</c:f>
              <c:numCache>
                <c:formatCode>General</c:formatCode>
                <c:ptCount val="3"/>
                <c:pt idx="0">
                  <c:v>18</c:v>
                </c:pt>
                <c:pt idx="1">
                  <c:v>0</c:v>
                </c:pt>
                <c:pt idx="2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091F-467A-82D9-D0127261EF08}"/>
            </c:ext>
          </c:extLst>
        </c:ser>
        <c:ser>
          <c:idx val="7"/>
          <c:order val="7"/>
          <c:tx>
            <c:strRef>
              <c:f>Sheet1!$P$9</c:f>
              <c:strCache>
                <c:ptCount val="1"/>
                <c:pt idx="0">
                  <c:v>70%</c:v>
                </c:pt>
              </c:strCache>
            </c:strRef>
          </c:tx>
          <c:spPr>
            <a:solidFill>
              <a:srgbClr val="FFC000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Q$1:$S$1</c:f>
              <c:strCache>
                <c:ptCount val="3"/>
                <c:pt idx="0">
                  <c:v>行っていない</c:v>
                </c:pt>
                <c:pt idx="1">
                  <c:v>自身は行っていない</c:v>
                </c:pt>
                <c:pt idx="2">
                  <c:v>自身も行っている</c:v>
                </c:pt>
              </c:strCache>
            </c:strRef>
          </c:cat>
          <c:val>
            <c:numRef>
              <c:f>Sheet1!$Q$9:$S$9</c:f>
              <c:numCache>
                <c:formatCode>General</c:formatCode>
                <c:ptCount val="3"/>
                <c:pt idx="0">
                  <c:v>7</c:v>
                </c:pt>
                <c:pt idx="1">
                  <c:v>1</c:v>
                </c:pt>
                <c:pt idx="2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091F-467A-82D9-D0127261EF08}"/>
            </c:ext>
          </c:extLst>
        </c:ser>
        <c:ser>
          <c:idx val="8"/>
          <c:order val="8"/>
          <c:tx>
            <c:strRef>
              <c:f>Sheet1!$P$10</c:f>
              <c:strCache>
                <c:ptCount val="1"/>
                <c:pt idx="0">
                  <c:v>80%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1!$Q$1:$S$1</c:f>
              <c:strCache>
                <c:ptCount val="3"/>
                <c:pt idx="0">
                  <c:v>行っていない</c:v>
                </c:pt>
                <c:pt idx="1">
                  <c:v>自身は行っていない</c:v>
                </c:pt>
                <c:pt idx="2">
                  <c:v>自身も行っている</c:v>
                </c:pt>
              </c:strCache>
            </c:strRef>
          </c:cat>
          <c:val>
            <c:numRef>
              <c:f>Sheet1!$Q$10:$S$10</c:f>
              <c:numCache>
                <c:formatCode>General</c:formatCode>
                <c:ptCount val="3"/>
                <c:pt idx="0">
                  <c:v>1</c:v>
                </c:pt>
                <c:pt idx="1">
                  <c:v>1</c:v>
                </c:pt>
                <c:pt idx="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091F-467A-82D9-D0127261EF08}"/>
            </c:ext>
          </c:extLst>
        </c:ser>
        <c:ser>
          <c:idx val="9"/>
          <c:order val="9"/>
          <c:tx>
            <c:strRef>
              <c:f>Sheet1!$P$11</c:f>
              <c:strCache>
                <c:ptCount val="1"/>
                <c:pt idx="0">
                  <c:v>90%</c:v>
                </c:pt>
              </c:strCache>
            </c:strRef>
          </c:tx>
          <c:spPr>
            <a:solidFill>
              <a:schemeClr val="accent2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Q$1:$S$1</c:f>
              <c:strCache>
                <c:ptCount val="3"/>
                <c:pt idx="0">
                  <c:v>行っていない</c:v>
                </c:pt>
                <c:pt idx="1">
                  <c:v>自身は行っていない</c:v>
                </c:pt>
                <c:pt idx="2">
                  <c:v>自身も行っている</c:v>
                </c:pt>
              </c:strCache>
            </c:strRef>
          </c:cat>
          <c:val>
            <c:numRef>
              <c:f>Sheet1!$Q$11:$S$11</c:f>
              <c:numCache>
                <c:formatCode>General</c:formatCode>
                <c:ptCount val="3"/>
                <c:pt idx="0">
                  <c:v>1</c:v>
                </c:pt>
                <c:pt idx="1">
                  <c:v>0</c:v>
                </c:pt>
                <c:pt idx="2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091F-467A-82D9-D0127261EF08}"/>
            </c:ext>
          </c:extLst>
        </c:ser>
        <c:ser>
          <c:idx val="10"/>
          <c:order val="10"/>
          <c:tx>
            <c:strRef>
              <c:f>Sheet1!$P$12</c:f>
              <c:strCache>
                <c:ptCount val="1"/>
                <c:pt idx="0">
                  <c:v>100%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Q$1:$S$1</c:f>
              <c:strCache>
                <c:ptCount val="3"/>
                <c:pt idx="0">
                  <c:v>行っていない</c:v>
                </c:pt>
                <c:pt idx="1">
                  <c:v>自身は行っていない</c:v>
                </c:pt>
                <c:pt idx="2">
                  <c:v>自身も行っている</c:v>
                </c:pt>
              </c:strCache>
            </c:strRef>
          </c:cat>
          <c:val>
            <c:numRef>
              <c:f>Sheet1!$Q$12:$S$12</c:f>
              <c:numCache>
                <c:formatCode>General</c:formatCode>
                <c:ptCount val="3"/>
                <c:pt idx="0">
                  <c:v>2</c:v>
                </c:pt>
                <c:pt idx="1">
                  <c:v>0</c:v>
                </c:pt>
                <c:pt idx="2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091F-467A-82D9-D0127261EF0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550115536"/>
        <c:axId val="550111936"/>
      </c:barChart>
      <c:catAx>
        <c:axId val="55011553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defRPr>
            </a:pPr>
            <a:endParaRPr lang="ja-JP"/>
          </a:p>
        </c:txPr>
        <c:crossAx val="550111936"/>
        <c:crosses val="autoZero"/>
        <c:auto val="1"/>
        <c:lblAlgn val="ctr"/>
        <c:lblOffset val="100"/>
        <c:noMultiLvlLbl val="0"/>
      </c:catAx>
      <c:valAx>
        <c:axId val="55011193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5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defRPr>
            </a:pPr>
            <a:endParaRPr lang="ja-JP"/>
          </a:p>
        </c:txPr>
        <c:crossAx val="55011553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05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Arial" panose="020B0604020202020204" pitchFamily="34" charset="0"/>
          <a:ea typeface="游ゴシック" panose="020B0400000000000000" pitchFamily="50" charset="-128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710036990797358"/>
          <c:y val="5.8835990779974874E-2"/>
          <c:w val="0.83547213478385585"/>
          <c:h val="0.684425140361952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00B0F0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lang="ja-JP" sz="12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J$35:$J$43</c:f>
              <c:strCache>
                <c:ptCount val="9"/>
                <c:pt idx="0">
                  <c:v>50歳</c:v>
                </c:pt>
                <c:pt idx="1">
                  <c:v>55歳</c:v>
                </c:pt>
                <c:pt idx="2">
                  <c:v>60歳</c:v>
                </c:pt>
                <c:pt idx="3">
                  <c:v>65歳</c:v>
                </c:pt>
                <c:pt idx="4">
                  <c:v>70歳</c:v>
                </c:pt>
                <c:pt idx="5">
                  <c:v>75歳</c:v>
                </c:pt>
                <c:pt idx="6">
                  <c:v>80歳</c:v>
                </c:pt>
                <c:pt idx="7">
                  <c:v>85歳</c:v>
                </c:pt>
                <c:pt idx="8">
                  <c:v>年齢は関係ないと考える</c:v>
                </c:pt>
              </c:strCache>
            </c:strRef>
          </c:cat>
          <c:val>
            <c:numRef>
              <c:f>Sheet1!$K$35:$K$43</c:f>
              <c:numCache>
                <c:formatCode>General</c:formatCode>
                <c:ptCount val="9"/>
                <c:pt idx="0">
                  <c:v>242</c:v>
                </c:pt>
                <c:pt idx="1">
                  <c:v>98</c:v>
                </c:pt>
                <c:pt idx="2">
                  <c:v>369</c:v>
                </c:pt>
                <c:pt idx="3">
                  <c:v>272</c:v>
                </c:pt>
                <c:pt idx="4">
                  <c:v>160</c:v>
                </c:pt>
                <c:pt idx="5">
                  <c:v>58</c:v>
                </c:pt>
                <c:pt idx="6">
                  <c:v>8</c:v>
                </c:pt>
                <c:pt idx="7">
                  <c:v>1</c:v>
                </c:pt>
                <c:pt idx="8">
                  <c:v>34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FF2-4F60-9320-028B6B7C19A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49687168"/>
        <c:axId val="549687888"/>
      </c:barChart>
      <c:catAx>
        <c:axId val="5496871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defRPr>
            </a:pPr>
            <a:endParaRPr lang="ja-JP"/>
          </a:p>
        </c:txPr>
        <c:crossAx val="549687888"/>
        <c:crosses val="autoZero"/>
        <c:auto val="1"/>
        <c:lblAlgn val="ctr"/>
        <c:lblOffset val="100"/>
        <c:noMultiLvlLbl val="0"/>
      </c:catAx>
      <c:valAx>
        <c:axId val="54968788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2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defRPr>
                </a:pPr>
                <a:r>
                  <a:rPr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umber</a:t>
                </a:r>
                <a:r>
                  <a:rPr lang="en-US" altLang="ja-JP" baseline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of responses (N)</a:t>
                </a:r>
                <a:endParaRPr lang="ja-JP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2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defRPr>
            </a:pPr>
            <a:endParaRPr lang="ja-JP"/>
          </a:p>
        </c:txPr>
        <c:crossAx val="5496871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  <a:latin typeface="Arial" panose="020B0604020202020204" pitchFamily="34" charset="0"/>
          <a:ea typeface="游ゴシック" panose="020B0400000000000000" pitchFamily="50" charset="-128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354091591870696"/>
          <c:y val="5.6330531591670181E-2"/>
          <c:w val="0.73839287964958988"/>
          <c:h val="0.52423845919665479"/>
        </c:manualLayout>
      </c:layout>
      <c:barChart>
        <c:barDir val="bar"/>
        <c:grouping val="percentStacked"/>
        <c:varyColors val="0"/>
        <c:ser>
          <c:idx val="0"/>
          <c:order val="0"/>
          <c:tx>
            <c:strRef>
              <c:f>Sheet1!$N$35</c:f>
              <c:strCache>
                <c:ptCount val="1"/>
                <c:pt idx="0">
                  <c:v>50 y.o.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O$34:$Q$34</c:f>
              <c:strCache>
                <c:ptCount val="3"/>
                <c:pt idx="0">
                  <c:v>No</c:v>
                </c:pt>
                <c:pt idx="1">
                  <c:v>Yes/No *</c:v>
                </c:pt>
                <c:pt idx="2">
                  <c:v>Yes</c:v>
                </c:pt>
              </c:strCache>
            </c:strRef>
          </c:cat>
          <c:val>
            <c:numRef>
              <c:f>Sheet1!$O$35:$Q$35</c:f>
              <c:numCache>
                <c:formatCode>General</c:formatCode>
                <c:ptCount val="3"/>
                <c:pt idx="0">
                  <c:v>192</c:v>
                </c:pt>
                <c:pt idx="1">
                  <c:v>24</c:v>
                </c:pt>
                <c:pt idx="2">
                  <c:v>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661-487E-B9F0-56EE90F5036C}"/>
            </c:ext>
          </c:extLst>
        </c:ser>
        <c:ser>
          <c:idx val="1"/>
          <c:order val="1"/>
          <c:tx>
            <c:strRef>
              <c:f>Sheet1!$N$36</c:f>
              <c:strCache>
                <c:ptCount val="1"/>
                <c:pt idx="0">
                  <c:v>55.y.o.</c:v>
                </c:pt>
              </c:strCache>
            </c:strRef>
          </c:tx>
          <c:spPr>
            <a:solidFill>
              <a:schemeClr val="accent2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O$34:$Q$34</c:f>
              <c:strCache>
                <c:ptCount val="3"/>
                <c:pt idx="0">
                  <c:v>No</c:v>
                </c:pt>
                <c:pt idx="1">
                  <c:v>Yes/No *</c:v>
                </c:pt>
                <c:pt idx="2">
                  <c:v>Yes</c:v>
                </c:pt>
              </c:strCache>
            </c:strRef>
          </c:cat>
          <c:val>
            <c:numRef>
              <c:f>Sheet1!$O$36:$Q$36</c:f>
              <c:numCache>
                <c:formatCode>General</c:formatCode>
                <c:ptCount val="3"/>
                <c:pt idx="0">
                  <c:v>75</c:v>
                </c:pt>
                <c:pt idx="1">
                  <c:v>8</c:v>
                </c:pt>
                <c:pt idx="2">
                  <c:v>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661-487E-B9F0-56EE90F5036C}"/>
            </c:ext>
          </c:extLst>
        </c:ser>
        <c:ser>
          <c:idx val="2"/>
          <c:order val="2"/>
          <c:tx>
            <c:strRef>
              <c:f>Sheet1!$N$37</c:f>
              <c:strCache>
                <c:ptCount val="1"/>
                <c:pt idx="0">
                  <c:v>60 y.o.</c:v>
                </c:pt>
              </c:strCache>
            </c:strRef>
          </c:tx>
          <c:spPr>
            <a:solidFill>
              <a:schemeClr val="accent6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O$34:$Q$34</c:f>
              <c:strCache>
                <c:ptCount val="3"/>
                <c:pt idx="0">
                  <c:v>No</c:v>
                </c:pt>
                <c:pt idx="1">
                  <c:v>Yes/No *</c:v>
                </c:pt>
                <c:pt idx="2">
                  <c:v>Yes</c:v>
                </c:pt>
              </c:strCache>
            </c:strRef>
          </c:cat>
          <c:val>
            <c:numRef>
              <c:f>Sheet1!$O$37:$Q$37</c:f>
              <c:numCache>
                <c:formatCode>General</c:formatCode>
                <c:ptCount val="3"/>
                <c:pt idx="0">
                  <c:v>296</c:v>
                </c:pt>
                <c:pt idx="1">
                  <c:v>33</c:v>
                </c:pt>
                <c:pt idx="2">
                  <c:v>4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661-487E-B9F0-56EE90F5036C}"/>
            </c:ext>
          </c:extLst>
        </c:ser>
        <c:ser>
          <c:idx val="3"/>
          <c:order val="3"/>
          <c:tx>
            <c:strRef>
              <c:f>Sheet1!$N$38</c:f>
              <c:strCache>
                <c:ptCount val="1"/>
                <c:pt idx="0">
                  <c:v>65 y.o.</c:v>
                </c:pt>
              </c:strCache>
            </c:strRef>
          </c:tx>
          <c:spPr>
            <a:solidFill>
              <a:schemeClr val="accent6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O$34:$Q$34</c:f>
              <c:strCache>
                <c:ptCount val="3"/>
                <c:pt idx="0">
                  <c:v>No</c:v>
                </c:pt>
                <c:pt idx="1">
                  <c:v>Yes/No *</c:v>
                </c:pt>
                <c:pt idx="2">
                  <c:v>Yes</c:v>
                </c:pt>
              </c:strCache>
            </c:strRef>
          </c:cat>
          <c:val>
            <c:numRef>
              <c:f>Sheet1!$O$38:$Q$38</c:f>
              <c:numCache>
                <c:formatCode>General</c:formatCode>
                <c:ptCount val="3"/>
                <c:pt idx="0">
                  <c:v>212</c:v>
                </c:pt>
                <c:pt idx="1">
                  <c:v>29</c:v>
                </c:pt>
                <c:pt idx="2">
                  <c:v>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7661-487E-B9F0-56EE90F5036C}"/>
            </c:ext>
          </c:extLst>
        </c:ser>
        <c:ser>
          <c:idx val="4"/>
          <c:order val="4"/>
          <c:tx>
            <c:strRef>
              <c:f>Sheet1!$N$39</c:f>
              <c:strCache>
                <c:ptCount val="1"/>
                <c:pt idx="0">
                  <c:v>70 y.o.</c:v>
                </c:pt>
              </c:strCache>
            </c:strRef>
          </c:tx>
          <c:spPr>
            <a:solidFill>
              <a:schemeClr val="accent6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O$34:$Q$34</c:f>
              <c:strCache>
                <c:ptCount val="3"/>
                <c:pt idx="0">
                  <c:v>No</c:v>
                </c:pt>
                <c:pt idx="1">
                  <c:v>Yes/No *</c:v>
                </c:pt>
                <c:pt idx="2">
                  <c:v>Yes</c:v>
                </c:pt>
              </c:strCache>
            </c:strRef>
          </c:cat>
          <c:val>
            <c:numRef>
              <c:f>Sheet1!$O$39:$Q$39</c:f>
              <c:numCache>
                <c:formatCode>General</c:formatCode>
                <c:ptCount val="3"/>
                <c:pt idx="0">
                  <c:v>128</c:v>
                </c:pt>
                <c:pt idx="1">
                  <c:v>12</c:v>
                </c:pt>
                <c:pt idx="2">
                  <c:v>2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7661-487E-B9F0-56EE90F5036C}"/>
            </c:ext>
          </c:extLst>
        </c:ser>
        <c:ser>
          <c:idx val="5"/>
          <c:order val="5"/>
          <c:tx>
            <c:strRef>
              <c:f>Sheet1!$N$40</c:f>
              <c:strCache>
                <c:ptCount val="1"/>
                <c:pt idx="0">
                  <c:v>75 y.o.</c:v>
                </c:pt>
              </c:strCache>
            </c:strRef>
          </c:tx>
          <c:spPr>
            <a:solidFill>
              <a:schemeClr val="accent1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O$34:$Q$34</c:f>
              <c:strCache>
                <c:ptCount val="3"/>
                <c:pt idx="0">
                  <c:v>No</c:v>
                </c:pt>
                <c:pt idx="1">
                  <c:v>Yes/No *</c:v>
                </c:pt>
                <c:pt idx="2">
                  <c:v>Yes</c:v>
                </c:pt>
              </c:strCache>
            </c:strRef>
          </c:cat>
          <c:val>
            <c:numRef>
              <c:f>Sheet1!$O$40:$Q$40</c:f>
              <c:numCache>
                <c:formatCode>General</c:formatCode>
                <c:ptCount val="3"/>
                <c:pt idx="0">
                  <c:v>45</c:v>
                </c:pt>
                <c:pt idx="1">
                  <c:v>7</c:v>
                </c:pt>
                <c:pt idx="2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7661-487E-B9F0-56EE90F5036C}"/>
            </c:ext>
          </c:extLst>
        </c:ser>
        <c:ser>
          <c:idx val="6"/>
          <c:order val="6"/>
          <c:tx>
            <c:strRef>
              <c:f>Sheet1!$N$41</c:f>
              <c:strCache>
                <c:ptCount val="1"/>
                <c:pt idx="0">
                  <c:v>80 y.o.</c:v>
                </c:pt>
              </c:strCache>
            </c:strRef>
          </c:tx>
          <c:spPr>
            <a:solidFill>
              <a:srgbClr val="00B0F0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O$34:$Q$34</c:f>
              <c:strCache>
                <c:ptCount val="3"/>
                <c:pt idx="0">
                  <c:v>No</c:v>
                </c:pt>
                <c:pt idx="1">
                  <c:v>Yes/No *</c:v>
                </c:pt>
                <c:pt idx="2">
                  <c:v>Yes</c:v>
                </c:pt>
              </c:strCache>
            </c:strRef>
          </c:cat>
          <c:val>
            <c:numRef>
              <c:f>Sheet1!$O$41:$Q$41</c:f>
              <c:numCache>
                <c:formatCode>General</c:formatCode>
                <c:ptCount val="3"/>
                <c:pt idx="0">
                  <c:v>7</c:v>
                </c:pt>
                <c:pt idx="1">
                  <c:v>1</c:v>
                </c:pt>
                <c:pt idx="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7661-487E-B9F0-56EE90F5036C}"/>
            </c:ext>
          </c:extLst>
        </c:ser>
        <c:ser>
          <c:idx val="7"/>
          <c:order val="7"/>
          <c:tx>
            <c:strRef>
              <c:f>Sheet1!$N$42</c:f>
              <c:strCache>
                <c:ptCount val="1"/>
                <c:pt idx="0">
                  <c:v>85 y.o.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1!$O$34:$Q$34</c:f>
              <c:strCache>
                <c:ptCount val="3"/>
                <c:pt idx="0">
                  <c:v>No</c:v>
                </c:pt>
                <c:pt idx="1">
                  <c:v>Yes/No *</c:v>
                </c:pt>
                <c:pt idx="2">
                  <c:v>Yes</c:v>
                </c:pt>
              </c:strCache>
            </c:strRef>
          </c:cat>
          <c:val>
            <c:numRef>
              <c:f>Sheet1!$O$42:$Q$42</c:f>
              <c:numCache>
                <c:formatCode>General</c:formatCode>
                <c:ptCount val="3"/>
                <c:pt idx="0">
                  <c:v>1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7661-487E-B9F0-56EE90F5036C}"/>
            </c:ext>
          </c:extLst>
        </c:ser>
        <c:ser>
          <c:idx val="8"/>
          <c:order val="8"/>
          <c:tx>
            <c:strRef>
              <c:f>Sheet1!$N$43</c:f>
              <c:strCache>
                <c:ptCount val="1"/>
                <c:pt idx="0">
                  <c:v>Regardless of age</c:v>
                </c:pt>
              </c:strCache>
            </c:strRef>
          </c:tx>
          <c:spPr>
            <a:solidFill>
              <a:srgbClr val="FFFF00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O$34:$Q$34</c:f>
              <c:strCache>
                <c:ptCount val="3"/>
                <c:pt idx="0">
                  <c:v>No</c:v>
                </c:pt>
                <c:pt idx="1">
                  <c:v>Yes/No *</c:v>
                </c:pt>
                <c:pt idx="2">
                  <c:v>Yes</c:v>
                </c:pt>
              </c:strCache>
            </c:strRef>
          </c:cat>
          <c:val>
            <c:numRef>
              <c:f>Sheet1!$O$43:$Q$43</c:f>
              <c:numCache>
                <c:formatCode>General</c:formatCode>
                <c:ptCount val="3"/>
                <c:pt idx="0">
                  <c:v>268</c:v>
                </c:pt>
                <c:pt idx="1">
                  <c:v>28</c:v>
                </c:pt>
                <c:pt idx="2">
                  <c:v>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7661-487E-B9F0-56EE90F5036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550139656"/>
        <c:axId val="550134616"/>
      </c:barChart>
      <c:catAx>
        <c:axId val="55013965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5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50134616"/>
        <c:crosses val="autoZero"/>
        <c:auto val="1"/>
        <c:lblAlgn val="ctr"/>
        <c:lblOffset val="100"/>
        <c:noMultiLvlLbl val="0"/>
      </c:catAx>
      <c:valAx>
        <c:axId val="55013461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5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5013965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9013213647688892"/>
          <c:y val="0.71834210011673361"/>
          <c:w val="0.75331755716081827"/>
          <c:h val="0.2714159850484172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1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05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8668863852613869E-2"/>
          <c:y val="0.20930304045097048"/>
          <c:w val="0.83551649957940899"/>
          <c:h val="0.4731252127330363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age_sex!$AH$5</c:f>
              <c:strCache>
                <c:ptCount val="1"/>
                <c:pt idx="0">
                  <c:v>女性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age_sex!$AG$6:$AG$13</c:f>
              <c:strCache>
                <c:ptCount val="8"/>
                <c:pt idx="0">
                  <c:v>20歳代</c:v>
                </c:pt>
                <c:pt idx="1">
                  <c:v>30歳代</c:v>
                </c:pt>
                <c:pt idx="2">
                  <c:v>40歳代</c:v>
                </c:pt>
                <c:pt idx="3">
                  <c:v>50歳代</c:v>
                </c:pt>
                <c:pt idx="4">
                  <c:v>60歳代</c:v>
                </c:pt>
                <c:pt idx="5">
                  <c:v>70歳代</c:v>
                </c:pt>
                <c:pt idx="6">
                  <c:v>80歳代</c:v>
                </c:pt>
                <c:pt idx="7">
                  <c:v>90歳代以上</c:v>
                </c:pt>
              </c:strCache>
            </c:strRef>
          </c:cat>
          <c:val>
            <c:numRef>
              <c:f>age_sex!$AH$6:$AH$13</c:f>
              <c:numCache>
                <c:formatCode>General</c:formatCode>
                <c:ptCount val="8"/>
                <c:pt idx="0">
                  <c:v>427</c:v>
                </c:pt>
                <c:pt idx="1">
                  <c:v>237</c:v>
                </c:pt>
                <c:pt idx="2">
                  <c:v>206</c:v>
                </c:pt>
                <c:pt idx="3">
                  <c:v>134</c:v>
                </c:pt>
                <c:pt idx="4">
                  <c:v>54</c:v>
                </c:pt>
                <c:pt idx="5">
                  <c:v>37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52F-4665-A6DB-A0822A618A40}"/>
            </c:ext>
          </c:extLst>
        </c:ser>
        <c:ser>
          <c:idx val="1"/>
          <c:order val="1"/>
          <c:tx>
            <c:strRef>
              <c:f>age_sex!$AI$5</c:f>
              <c:strCache>
                <c:ptCount val="1"/>
                <c:pt idx="0">
                  <c:v>男性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age_sex!$AG$6:$AG$13</c:f>
              <c:strCache>
                <c:ptCount val="8"/>
                <c:pt idx="0">
                  <c:v>20歳代</c:v>
                </c:pt>
                <c:pt idx="1">
                  <c:v>30歳代</c:v>
                </c:pt>
                <c:pt idx="2">
                  <c:v>40歳代</c:v>
                </c:pt>
                <c:pt idx="3">
                  <c:v>50歳代</c:v>
                </c:pt>
                <c:pt idx="4">
                  <c:v>60歳代</c:v>
                </c:pt>
                <c:pt idx="5">
                  <c:v>70歳代</c:v>
                </c:pt>
                <c:pt idx="6">
                  <c:v>80歳代</c:v>
                </c:pt>
                <c:pt idx="7">
                  <c:v>90歳代以上</c:v>
                </c:pt>
              </c:strCache>
            </c:strRef>
          </c:cat>
          <c:val>
            <c:numRef>
              <c:f>age_sex!$AI$6:$AI$13</c:f>
              <c:numCache>
                <c:formatCode>General</c:formatCode>
                <c:ptCount val="8"/>
                <c:pt idx="0">
                  <c:v>257</c:v>
                </c:pt>
                <c:pt idx="1">
                  <c:v>312</c:v>
                </c:pt>
                <c:pt idx="2">
                  <c:v>258</c:v>
                </c:pt>
                <c:pt idx="3">
                  <c:v>140</c:v>
                </c:pt>
                <c:pt idx="4">
                  <c:v>82</c:v>
                </c:pt>
                <c:pt idx="5">
                  <c:v>70</c:v>
                </c:pt>
                <c:pt idx="6">
                  <c:v>10</c:v>
                </c:pt>
                <c:pt idx="7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52F-4665-A6DB-A0822A618A4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59555496"/>
        <c:axId val="559567736"/>
      </c:barChart>
      <c:catAx>
        <c:axId val="5595554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59567736"/>
        <c:crosses val="autoZero"/>
        <c:auto val="1"/>
        <c:lblAlgn val="ctr"/>
        <c:lblOffset val="100"/>
        <c:noMultiLvlLbl val="0"/>
      </c:catAx>
      <c:valAx>
        <c:axId val="55956773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5955549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1458319776143683E-2"/>
          <c:y val="0.20592104050605162"/>
          <c:w val="0.90256765424983032"/>
          <c:h val="0.5240560919284382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N$4</c:f>
              <c:strCache>
                <c:ptCount val="1"/>
                <c:pt idx="0">
                  <c:v>女性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12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M$5:$M$12</c:f>
              <c:strCache>
                <c:ptCount val="8"/>
                <c:pt idx="0">
                  <c:v>20歳代</c:v>
                </c:pt>
                <c:pt idx="1">
                  <c:v>30歳代</c:v>
                </c:pt>
                <c:pt idx="2">
                  <c:v>40歳代</c:v>
                </c:pt>
                <c:pt idx="3">
                  <c:v>50歳代</c:v>
                </c:pt>
                <c:pt idx="4">
                  <c:v>60歳代</c:v>
                </c:pt>
                <c:pt idx="5">
                  <c:v>70歳代</c:v>
                </c:pt>
                <c:pt idx="6">
                  <c:v>80歳代</c:v>
                </c:pt>
                <c:pt idx="7">
                  <c:v>90歳代以上</c:v>
                </c:pt>
              </c:strCache>
            </c:strRef>
          </c:cat>
          <c:val>
            <c:numRef>
              <c:f>Sheet1!$N$5:$N$12</c:f>
              <c:numCache>
                <c:formatCode>General</c:formatCode>
                <c:ptCount val="8"/>
                <c:pt idx="0">
                  <c:v>131</c:v>
                </c:pt>
                <c:pt idx="1">
                  <c:v>118</c:v>
                </c:pt>
                <c:pt idx="2">
                  <c:v>123</c:v>
                </c:pt>
                <c:pt idx="3">
                  <c:v>59</c:v>
                </c:pt>
                <c:pt idx="4">
                  <c:v>52</c:v>
                </c:pt>
                <c:pt idx="5">
                  <c:v>26</c:v>
                </c:pt>
                <c:pt idx="6">
                  <c:v>7</c:v>
                </c:pt>
                <c:pt idx="7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C33-4DB0-B97F-AD873EA090E4}"/>
            </c:ext>
          </c:extLst>
        </c:ser>
        <c:ser>
          <c:idx val="1"/>
          <c:order val="1"/>
          <c:tx>
            <c:strRef>
              <c:f>Sheet1!$O$4</c:f>
              <c:strCache>
                <c:ptCount val="1"/>
                <c:pt idx="0">
                  <c:v>男性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12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M$5:$M$12</c:f>
              <c:strCache>
                <c:ptCount val="8"/>
                <c:pt idx="0">
                  <c:v>20歳代</c:v>
                </c:pt>
                <c:pt idx="1">
                  <c:v>30歳代</c:v>
                </c:pt>
                <c:pt idx="2">
                  <c:v>40歳代</c:v>
                </c:pt>
                <c:pt idx="3">
                  <c:v>50歳代</c:v>
                </c:pt>
                <c:pt idx="4">
                  <c:v>60歳代</c:v>
                </c:pt>
                <c:pt idx="5">
                  <c:v>70歳代</c:v>
                </c:pt>
                <c:pt idx="6">
                  <c:v>80歳代</c:v>
                </c:pt>
                <c:pt idx="7">
                  <c:v>90歳代以上</c:v>
                </c:pt>
              </c:strCache>
            </c:strRef>
          </c:cat>
          <c:val>
            <c:numRef>
              <c:f>Sheet1!$O$5:$O$12</c:f>
              <c:numCache>
                <c:formatCode>General</c:formatCode>
                <c:ptCount val="8"/>
                <c:pt idx="0">
                  <c:v>176</c:v>
                </c:pt>
                <c:pt idx="1">
                  <c:v>182</c:v>
                </c:pt>
                <c:pt idx="2">
                  <c:v>180</c:v>
                </c:pt>
                <c:pt idx="3">
                  <c:v>105</c:v>
                </c:pt>
                <c:pt idx="4">
                  <c:v>67</c:v>
                </c:pt>
                <c:pt idx="5">
                  <c:v>67</c:v>
                </c:pt>
                <c:pt idx="6">
                  <c:v>10</c:v>
                </c:pt>
                <c:pt idx="7">
                  <c:v>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C33-4DB0-B97F-AD873EA090E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10552856"/>
        <c:axId val="610553576"/>
      </c:barChart>
      <c:catAx>
        <c:axId val="6105528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10553576"/>
        <c:crosses val="autoZero"/>
        <c:auto val="1"/>
        <c:lblAlgn val="ctr"/>
        <c:lblOffset val="100"/>
        <c:noMultiLvlLbl val="0"/>
      </c:catAx>
      <c:valAx>
        <c:axId val="61055357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1055285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1458319776143683E-2"/>
          <c:y val="0.22450980091185663"/>
          <c:w val="0.90256765424983032"/>
          <c:h val="0.5049064930650263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S$4</c:f>
              <c:strCache>
                <c:ptCount val="1"/>
                <c:pt idx="0">
                  <c:v>女性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12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R$5:$R$12</c:f>
              <c:strCache>
                <c:ptCount val="8"/>
                <c:pt idx="0">
                  <c:v>20歳代</c:v>
                </c:pt>
                <c:pt idx="1">
                  <c:v>30歳代</c:v>
                </c:pt>
                <c:pt idx="2">
                  <c:v>40歳代</c:v>
                </c:pt>
                <c:pt idx="3">
                  <c:v>50歳代</c:v>
                </c:pt>
                <c:pt idx="4">
                  <c:v>60歳代</c:v>
                </c:pt>
                <c:pt idx="5">
                  <c:v>70歳代</c:v>
                </c:pt>
                <c:pt idx="6">
                  <c:v>80歳代</c:v>
                </c:pt>
                <c:pt idx="7">
                  <c:v>90歳代以上</c:v>
                </c:pt>
              </c:strCache>
            </c:strRef>
          </c:cat>
          <c:val>
            <c:numRef>
              <c:f>Sheet1!$S$5:$S$12</c:f>
              <c:numCache>
                <c:formatCode>General</c:formatCode>
                <c:ptCount val="8"/>
                <c:pt idx="0">
                  <c:v>116</c:v>
                </c:pt>
                <c:pt idx="1">
                  <c:v>117</c:v>
                </c:pt>
                <c:pt idx="2">
                  <c:v>122</c:v>
                </c:pt>
                <c:pt idx="3">
                  <c:v>65</c:v>
                </c:pt>
                <c:pt idx="4">
                  <c:v>52</c:v>
                </c:pt>
                <c:pt idx="5">
                  <c:v>24</c:v>
                </c:pt>
                <c:pt idx="6">
                  <c:v>6</c:v>
                </c:pt>
                <c:pt idx="7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7E3-447C-8ED3-286D2244CCEC}"/>
            </c:ext>
          </c:extLst>
        </c:ser>
        <c:ser>
          <c:idx val="1"/>
          <c:order val="1"/>
          <c:tx>
            <c:strRef>
              <c:f>Sheet1!$T$4</c:f>
              <c:strCache>
                <c:ptCount val="1"/>
                <c:pt idx="0">
                  <c:v>男性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12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R$5:$R$12</c:f>
              <c:strCache>
                <c:ptCount val="8"/>
                <c:pt idx="0">
                  <c:v>20歳代</c:v>
                </c:pt>
                <c:pt idx="1">
                  <c:v>30歳代</c:v>
                </c:pt>
                <c:pt idx="2">
                  <c:v>40歳代</c:v>
                </c:pt>
                <c:pt idx="3">
                  <c:v>50歳代</c:v>
                </c:pt>
                <c:pt idx="4">
                  <c:v>60歳代</c:v>
                </c:pt>
                <c:pt idx="5">
                  <c:v>70歳代</c:v>
                </c:pt>
                <c:pt idx="6">
                  <c:v>80歳代</c:v>
                </c:pt>
                <c:pt idx="7">
                  <c:v>90歳代以上</c:v>
                </c:pt>
              </c:strCache>
            </c:strRef>
          </c:cat>
          <c:val>
            <c:numRef>
              <c:f>Sheet1!$T$5:$T$12</c:f>
              <c:numCache>
                <c:formatCode>General</c:formatCode>
                <c:ptCount val="8"/>
                <c:pt idx="0">
                  <c:v>158</c:v>
                </c:pt>
                <c:pt idx="1">
                  <c:v>183</c:v>
                </c:pt>
                <c:pt idx="2">
                  <c:v>168</c:v>
                </c:pt>
                <c:pt idx="3">
                  <c:v>110</c:v>
                </c:pt>
                <c:pt idx="4">
                  <c:v>70</c:v>
                </c:pt>
                <c:pt idx="5">
                  <c:v>72</c:v>
                </c:pt>
                <c:pt idx="6">
                  <c:v>17</c:v>
                </c:pt>
                <c:pt idx="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7E3-447C-8ED3-286D2244CCE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51902000"/>
        <c:axId val="451903800"/>
      </c:barChart>
      <c:catAx>
        <c:axId val="4519020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451903800"/>
        <c:crosses val="autoZero"/>
        <c:auto val="1"/>
        <c:lblAlgn val="ctr"/>
        <c:lblOffset val="100"/>
        <c:noMultiLvlLbl val="0"/>
      </c:catAx>
      <c:valAx>
        <c:axId val="45190380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45190200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67056534639239"/>
          <c:y val="0.36036520151137752"/>
          <c:w val="0.7648524057197551"/>
          <c:h val="0.47835147102891512"/>
        </c:manualLayout>
      </c:layout>
      <c:barChart>
        <c:barDir val="bar"/>
        <c:grouping val="stacked"/>
        <c:varyColors val="0"/>
        <c:ser>
          <c:idx val="0"/>
          <c:order val="0"/>
          <c:tx>
            <c:strRef>
              <c:f>Sheet1!$I$12</c:f>
              <c:strCache>
                <c:ptCount val="1"/>
                <c:pt idx="0">
                  <c:v>近くに医療機関が数多く存在する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1000" b="0" i="0" u="none" strike="noStrike" kern="1200" baseline="0">
                    <a:solidFill>
                      <a:schemeClr val="bg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J$11:$M$11</c:f>
              <c:strCache>
                <c:ptCount val="4"/>
                <c:pt idx="0">
                  <c:v>定期通院先なし/オンライン診療経験あり</c:v>
                </c:pt>
                <c:pt idx="1">
                  <c:v>定期通院先なし/オンライン診療経験なし</c:v>
                </c:pt>
                <c:pt idx="2">
                  <c:v>定期通院先あり/オンライン診療経験あり</c:v>
                </c:pt>
                <c:pt idx="3">
                  <c:v>定期通院先あり/オンライン診療経験なし</c:v>
                </c:pt>
              </c:strCache>
            </c:strRef>
          </c:cat>
          <c:val>
            <c:numRef>
              <c:f>Sheet1!$J$12:$M$12</c:f>
              <c:numCache>
                <c:formatCode>0.0_ </c:formatCode>
                <c:ptCount val="4"/>
                <c:pt idx="0">
                  <c:v>35.15</c:v>
                </c:pt>
                <c:pt idx="1">
                  <c:v>24.17</c:v>
                </c:pt>
                <c:pt idx="2">
                  <c:v>40.24</c:v>
                </c:pt>
                <c:pt idx="3">
                  <c:v>34.2700000000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7FB-4C15-8EFC-7CF5EDFE93E8}"/>
            </c:ext>
          </c:extLst>
        </c:ser>
        <c:ser>
          <c:idx val="1"/>
          <c:order val="1"/>
          <c:tx>
            <c:strRef>
              <c:f>Sheet1!$I$13</c:f>
              <c:strCache>
                <c:ptCount val="1"/>
                <c:pt idx="0">
                  <c:v>近くに医療機関がそれなりの数存在する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10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J$11:$M$11</c:f>
              <c:strCache>
                <c:ptCount val="4"/>
                <c:pt idx="0">
                  <c:v>定期通院先なし/オンライン診療経験あり</c:v>
                </c:pt>
                <c:pt idx="1">
                  <c:v>定期通院先なし/オンライン診療経験なし</c:v>
                </c:pt>
                <c:pt idx="2">
                  <c:v>定期通院先あり/オンライン診療経験あり</c:v>
                </c:pt>
                <c:pt idx="3">
                  <c:v>定期通院先あり/オンライン診療経験なし</c:v>
                </c:pt>
              </c:strCache>
            </c:strRef>
          </c:cat>
          <c:val>
            <c:numRef>
              <c:f>Sheet1!$J$13:$M$13</c:f>
              <c:numCache>
                <c:formatCode>0.0_ </c:formatCode>
                <c:ptCount val="4"/>
                <c:pt idx="0">
                  <c:v>48.76</c:v>
                </c:pt>
                <c:pt idx="1">
                  <c:v>50.76</c:v>
                </c:pt>
                <c:pt idx="2">
                  <c:v>50.23</c:v>
                </c:pt>
                <c:pt idx="3">
                  <c:v>52.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7FB-4C15-8EFC-7CF5EDFE93E8}"/>
            </c:ext>
          </c:extLst>
        </c:ser>
        <c:ser>
          <c:idx val="2"/>
          <c:order val="2"/>
          <c:tx>
            <c:strRef>
              <c:f>Sheet1!$I$14</c:f>
              <c:strCache>
                <c:ptCount val="1"/>
                <c:pt idx="0">
                  <c:v>近くに医療機関はあまり存在しない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10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J$11:$M$11</c:f>
              <c:strCache>
                <c:ptCount val="4"/>
                <c:pt idx="0">
                  <c:v>定期通院先なし/オンライン診療経験あり</c:v>
                </c:pt>
                <c:pt idx="1">
                  <c:v>定期通院先なし/オンライン診療経験なし</c:v>
                </c:pt>
                <c:pt idx="2">
                  <c:v>定期通院先あり/オンライン診療経験あり</c:v>
                </c:pt>
                <c:pt idx="3">
                  <c:v>定期通院先あり/オンライン診療経験なし</c:v>
                </c:pt>
              </c:strCache>
            </c:strRef>
          </c:cat>
          <c:val>
            <c:numRef>
              <c:f>Sheet1!$J$14:$M$14</c:f>
              <c:numCache>
                <c:formatCode>0.0_ </c:formatCode>
                <c:ptCount val="4"/>
                <c:pt idx="0">
                  <c:v>16.09</c:v>
                </c:pt>
                <c:pt idx="1">
                  <c:v>25.07</c:v>
                </c:pt>
                <c:pt idx="2">
                  <c:v>9.5299999999999994</c:v>
                </c:pt>
                <c:pt idx="3">
                  <c:v>13.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7FB-4C15-8EFC-7CF5EDFE93E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766884904"/>
        <c:axId val="766881664"/>
      </c:barChart>
      <c:catAx>
        <c:axId val="76688490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66881664"/>
        <c:crosses val="autoZero"/>
        <c:auto val="1"/>
        <c:lblAlgn val="ctr"/>
        <c:lblOffset val="100"/>
        <c:noMultiLvlLbl val="0"/>
      </c:catAx>
      <c:valAx>
        <c:axId val="766881664"/>
        <c:scaling>
          <c:orientation val="minMax"/>
          <c:max val="10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_ 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76688490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8.9470615385212088E-2"/>
          <c:y val="0.13406313519123944"/>
          <c:w val="0.7510936211284811"/>
          <c:h val="0.1891065248776430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  <c:userShapes r:id="rId4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0016650398039091"/>
          <c:y val="0.30799037532310014"/>
          <c:w val="0.62303793843951327"/>
          <c:h val="0.56896916995200164"/>
        </c:manualLayout>
      </c:layout>
      <c:barChart>
        <c:barDir val="bar"/>
        <c:grouping val="stacked"/>
        <c:varyColors val="0"/>
        <c:ser>
          <c:idx val="0"/>
          <c:order val="0"/>
          <c:tx>
            <c:strRef>
              <c:f>Sheet1!$I$29</c:f>
              <c:strCache>
                <c:ptCount val="1"/>
                <c:pt idx="0">
                  <c:v>かなり手間がかかる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1000" b="0" i="0" u="none" strike="noStrike" kern="1200" baseline="0">
                    <a:solidFill>
                      <a:schemeClr val="bg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J$28:$M$28</c:f>
              <c:strCache>
                <c:ptCount val="4"/>
                <c:pt idx="0">
                  <c:v>定期通院先なし/オンライン診療経験あり</c:v>
                </c:pt>
                <c:pt idx="1">
                  <c:v>定期通院先なし/オンライン診療経験なし</c:v>
                </c:pt>
                <c:pt idx="2">
                  <c:v>定期通院先あり/オンライン診療経験あり</c:v>
                </c:pt>
                <c:pt idx="3">
                  <c:v>定期通院先あり/オンライン診療経験なし</c:v>
                </c:pt>
              </c:strCache>
            </c:strRef>
          </c:cat>
          <c:val>
            <c:numRef>
              <c:f>Sheet1!$J$29:$M$29</c:f>
              <c:numCache>
                <c:formatCode>0.0_ </c:formatCode>
                <c:ptCount val="4"/>
                <c:pt idx="0">
                  <c:v>16.579999999999998</c:v>
                </c:pt>
                <c:pt idx="1">
                  <c:v>8.6300000000000008</c:v>
                </c:pt>
                <c:pt idx="2">
                  <c:v>15.55</c:v>
                </c:pt>
                <c:pt idx="3">
                  <c:v>9.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4A0-412D-8C96-186BE41A3181}"/>
            </c:ext>
          </c:extLst>
        </c:ser>
        <c:ser>
          <c:idx val="1"/>
          <c:order val="1"/>
          <c:tx>
            <c:strRef>
              <c:f>Sheet1!$I$30</c:f>
              <c:strCache>
                <c:ptCount val="1"/>
                <c:pt idx="0">
                  <c:v>やや手間がかかる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1000" b="0" i="0" u="none" strike="noStrike" kern="1200" baseline="0">
                    <a:solidFill>
                      <a:schemeClr val="bg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J$28:$M$28</c:f>
              <c:strCache>
                <c:ptCount val="4"/>
                <c:pt idx="0">
                  <c:v>定期通院先なし/オンライン診療経験あり</c:v>
                </c:pt>
                <c:pt idx="1">
                  <c:v>定期通院先なし/オンライン診療経験なし</c:v>
                </c:pt>
                <c:pt idx="2">
                  <c:v>定期通院先あり/オンライン診療経験あり</c:v>
                </c:pt>
                <c:pt idx="3">
                  <c:v>定期通院先あり/オンライン診療経験なし</c:v>
                </c:pt>
              </c:strCache>
            </c:strRef>
          </c:cat>
          <c:val>
            <c:numRef>
              <c:f>Sheet1!$J$30:$M$30</c:f>
              <c:numCache>
                <c:formatCode>0.0_ </c:formatCode>
                <c:ptCount val="4"/>
                <c:pt idx="0">
                  <c:v>44.8</c:v>
                </c:pt>
                <c:pt idx="1">
                  <c:v>36.700000000000003</c:v>
                </c:pt>
                <c:pt idx="2">
                  <c:v>48.17</c:v>
                </c:pt>
                <c:pt idx="3">
                  <c:v>40.049999999999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4A0-412D-8C96-186BE41A3181}"/>
            </c:ext>
          </c:extLst>
        </c:ser>
        <c:ser>
          <c:idx val="2"/>
          <c:order val="2"/>
          <c:tx>
            <c:strRef>
              <c:f>Sheet1!$I$31</c:f>
              <c:strCache>
                <c:ptCount val="1"/>
                <c:pt idx="0">
                  <c:v>あまり手間はかからない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10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J$28:$M$28</c:f>
              <c:strCache>
                <c:ptCount val="4"/>
                <c:pt idx="0">
                  <c:v>定期通院先なし/オンライン診療経験あり</c:v>
                </c:pt>
                <c:pt idx="1">
                  <c:v>定期通院先なし/オンライン診療経験なし</c:v>
                </c:pt>
                <c:pt idx="2">
                  <c:v>定期通院先あり/オンライン診療経験あり</c:v>
                </c:pt>
                <c:pt idx="3">
                  <c:v>定期通院先あり/オンライン診療経験なし</c:v>
                </c:pt>
              </c:strCache>
            </c:strRef>
          </c:cat>
          <c:val>
            <c:numRef>
              <c:f>Sheet1!$J$31:$M$31</c:f>
              <c:numCache>
                <c:formatCode>0.0_ </c:formatCode>
                <c:ptCount val="4"/>
                <c:pt idx="0">
                  <c:v>30.69</c:v>
                </c:pt>
                <c:pt idx="1">
                  <c:v>34.770000000000003</c:v>
                </c:pt>
                <c:pt idx="2">
                  <c:v>28.43</c:v>
                </c:pt>
                <c:pt idx="3">
                  <c:v>36.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4A0-412D-8C96-186BE41A3181}"/>
            </c:ext>
          </c:extLst>
        </c:ser>
        <c:ser>
          <c:idx val="3"/>
          <c:order val="3"/>
          <c:tx>
            <c:strRef>
              <c:f>Sheet1!$I$32</c:f>
              <c:strCache>
                <c:ptCount val="1"/>
                <c:pt idx="0">
                  <c:v>全く手間はかからない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10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J$28:$M$28</c:f>
              <c:strCache>
                <c:ptCount val="4"/>
                <c:pt idx="0">
                  <c:v>定期通院先なし/オンライン診療経験あり</c:v>
                </c:pt>
                <c:pt idx="1">
                  <c:v>定期通院先なし/オンライン診療経験なし</c:v>
                </c:pt>
                <c:pt idx="2">
                  <c:v>定期通院先あり/オンライン診療経験あり</c:v>
                </c:pt>
                <c:pt idx="3">
                  <c:v>定期通院先あり/オンライン診療経験なし</c:v>
                </c:pt>
              </c:strCache>
            </c:strRef>
          </c:cat>
          <c:val>
            <c:numRef>
              <c:f>Sheet1!$J$32:$M$32</c:f>
              <c:numCache>
                <c:formatCode>0.0_ </c:formatCode>
                <c:ptCount val="4"/>
                <c:pt idx="0">
                  <c:v>7.92</c:v>
                </c:pt>
                <c:pt idx="1">
                  <c:v>19.899999999999999</c:v>
                </c:pt>
                <c:pt idx="2">
                  <c:v>7.85</c:v>
                </c:pt>
                <c:pt idx="3">
                  <c:v>13.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D4A0-412D-8C96-186BE41A318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462340712"/>
        <c:axId val="462341072"/>
      </c:barChart>
      <c:catAx>
        <c:axId val="46234071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62341072"/>
        <c:crosses val="autoZero"/>
        <c:auto val="1"/>
        <c:lblAlgn val="ctr"/>
        <c:lblOffset val="100"/>
        <c:noMultiLvlLbl val="0"/>
      </c:catAx>
      <c:valAx>
        <c:axId val="462341072"/>
        <c:scaling>
          <c:orientation val="minMax"/>
          <c:max val="10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_ 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46234071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28458610442289761"/>
          <c:y val="6.3521438485488857E-2"/>
          <c:w val="0.67765957354504236"/>
          <c:h val="0.1748504405951294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5507375411314868E-2"/>
          <c:y val="0.15493380450257413"/>
          <c:w val="0.87725303514649522"/>
          <c:h val="0.5067062401202612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I$74</c:f>
              <c:strCache>
                <c:ptCount val="1"/>
                <c:pt idx="0">
                  <c:v>オンライン診療経験なし群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11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H$75:$H$79</c:f>
              <c:strCache>
                <c:ptCount val="5"/>
                <c:pt idx="0">
                  <c:v>週1回程度</c:v>
                </c:pt>
                <c:pt idx="1">
                  <c:v>2週に1回程度</c:v>
                </c:pt>
                <c:pt idx="2">
                  <c:v>月1回程度</c:v>
                </c:pt>
                <c:pt idx="3">
                  <c:v>2ヶ月に1回程度</c:v>
                </c:pt>
                <c:pt idx="4">
                  <c:v>3ヶ月に1回程度</c:v>
                </c:pt>
              </c:strCache>
            </c:strRef>
          </c:cat>
          <c:val>
            <c:numRef>
              <c:f>Sheet1!$I$75:$I$79</c:f>
              <c:numCache>
                <c:formatCode>General</c:formatCode>
                <c:ptCount val="5"/>
                <c:pt idx="0">
                  <c:v>4.2</c:v>
                </c:pt>
                <c:pt idx="1">
                  <c:v>7.9</c:v>
                </c:pt>
                <c:pt idx="2">
                  <c:v>36.5</c:v>
                </c:pt>
                <c:pt idx="3">
                  <c:v>17.7</c:v>
                </c:pt>
                <c:pt idx="4">
                  <c:v>33.7000000000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000-44FF-9AD6-24F68144B872}"/>
            </c:ext>
          </c:extLst>
        </c:ser>
        <c:ser>
          <c:idx val="1"/>
          <c:order val="1"/>
          <c:tx>
            <c:strRef>
              <c:f>Sheet1!$J$74</c:f>
              <c:strCache>
                <c:ptCount val="1"/>
                <c:pt idx="0">
                  <c:v>オンライン診療経験あり群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11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H$75:$H$79</c:f>
              <c:strCache>
                <c:ptCount val="5"/>
                <c:pt idx="0">
                  <c:v>週1回程度</c:v>
                </c:pt>
                <c:pt idx="1">
                  <c:v>2週に1回程度</c:v>
                </c:pt>
                <c:pt idx="2">
                  <c:v>月1回程度</c:v>
                </c:pt>
                <c:pt idx="3">
                  <c:v>2ヶ月に1回程度</c:v>
                </c:pt>
                <c:pt idx="4">
                  <c:v>3ヶ月に1回程度</c:v>
                </c:pt>
              </c:strCache>
            </c:strRef>
          </c:cat>
          <c:val>
            <c:numRef>
              <c:f>Sheet1!$J$75:$J$79</c:f>
              <c:numCache>
                <c:formatCode>General</c:formatCode>
                <c:ptCount val="5"/>
                <c:pt idx="0">
                  <c:v>12.6</c:v>
                </c:pt>
                <c:pt idx="1">
                  <c:v>20.9</c:v>
                </c:pt>
                <c:pt idx="2">
                  <c:v>34.799999999999997</c:v>
                </c:pt>
                <c:pt idx="3">
                  <c:v>14</c:v>
                </c:pt>
                <c:pt idx="4">
                  <c:v>17.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000-44FF-9AD6-24F68144B87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52526432"/>
        <c:axId val="652524632"/>
      </c:barChart>
      <c:catAx>
        <c:axId val="6525264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52524632"/>
        <c:crosses val="autoZero"/>
        <c:auto val="1"/>
        <c:lblAlgn val="ctr"/>
        <c:lblOffset val="100"/>
        <c:noMultiLvlLbl val="0"/>
      </c:catAx>
      <c:valAx>
        <c:axId val="65252463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5252643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7.3640373956343416E-2"/>
          <c:y val="0.92471174343429918"/>
          <c:w val="0.89999984005902889"/>
          <c:h val="4.968884282139134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100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5507375411314868E-2"/>
          <c:y val="0.16103317834622854"/>
          <c:w val="0.87725303514649522"/>
          <c:h val="0.5256571069716903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I$87</c:f>
              <c:strCache>
                <c:ptCount val="1"/>
                <c:pt idx="0">
                  <c:v>オンライン診療経験なし群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H$88:$H$91</c:f>
              <c:strCache>
                <c:ptCount val="4"/>
                <c:pt idx="0">
                  <c:v>30分未満</c:v>
                </c:pt>
                <c:pt idx="1">
                  <c:v>30分以上1時間未満</c:v>
                </c:pt>
                <c:pt idx="2">
                  <c:v>1時間以上2時間未満</c:v>
                </c:pt>
                <c:pt idx="3">
                  <c:v>2時間以上</c:v>
                </c:pt>
              </c:strCache>
            </c:strRef>
          </c:cat>
          <c:val>
            <c:numRef>
              <c:f>Sheet1!$I$88:$I$91</c:f>
              <c:numCache>
                <c:formatCode>General</c:formatCode>
                <c:ptCount val="4"/>
                <c:pt idx="0">
                  <c:v>62.1</c:v>
                </c:pt>
                <c:pt idx="1">
                  <c:v>27.3</c:v>
                </c:pt>
                <c:pt idx="2">
                  <c:v>8</c:v>
                </c:pt>
                <c:pt idx="3">
                  <c:v>2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514-4BD6-9440-CCEBFEF70760}"/>
            </c:ext>
          </c:extLst>
        </c:ser>
        <c:ser>
          <c:idx val="1"/>
          <c:order val="1"/>
          <c:tx>
            <c:strRef>
              <c:f>Sheet1!$J$87</c:f>
              <c:strCache>
                <c:ptCount val="1"/>
                <c:pt idx="0">
                  <c:v>オンライン診療経験あり群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H$88:$H$91</c:f>
              <c:strCache>
                <c:ptCount val="4"/>
                <c:pt idx="0">
                  <c:v>30分未満</c:v>
                </c:pt>
                <c:pt idx="1">
                  <c:v>30分以上1時間未満</c:v>
                </c:pt>
                <c:pt idx="2">
                  <c:v>1時間以上2時間未満</c:v>
                </c:pt>
                <c:pt idx="3">
                  <c:v>2時間以上</c:v>
                </c:pt>
              </c:strCache>
            </c:strRef>
          </c:cat>
          <c:val>
            <c:numRef>
              <c:f>Sheet1!$J$88:$J$91</c:f>
              <c:numCache>
                <c:formatCode>General</c:formatCode>
                <c:ptCount val="4"/>
                <c:pt idx="0">
                  <c:v>42.2</c:v>
                </c:pt>
                <c:pt idx="1">
                  <c:v>42.1</c:v>
                </c:pt>
                <c:pt idx="2">
                  <c:v>12.5</c:v>
                </c:pt>
                <c:pt idx="3">
                  <c:v>3.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514-4BD6-9440-CCEBFEF7076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35635992"/>
        <c:axId val="335637432"/>
      </c:barChart>
      <c:catAx>
        <c:axId val="3356359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335637432"/>
        <c:crosses val="autoZero"/>
        <c:auto val="1"/>
        <c:lblAlgn val="ctr"/>
        <c:lblOffset val="100"/>
        <c:noMultiLvlLbl val="0"/>
      </c:catAx>
      <c:valAx>
        <c:axId val="33563743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3563599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5.2226298767779955E-2"/>
          <c:y val="0.83219228283276048"/>
          <c:w val="0.89999984005902889"/>
          <c:h val="6.105790757761532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95272174381384"/>
          <c:y val="0.11469390060450624"/>
          <c:w val="0.82290177636618089"/>
          <c:h val="0.6583418121186037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00B0F0"/>
            </a:solidFill>
            <a:ln>
              <a:noFill/>
            </a:ln>
            <a:effectLst/>
          </c:spPr>
          <c:invertIfNegative val="0"/>
          <c:dLbls>
            <c:dLbl>
              <c:idx val="0"/>
              <c:tx>
                <c:rich>
                  <a:bodyPr/>
                  <a:lstStyle/>
                  <a:p>
                    <a:fld id="{C9584E37-DDC7-4C4C-BC13-BAA07C512F8D}" type="VALUE">
                      <a:rPr lang="en-US" altLang="ja-JP" smtClean="0"/>
                      <a:pPr/>
                      <a:t>[値]</a:t>
                    </a:fld>
                    <a:endParaRPr lang="ja-JP" altLang="en-US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10033339800119086"/>
                      <c:h val="0.13222847933151904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0667-4490-AD19-AB2C730734FC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fld id="{0EA82924-9BAF-4869-85CD-3136A7CEB24A}" type="VALUE">
                      <a:rPr lang="en-US" altLang="ja-JP" smtClean="0"/>
                      <a:pPr/>
                      <a:t>[値]</a:t>
                    </a:fld>
                    <a:endParaRPr lang="ja-JP" altLang="en-US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10033339800119086"/>
                      <c:h val="0.1334157744385904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2-0667-4490-AD19-AB2C730734FC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fld id="{D1FC89E4-3A3C-476A-9920-2DD31FBC9D02}" type="VALUE">
                      <a:rPr lang="en-US" altLang="ja-JP" smtClean="0"/>
                      <a:pPr/>
                      <a:t>[値]</a:t>
                    </a:fld>
                    <a:endParaRPr lang="ja-JP" altLang="en-US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0667-4490-AD19-AB2C730734FC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lang="ja-JP" sz="12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J$2:$J$12</c:f>
              <c:strCache>
                <c:ptCount val="11"/>
                <c:pt idx="0">
                  <c:v>0%</c:v>
                </c:pt>
                <c:pt idx="1">
                  <c:v>10%</c:v>
                </c:pt>
                <c:pt idx="2">
                  <c:v>20%</c:v>
                </c:pt>
                <c:pt idx="3">
                  <c:v>30%</c:v>
                </c:pt>
                <c:pt idx="4">
                  <c:v>40%</c:v>
                </c:pt>
                <c:pt idx="5">
                  <c:v>50%</c:v>
                </c:pt>
                <c:pt idx="6">
                  <c:v>60%</c:v>
                </c:pt>
                <c:pt idx="7">
                  <c:v>70%</c:v>
                </c:pt>
                <c:pt idx="8">
                  <c:v>80%</c:v>
                </c:pt>
                <c:pt idx="9">
                  <c:v>90%</c:v>
                </c:pt>
                <c:pt idx="10">
                  <c:v>100%</c:v>
                </c:pt>
              </c:strCache>
            </c:strRef>
          </c:cat>
          <c:val>
            <c:numRef>
              <c:f>Sheet1!$K$2:$K$12</c:f>
              <c:numCache>
                <c:formatCode>General</c:formatCode>
                <c:ptCount val="11"/>
                <c:pt idx="0">
                  <c:v>203</c:v>
                </c:pt>
                <c:pt idx="1">
                  <c:v>636</c:v>
                </c:pt>
                <c:pt idx="2">
                  <c:v>276</c:v>
                </c:pt>
                <c:pt idx="3">
                  <c:v>215</c:v>
                </c:pt>
                <c:pt idx="4">
                  <c:v>50</c:v>
                </c:pt>
                <c:pt idx="5">
                  <c:v>128</c:v>
                </c:pt>
                <c:pt idx="6">
                  <c:v>19</c:v>
                </c:pt>
                <c:pt idx="7">
                  <c:v>14</c:v>
                </c:pt>
                <c:pt idx="8">
                  <c:v>2</c:v>
                </c:pt>
                <c:pt idx="9">
                  <c:v>4</c:v>
                </c:pt>
                <c:pt idx="10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667-4490-AD19-AB2C730734F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70176696"/>
        <c:axId val="670177416"/>
      </c:barChart>
      <c:catAx>
        <c:axId val="6701766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70177416"/>
        <c:crosses val="autoZero"/>
        <c:auto val="1"/>
        <c:lblAlgn val="ctr"/>
        <c:lblOffset val="100"/>
        <c:noMultiLvlLbl val="0"/>
      </c:catAx>
      <c:valAx>
        <c:axId val="67017741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2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umber of responses (N)</a:t>
                </a:r>
                <a:endParaRPr lang="ja-JP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1.181586357147749E-2"/>
              <c:y val="4.6589513042679893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2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7017669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88342</cdr:x>
      <cdr:y>0.76731</cdr:y>
    </cdr:from>
    <cdr:to>
      <cdr:x>0.98938</cdr:x>
      <cdr:y>0.86171</cdr:y>
    </cdr:to>
    <cdr:sp macro="" textlink="">
      <cdr:nvSpPr>
        <cdr:cNvPr id="10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3B770623-D567-3A58-C803-56D34CA77176}"/>
            </a:ext>
          </a:extLst>
        </cdr:cNvPr>
        <cdr:cNvSpPr txBox="1"/>
      </cdr:nvSpPr>
      <cdr:spPr>
        <a:xfrm xmlns:a="http://schemas.openxmlformats.org/drawingml/2006/main">
          <a:off x="4099863" y="2501691"/>
          <a:ext cx="491750" cy="307776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ja-JP"/>
          </a:defPPr>
          <a:lvl1pPr marL="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1400" dirty="0">
              <a:latin typeface="Arial" panose="020B0604020202020204" pitchFamily="34" charset="0"/>
              <a:cs typeface="Arial" panose="020B0604020202020204" pitchFamily="34" charset="0"/>
            </a:rPr>
            <a:t>(%)</a:t>
          </a:r>
          <a:endParaRPr kumimoji="1" lang="ja-JP" altLang="en-US" sz="14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02556</cdr:x>
      <cdr:y>0.0758</cdr:y>
    </cdr:from>
    <cdr:to>
      <cdr:x>0.20397</cdr:x>
      <cdr:y>0.21231</cdr:y>
    </cdr:to>
    <cdr:sp macro="" textlink="">
      <cdr:nvSpPr>
        <cdr:cNvPr id="2" name="テキスト ボックス 7">
          <a:extLst xmlns:a="http://schemas.openxmlformats.org/drawingml/2006/main">
            <a:ext uri="{FF2B5EF4-FFF2-40B4-BE49-F238E27FC236}">
              <a16:creationId xmlns:a16="http://schemas.microsoft.com/office/drawing/2014/main" id="{1CF4EBD5-5FDF-B34F-FF84-8EC9E328DC6E}"/>
            </a:ext>
          </a:extLst>
        </cdr:cNvPr>
        <cdr:cNvSpPr txBox="1"/>
      </cdr:nvSpPr>
      <cdr:spPr>
        <a:xfrm xmlns:a="http://schemas.openxmlformats.org/drawingml/2006/main">
          <a:off x="140932" y="187974"/>
          <a:ext cx="983808" cy="338554"/>
        </a:xfrm>
        <a:prstGeom xmlns:a="http://schemas.openxmlformats.org/drawingml/2006/main" prst="rect">
          <a:avLst/>
        </a:prstGeom>
        <a:solidFill xmlns:a="http://schemas.openxmlformats.org/drawingml/2006/main">
          <a:schemeClr val="bg1"/>
        </a:solidFill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ja-JP"/>
          </a:defPPr>
          <a:lvl1pPr marL="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/>
          <a:r>
            <a:rPr kumimoji="1" lang="en-US" altLang="ja-JP" sz="1600" dirty="0">
              <a:latin typeface="Times New Roman" panose="02020603050405020304" pitchFamily="18" charset="0"/>
              <a:cs typeface="Times New Roman" panose="02020603050405020304" pitchFamily="18" charset="0"/>
            </a:rPr>
            <a:t>Yes</a:t>
          </a:r>
          <a:endParaRPr kumimoji="1" lang="ja-JP" altLang="en-US" sz="16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</cdr:x>
      <cdr:y>0.24322</cdr:y>
    </cdr:from>
    <cdr:to>
      <cdr:x>0.20397</cdr:x>
      <cdr:y>0.37973</cdr:y>
    </cdr:to>
    <cdr:sp macro="" textlink="">
      <cdr:nvSpPr>
        <cdr:cNvPr id="3" name="テキスト ボックス 8">
          <a:extLst xmlns:a="http://schemas.openxmlformats.org/drawingml/2006/main">
            <a:ext uri="{FF2B5EF4-FFF2-40B4-BE49-F238E27FC236}">
              <a16:creationId xmlns:a16="http://schemas.microsoft.com/office/drawing/2014/main" id="{539B990B-0D19-62CF-EF60-2C0F0145C1E4}"/>
            </a:ext>
          </a:extLst>
        </cdr:cNvPr>
        <cdr:cNvSpPr txBox="1"/>
      </cdr:nvSpPr>
      <cdr:spPr>
        <a:xfrm xmlns:a="http://schemas.openxmlformats.org/drawingml/2006/main">
          <a:off x="0" y="603182"/>
          <a:ext cx="1124740" cy="338554"/>
        </a:xfrm>
        <a:prstGeom xmlns:a="http://schemas.openxmlformats.org/drawingml/2006/main" prst="rect">
          <a:avLst/>
        </a:prstGeom>
        <a:solidFill xmlns:a="http://schemas.openxmlformats.org/drawingml/2006/main">
          <a:schemeClr val="bg1"/>
        </a:solidFill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ja-JP"/>
          </a:defPPr>
          <a:lvl1pPr marL="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/>
          <a:r>
            <a:rPr kumimoji="1" lang="en-US" altLang="ja-JP" sz="1600" dirty="0">
              <a:latin typeface="Times New Roman" panose="02020603050405020304" pitchFamily="18" charset="0"/>
              <a:cs typeface="Times New Roman" panose="02020603050405020304" pitchFamily="18" charset="0"/>
            </a:rPr>
            <a:t>Yes/No *</a:t>
          </a:r>
          <a:endParaRPr kumimoji="1" lang="ja-JP" altLang="en-US" sz="16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02556</cdr:x>
      <cdr:y>0.42554</cdr:y>
    </cdr:from>
    <cdr:to>
      <cdr:x>0.20397</cdr:x>
      <cdr:y>0.56205</cdr:y>
    </cdr:to>
    <cdr:sp macro="" textlink="">
      <cdr:nvSpPr>
        <cdr:cNvPr id="4" name="テキスト ボックス 9">
          <a:extLst xmlns:a="http://schemas.openxmlformats.org/drawingml/2006/main">
            <a:ext uri="{FF2B5EF4-FFF2-40B4-BE49-F238E27FC236}">
              <a16:creationId xmlns:a16="http://schemas.microsoft.com/office/drawing/2014/main" id="{0ED4EDDA-5AD4-AB8A-BA79-A7E32C333320}"/>
            </a:ext>
          </a:extLst>
        </cdr:cNvPr>
        <cdr:cNvSpPr txBox="1"/>
      </cdr:nvSpPr>
      <cdr:spPr>
        <a:xfrm xmlns:a="http://schemas.openxmlformats.org/drawingml/2006/main">
          <a:off x="140932" y="1055336"/>
          <a:ext cx="983808" cy="338554"/>
        </a:xfrm>
        <a:prstGeom xmlns:a="http://schemas.openxmlformats.org/drawingml/2006/main" prst="rect">
          <a:avLst/>
        </a:prstGeom>
        <a:solidFill xmlns:a="http://schemas.openxmlformats.org/drawingml/2006/main">
          <a:schemeClr val="bg1"/>
        </a:solidFill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ja-JP"/>
          </a:defPPr>
          <a:lvl1pPr marL="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/>
          <a:r>
            <a:rPr kumimoji="1" lang="en-US" altLang="ja-JP" sz="1600" dirty="0">
              <a:latin typeface="Times New Roman" panose="02020603050405020304" pitchFamily="18" charset="0"/>
              <a:cs typeface="Times New Roman" panose="02020603050405020304" pitchFamily="18" charset="0"/>
            </a:rPr>
            <a:t>No</a:t>
          </a:r>
          <a:endParaRPr kumimoji="1" lang="ja-JP" altLang="en-US" sz="16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9CCFF23-2934-47C6-89EC-C0018E88EE72}" type="datetimeFigureOut">
              <a:rPr kumimoji="1" lang="ja-JP" altLang="en-US" smtClean="0"/>
              <a:t>2024/9/2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1425"/>
            <a:ext cx="59531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FBBEFD1-A176-4527-9786-48C428EC13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31008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A </a:t>
            </a:r>
            <a:r>
              <a:rPr kumimoji="1" lang="ja-JP" altLang="en-US" dirty="0"/>
              <a:t>近傍の医療機関数</a:t>
            </a:r>
            <a:endParaRPr kumimoji="1" lang="en-US" altLang="ja-JP" dirty="0"/>
          </a:p>
          <a:p>
            <a:r>
              <a:rPr kumimoji="1" lang="en-US" altLang="ja-JP" dirty="0"/>
              <a:t>B </a:t>
            </a:r>
            <a:r>
              <a:rPr kumimoji="1" lang="ja-JP" altLang="en-US" dirty="0"/>
              <a:t>通院の手間</a:t>
            </a:r>
            <a:endParaRPr kumimoji="1" lang="en-US" altLang="ja-JP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FBBEFD1-A176-4527-9786-48C428EC13B0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540403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FBBEFD1-A176-4527-9786-48C428EC13B0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114669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895D180-E261-4ED3-571B-5976CC3D185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DB67E08A-A88E-0284-9CC9-B79023446A2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78E29E5-720C-C5A5-AC32-A30FF24769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ED8F5-F882-4398-B841-7759C555EB20}" type="datetimeFigureOut">
              <a:rPr kumimoji="1" lang="ja-JP" altLang="en-US" smtClean="0"/>
              <a:t>2024/9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B35FB57-AA04-6904-8EB2-BA6331A2D1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F7623D6-42CC-8C28-DA07-6B10BCF443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233F16-C324-489C-B014-0D9EFACD2E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00402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DEFB61C-B50E-26D7-B206-32F7D6C905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F3E341C-2016-9DA4-ECE2-5AD94BE5052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05E4F35-D587-F76E-EEF3-2CB30033B6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ED8F5-F882-4398-B841-7759C555EB20}" type="datetimeFigureOut">
              <a:rPr kumimoji="1" lang="ja-JP" altLang="en-US" smtClean="0"/>
              <a:t>2024/9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3D9AD7B-D46F-C88B-7A94-F08A186CE4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CA4D0AF-620A-278E-1581-D20872C357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233F16-C324-489C-B014-0D9EFACD2E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49184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BD6F0AA6-08FE-CF0C-1F84-04BFCA2343F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3EC3E2E-3D2F-9066-D8A0-18F063D5332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6120F09-4762-BB73-0110-552C917FA2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ED8F5-F882-4398-B841-7759C555EB20}" type="datetimeFigureOut">
              <a:rPr kumimoji="1" lang="ja-JP" altLang="en-US" smtClean="0"/>
              <a:t>2024/9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D487C3F-4AAD-B50E-10C0-3F218FB5C7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FD45280-EE5E-8B29-CA49-4EFFAA732D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233F16-C324-489C-B014-0D9EFACD2E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4528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D0A3E39-E6A5-2109-F052-A97DB60256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30925B8-34CB-3F6C-9ABC-807199F8D50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0CBC804-F355-D0B4-BEAF-36D29BEF0B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ED8F5-F882-4398-B841-7759C555EB20}" type="datetimeFigureOut">
              <a:rPr kumimoji="1" lang="ja-JP" altLang="en-US" smtClean="0"/>
              <a:t>2024/9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227ECCF-1CC9-82F2-63CC-93F1DA2F70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D416559-0DD1-748C-F8DF-93E8351976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233F16-C324-489C-B014-0D9EFACD2E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23800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3302D18-72D7-7629-FE5D-6352DBEF73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DBF7172-592D-AEC7-FCF9-71D8854646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EA4F255-1172-2CA8-60E1-2FBA9785E7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ED8F5-F882-4398-B841-7759C555EB20}" type="datetimeFigureOut">
              <a:rPr kumimoji="1" lang="ja-JP" altLang="en-US" smtClean="0"/>
              <a:t>2024/9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2A7FA63-47DB-03E7-1FFB-13595CBFDE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9CDC4CC-019B-5543-9147-3A1890B009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233F16-C324-489C-B014-0D9EFACD2E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02272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CD9BED3-2024-DE74-8FE1-3618329F0C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92C6918-1E64-46C0-EF54-A7A55E82261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A221109-5883-7DAC-53D5-B9D6CA15A13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27D3683-D9D3-A592-9C0E-07AD60BB1C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ED8F5-F882-4398-B841-7759C555EB20}" type="datetimeFigureOut">
              <a:rPr kumimoji="1" lang="ja-JP" altLang="en-US" smtClean="0"/>
              <a:t>2024/9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300CD22-CE3D-440B-A741-ABD1D247DA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EBC5254-536D-05BA-7530-494FE1D1DA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233F16-C324-489C-B014-0D9EFACD2E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86988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500D63C-16D3-0C38-B8BB-9B32210C80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AF8FA2D-7C9D-11AC-55D1-BCE5B51F22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3A73DB3-3E7C-5B86-7EAE-0B730EE09B6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8276F643-5FAF-5170-BB34-5AAA9D4A6F7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236736A8-E79D-DECD-2B46-DF01A7D850E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B8A4A2FE-4EFB-F2AF-DBA1-212367A6EB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ED8F5-F882-4398-B841-7759C555EB20}" type="datetimeFigureOut">
              <a:rPr kumimoji="1" lang="ja-JP" altLang="en-US" smtClean="0"/>
              <a:t>2024/9/24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8FDF9E02-33EB-3DBD-D87B-691C4F9F3F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01BDF29A-6B73-8DDF-3F5C-50D46466A1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233F16-C324-489C-B014-0D9EFACD2E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82493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A7A4177-F04D-1BD7-31F3-FC9A48FE42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5A0B242B-0F9C-2FB9-54C5-39E4D6BA5A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ED8F5-F882-4398-B841-7759C555EB20}" type="datetimeFigureOut">
              <a:rPr kumimoji="1" lang="ja-JP" altLang="en-US" smtClean="0"/>
              <a:t>2024/9/2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CD13736A-4EA8-44F4-C868-99CDDB157A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CDBB42B1-C601-F242-DD90-D091C15382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233F16-C324-489C-B014-0D9EFACD2E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46399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FE5D3F4E-369F-2177-A423-50528CBA79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ED8F5-F882-4398-B841-7759C555EB20}" type="datetimeFigureOut">
              <a:rPr kumimoji="1" lang="ja-JP" altLang="en-US" smtClean="0"/>
              <a:t>2024/9/24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F826D5D6-724B-1296-74F0-74878BA043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2F3B8568-A3E6-FC99-A530-751553C4A0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233F16-C324-489C-B014-0D9EFACD2E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90743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D0329C0-DC57-07EB-A22E-B8A0D6225D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56AFB8C-ED59-4943-9996-D97653817C8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281F550-7BEA-39F5-9511-62796FC797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832F6AE-02E1-75E3-C2FB-7AD87C0A4D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ED8F5-F882-4398-B841-7759C555EB20}" type="datetimeFigureOut">
              <a:rPr kumimoji="1" lang="ja-JP" altLang="en-US" smtClean="0"/>
              <a:t>2024/9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7C40343-2188-A33E-3784-D701C79617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2075787-59CF-ADFC-8AFE-F119188F21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233F16-C324-489C-B014-0D9EFACD2E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06211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D2DC821-2D8B-DA15-48CA-E3602E74BA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11D8EFCF-B303-EA3A-F983-17350F42862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23C7CA9C-CB26-ABE2-700B-FE3D690F067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476E17C-BEA2-E990-A903-696B8AB968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ED8F5-F882-4398-B841-7759C555EB20}" type="datetimeFigureOut">
              <a:rPr kumimoji="1" lang="ja-JP" altLang="en-US" smtClean="0"/>
              <a:t>2024/9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388E64F-662F-017D-9C45-D2087F6311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EE88979-09DE-0F1E-06DF-232791A443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233F16-C324-489C-B014-0D9EFACD2E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38026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4772B7EE-03DC-2B4C-537D-8A674C498A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A9B38B7-7DEA-BB0C-BF7E-575BCF82A4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9881892-D0E0-987E-C04D-CC3B36C4F73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3ED8F5-F882-4398-B841-7759C555EB20}" type="datetimeFigureOut">
              <a:rPr kumimoji="1" lang="ja-JP" altLang="en-US" smtClean="0"/>
              <a:t>2024/9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83343E4-556A-7FD3-B3CB-7E2A9BE5863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78D507A-FAA0-2A0E-B427-37464DBB1EC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233F16-C324-489C-B014-0D9EFACD2E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88936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.png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6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7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.png"/><Relationship Id="rId4" Type="http://schemas.openxmlformats.org/officeDocument/2006/relationships/chart" Target="../charts/chart8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0.xml"/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12.xml"/><Relationship Id="rId4" Type="http://schemas.openxmlformats.org/officeDocument/2006/relationships/chart" Target="../charts/chart11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0C37B568-6461-4708-C63F-EF90ADDA38A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80677044"/>
              </p:ext>
            </p:extLst>
          </p:nvPr>
        </p:nvGraphicFramePr>
        <p:xfrm>
          <a:off x="671557" y="274094"/>
          <a:ext cx="5387340" cy="33746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5CE46158-E8A2-7544-5E95-83A5C7B79B9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82307223"/>
              </p:ext>
            </p:extLst>
          </p:nvPr>
        </p:nvGraphicFramePr>
        <p:xfrm>
          <a:off x="6558661" y="389045"/>
          <a:ext cx="5801360" cy="317005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8C212DC8-C546-8DBC-19E2-04095CB734BF}"/>
              </a:ext>
            </a:extLst>
          </p:cNvPr>
          <p:cNvSpPr txBox="1"/>
          <p:nvPr/>
        </p:nvSpPr>
        <p:spPr>
          <a:xfrm>
            <a:off x="292748" y="1281431"/>
            <a:ext cx="400110" cy="1454885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. of respondents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スライド番号プレースホルダー 7">
            <a:extLst>
              <a:ext uri="{FF2B5EF4-FFF2-40B4-BE49-F238E27FC236}">
                <a16:creationId xmlns:a16="http://schemas.microsoft.com/office/drawing/2014/main" id="{CB4336AA-D693-17F9-17AE-D9E84F0DB0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778621" y="6224249"/>
            <a:ext cx="2743200" cy="365125"/>
          </a:xfrm>
        </p:spPr>
        <p:txBody>
          <a:bodyPr/>
          <a:lstStyle/>
          <a:p>
            <a:fld id="{6436FFE7-A03F-4AA2-A8F2-22E89E0B9218}" type="slidenum">
              <a:rPr kumimoji="1" lang="ja-JP" altLang="en-US" smtClean="0">
                <a:solidFill>
                  <a:schemeClr val="tx1"/>
                </a:solidFill>
              </a:rPr>
              <a:t>1</a:t>
            </a:fld>
            <a:endParaRPr kumimoji="1" lang="ja-JP" altLang="en-US">
              <a:solidFill>
                <a:schemeClr val="tx1"/>
              </a:solidFill>
            </a:endParaRPr>
          </a:p>
        </p:txBody>
      </p:sp>
      <p:graphicFrame>
        <p:nvGraphicFramePr>
          <p:cNvPr id="9" name="グラフ 8">
            <a:extLst>
              <a:ext uri="{FF2B5EF4-FFF2-40B4-BE49-F238E27FC236}">
                <a16:creationId xmlns:a16="http://schemas.microsoft.com/office/drawing/2014/main" id="{6AC87183-BD06-09C0-AF01-8E76C8A992B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29185379"/>
              </p:ext>
            </p:extLst>
          </p:nvPr>
        </p:nvGraphicFramePr>
        <p:xfrm>
          <a:off x="680447" y="3259910"/>
          <a:ext cx="5462924" cy="32346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1" name="グラフ 10">
            <a:extLst>
              <a:ext uri="{FF2B5EF4-FFF2-40B4-BE49-F238E27FC236}">
                <a16:creationId xmlns:a16="http://schemas.microsoft.com/office/drawing/2014/main" id="{8AB5AFB8-E1D0-A142-3E45-CB4A4CEC988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55727357"/>
              </p:ext>
            </p:extLst>
          </p:nvPr>
        </p:nvGraphicFramePr>
        <p:xfrm>
          <a:off x="6645023" y="3169398"/>
          <a:ext cx="5378450" cy="34242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0D62A8F8-7F1D-2111-6B95-AFF47A083A3B}"/>
              </a:ext>
            </a:extLst>
          </p:cNvPr>
          <p:cNvSpPr txBox="1"/>
          <p:nvPr/>
        </p:nvSpPr>
        <p:spPr>
          <a:xfrm>
            <a:off x="6264760" y="1281431"/>
            <a:ext cx="400110" cy="1454885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. of respondents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F28703DF-32AA-FD6C-C723-FF2951442306}"/>
              </a:ext>
            </a:extLst>
          </p:cNvPr>
          <p:cNvSpPr txBox="1"/>
          <p:nvPr/>
        </p:nvSpPr>
        <p:spPr>
          <a:xfrm>
            <a:off x="6264973" y="4199148"/>
            <a:ext cx="400110" cy="1603965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o. of respondents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9CAE8C86-C664-A170-C6FA-3DD3A5F6EE68}"/>
              </a:ext>
            </a:extLst>
          </p:cNvPr>
          <p:cNvSpPr txBox="1"/>
          <p:nvPr/>
        </p:nvSpPr>
        <p:spPr>
          <a:xfrm>
            <a:off x="208348" y="4059482"/>
            <a:ext cx="400110" cy="165007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. of respondents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CE69B8E7-39D6-9CB7-0849-CFB5AA4A8186}"/>
              </a:ext>
            </a:extLst>
          </p:cNvPr>
          <p:cNvSpPr/>
          <p:nvPr/>
        </p:nvSpPr>
        <p:spPr>
          <a:xfrm>
            <a:off x="6863111" y="5942878"/>
            <a:ext cx="283779" cy="36512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pic>
        <p:nvPicPr>
          <p:cNvPr id="23" name="図 22">
            <a:extLst>
              <a:ext uri="{FF2B5EF4-FFF2-40B4-BE49-F238E27FC236}">
                <a16:creationId xmlns:a16="http://schemas.microsoft.com/office/drawing/2014/main" id="{FD1878FD-4448-C821-8853-999E8081138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245883" y="3057094"/>
            <a:ext cx="2238687" cy="438211"/>
          </a:xfrm>
          <a:prstGeom prst="rect">
            <a:avLst/>
          </a:prstGeom>
        </p:spPr>
      </p:pic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77100E90-D3A7-0556-4182-F5C0505BC74C}"/>
              </a:ext>
            </a:extLst>
          </p:cNvPr>
          <p:cNvSpPr txBox="1"/>
          <p:nvPr/>
        </p:nvSpPr>
        <p:spPr>
          <a:xfrm>
            <a:off x="2700475" y="3106922"/>
            <a:ext cx="790601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emale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632C0010-79C7-1ED7-BE49-68C2D8015B3F}"/>
              </a:ext>
            </a:extLst>
          </p:cNvPr>
          <p:cNvSpPr txBox="1"/>
          <p:nvPr/>
        </p:nvSpPr>
        <p:spPr>
          <a:xfrm>
            <a:off x="3809372" y="3106922"/>
            <a:ext cx="628698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e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6" name="図 25">
            <a:extLst>
              <a:ext uri="{FF2B5EF4-FFF2-40B4-BE49-F238E27FC236}">
                <a16:creationId xmlns:a16="http://schemas.microsoft.com/office/drawing/2014/main" id="{FBEF96BF-61D2-5A89-2888-1C20900D278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245883" y="6157840"/>
            <a:ext cx="2238687" cy="438211"/>
          </a:xfrm>
          <a:prstGeom prst="rect">
            <a:avLst/>
          </a:prstGeom>
        </p:spPr>
      </p:pic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4268AD3D-8B7D-A21C-7317-E693297F7AEE}"/>
              </a:ext>
            </a:extLst>
          </p:cNvPr>
          <p:cNvSpPr txBox="1"/>
          <p:nvPr/>
        </p:nvSpPr>
        <p:spPr>
          <a:xfrm>
            <a:off x="2659360" y="6207668"/>
            <a:ext cx="790601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emale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6C6A6EAC-942E-9E9D-E24B-ECD53CD033F2}"/>
              </a:ext>
            </a:extLst>
          </p:cNvPr>
          <p:cNvSpPr txBox="1"/>
          <p:nvPr/>
        </p:nvSpPr>
        <p:spPr>
          <a:xfrm>
            <a:off x="3809372" y="6207668"/>
            <a:ext cx="628698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e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9" name="図 28">
            <a:extLst>
              <a:ext uri="{FF2B5EF4-FFF2-40B4-BE49-F238E27FC236}">
                <a16:creationId xmlns:a16="http://schemas.microsoft.com/office/drawing/2014/main" id="{F79A343E-931B-1B74-B5CC-8019CD8680C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210503" y="3052231"/>
            <a:ext cx="2238687" cy="438211"/>
          </a:xfrm>
          <a:prstGeom prst="rect">
            <a:avLst/>
          </a:prstGeom>
        </p:spPr>
      </p:pic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38D5FAE0-717C-8B17-9BEC-16E7D1B0A5C8}"/>
              </a:ext>
            </a:extLst>
          </p:cNvPr>
          <p:cNvSpPr txBox="1"/>
          <p:nvPr/>
        </p:nvSpPr>
        <p:spPr>
          <a:xfrm>
            <a:off x="8623980" y="3102059"/>
            <a:ext cx="790601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emale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02F57748-9826-E0DB-84A1-C97E29BE6BDF}"/>
              </a:ext>
            </a:extLst>
          </p:cNvPr>
          <p:cNvSpPr txBox="1"/>
          <p:nvPr/>
        </p:nvSpPr>
        <p:spPr>
          <a:xfrm>
            <a:off x="9773992" y="3102059"/>
            <a:ext cx="628698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e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2" name="図 31">
            <a:extLst>
              <a:ext uri="{FF2B5EF4-FFF2-40B4-BE49-F238E27FC236}">
                <a16:creationId xmlns:a16="http://schemas.microsoft.com/office/drawing/2014/main" id="{F70EF84F-9235-D173-022C-F0C52510FC5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207291" y="6147240"/>
            <a:ext cx="2238687" cy="438211"/>
          </a:xfrm>
          <a:prstGeom prst="rect">
            <a:avLst/>
          </a:prstGeom>
        </p:spPr>
      </p:pic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A8DFCF2C-6726-FF6A-B2FA-979A25C9D1FC}"/>
              </a:ext>
            </a:extLst>
          </p:cNvPr>
          <p:cNvSpPr txBox="1"/>
          <p:nvPr/>
        </p:nvSpPr>
        <p:spPr>
          <a:xfrm>
            <a:off x="8620768" y="6197068"/>
            <a:ext cx="790601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emale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939C827E-25BC-E9E1-F07A-3C3B1D3F524F}"/>
              </a:ext>
            </a:extLst>
          </p:cNvPr>
          <p:cNvSpPr txBox="1"/>
          <p:nvPr/>
        </p:nvSpPr>
        <p:spPr>
          <a:xfrm>
            <a:off x="9770780" y="6197068"/>
            <a:ext cx="628698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e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DA2EDF3C-DB09-19EB-6453-596FA251FD2E}"/>
              </a:ext>
            </a:extLst>
          </p:cNvPr>
          <p:cNvSpPr txBox="1"/>
          <p:nvPr/>
        </p:nvSpPr>
        <p:spPr>
          <a:xfrm>
            <a:off x="208348" y="50491"/>
            <a:ext cx="1182251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tribution of age and sex of respondents for patients/general survey 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B6FE8C9B-F71C-A49A-0812-828642EDE8B8}"/>
              </a:ext>
            </a:extLst>
          </p:cNvPr>
          <p:cNvSpPr txBox="1"/>
          <p:nvPr/>
        </p:nvSpPr>
        <p:spPr>
          <a:xfrm>
            <a:off x="362236" y="543307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83353F21-A40A-602C-2E2A-C815889EDB5A}"/>
              </a:ext>
            </a:extLst>
          </p:cNvPr>
          <p:cNvSpPr txBox="1"/>
          <p:nvPr/>
        </p:nvSpPr>
        <p:spPr>
          <a:xfrm>
            <a:off x="6352798" y="537849"/>
            <a:ext cx="4924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5219E627-D98C-F53B-D111-D7EED8B184C6}"/>
              </a:ext>
            </a:extLst>
          </p:cNvPr>
          <p:cNvSpPr txBox="1"/>
          <p:nvPr/>
        </p:nvSpPr>
        <p:spPr>
          <a:xfrm>
            <a:off x="389090" y="3410695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5D3C0FD9-9F11-66C4-6141-870CD46A0798}"/>
              </a:ext>
            </a:extLst>
          </p:cNvPr>
          <p:cNvSpPr txBox="1"/>
          <p:nvPr/>
        </p:nvSpPr>
        <p:spPr>
          <a:xfrm>
            <a:off x="6380342" y="3376366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6" name="表 15">
            <a:extLst>
              <a:ext uri="{FF2B5EF4-FFF2-40B4-BE49-F238E27FC236}">
                <a16:creationId xmlns:a16="http://schemas.microsoft.com/office/drawing/2014/main" id="{95AF77F4-AE65-AFEB-3847-766316F87A7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4848508"/>
              </p:ext>
            </p:extLst>
          </p:nvPr>
        </p:nvGraphicFramePr>
        <p:xfrm>
          <a:off x="934535" y="2581746"/>
          <a:ext cx="5124368" cy="5486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88077">
                  <a:extLst>
                    <a:ext uri="{9D8B030D-6E8A-4147-A177-3AD203B41FA5}">
                      <a16:colId xmlns:a16="http://schemas.microsoft.com/office/drawing/2014/main" val="2478681261"/>
                    </a:ext>
                  </a:extLst>
                </a:gridCol>
                <a:gridCol w="593015">
                  <a:extLst>
                    <a:ext uri="{9D8B030D-6E8A-4147-A177-3AD203B41FA5}">
                      <a16:colId xmlns:a16="http://schemas.microsoft.com/office/drawing/2014/main" val="1605347178"/>
                    </a:ext>
                  </a:extLst>
                </a:gridCol>
                <a:gridCol w="640546">
                  <a:extLst>
                    <a:ext uri="{9D8B030D-6E8A-4147-A177-3AD203B41FA5}">
                      <a16:colId xmlns:a16="http://schemas.microsoft.com/office/drawing/2014/main" val="1533135711"/>
                    </a:ext>
                  </a:extLst>
                </a:gridCol>
                <a:gridCol w="640546">
                  <a:extLst>
                    <a:ext uri="{9D8B030D-6E8A-4147-A177-3AD203B41FA5}">
                      <a16:colId xmlns:a16="http://schemas.microsoft.com/office/drawing/2014/main" val="1993072571"/>
                    </a:ext>
                  </a:extLst>
                </a:gridCol>
                <a:gridCol w="640546">
                  <a:extLst>
                    <a:ext uri="{9D8B030D-6E8A-4147-A177-3AD203B41FA5}">
                      <a16:colId xmlns:a16="http://schemas.microsoft.com/office/drawing/2014/main" val="3507692990"/>
                    </a:ext>
                  </a:extLst>
                </a:gridCol>
                <a:gridCol w="640546">
                  <a:extLst>
                    <a:ext uri="{9D8B030D-6E8A-4147-A177-3AD203B41FA5}">
                      <a16:colId xmlns:a16="http://schemas.microsoft.com/office/drawing/2014/main" val="1937407041"/>
                    </a:ext>
                  </a:extLst>
                </a:gridCol>
                <a:gridCol w="595890">
                  <a:extLst>
                    <a:ext uri="{9D8B030D-6E8A-4147-A177-3AD203B41FA5}">
                      <a16:colId xmlns:a16="http://schemas.microsoft.com/office/drawing/2014/main" val="4074745582"/>
                    </a:ext>
                  </a:extLst>
                </a:gridCol>
                <a:gridCol w="685202">
                  <a:extLst>
                    <a:ext uri="{9D8B030D-6E8A-4147-A177-3AD203B41FA5}">
                      <a16:colId xmlns:a16="http://schemas.microsoft.com/office/drawing/2014/main" val="1642147262"/>
                    </a:ext>
                  </a:extLst>
                </a:gridCol>
              </a:tblGrid>
              <a:tr h="219106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gt; 9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95718829"/>
                  </a:ext>
                </a:extLst>
              </a:tr>
              <a:tr h="219106">
                <a:tc gridSpan="8"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 (in years): 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30730660"/>
                  </a:ext>
                </a:extLst>
              </a:tr>
            </a:tbl>
          </a:graphicData>
        </a:graphic>
      </p:graphicFrame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BCA4E4B4-BFCB-64C1-B973-26F2063E9CE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55493857"/>
              </p:ext>
            </p:extLst>
          </p:nvPr>
        </p:nvGraphicFramePr>
        <p:xfrm>
          <a:off x="995239" y="5655785"/>
          <a:ext cx="5063656" cy="5486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79925">
                  <a:extLst>
                    <a:ext uri="{9D8B030D-6E8A-4147-A177-3AD203B41FA5}">
                      <a16:colId xmlns:a16="http://schemas.microsoft.com/office/drawing/2014/main" val="2478681261"/>
                    </a:ext>
                  </a:extLst>
                </a:gridCol>
                <a:gridCol w="585989">
                  <a:extLst>
                    <a:ext uri="{9D8B030D-6E8A-4147-A177-3AD203B41FA5}">
                      <a16:colId xmlns:a16="http://schemas.microsoft.com/office/drawing/2014/main" val="1605347178"/>
                    </a:ext>
                  </a:extLst>
                </a:gridCol>
                <a:gridCol w="632957">
                  <a:extLst>
                    <a:ext uri="{9D8B030D-6E8A-4147-A177-3AD203B41FA5}">
                      <a16:colId xmlns:a16="http://schemas.microsoft.com/office/drawing/2014/main" val="1533135711"/>
                    </a:ext>
                  </a:extLst>
                </a:gridCol>
                <a:gridCol w="632957">
                  <a:extLst>
                    <a:ext uri="{9D8B030D-6E8A-4147-A177-3AD203B41FA5}">
                      <a16:colId xmlns:a16="http://schemas.microsoft.com/office/drawing/2014/main" val="1993072571"/>
                    </a:ext>
                  </a:extLst>
                </a:gridCol>
                <a:gridCol w="632957">
                  <a:extLst>
                    <a:ext uri="{9D8B030D-6E8A-4147-A177-3AD203B41FA5}">
                      <a16:colId xmlns:a16="http://schemas.microsoft.com/office/drawing/2014/main" val="3507692990"/>
                    </a:ext>
                  </a:extLst>
                </a:gridCol>
                <a:gridCol w="632957">
                  <a:extLst>
                    <a:ext uri="{9D8B030D-6E8A-4147-A177-3AD203B41FA5}">
                      <a16:colId xmlns:a16="http://schemas.microsoft.com/office/drawing/2014/main" val="1937407041"/>
                    </a:ext>
                  </a:extLst>
                </a:gridCol>
                <a:gridCol w="588830">
                  <a:extLst>
                    <a:ext uri="{9D8B030D-6E8A-4147-A177-3AD203B41FA5}">
                      <a16:colId xmlns:a16="http://schemas.microsoft.com/office/drawing/2014/main" val="4074745582"/>
                    </a:ext>
                  </a:extLst>
                </a:gridCol>
                <a:gridCol w="677084">
                  <a:extLst>
                    <a:ext uri="{9D8B030D-6E8A-4147-A177-3AD203B41FA5}">
                      <a16:colId xmlns:a16="http://schemas.microsoft.com/office/drawing/2014/main" val="1642147262"/>
                    </a:ext>
                  </a:extLst>
                </a:gridCol>
              </a:tblGrid>
              <a:tr h="219106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gt; 9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95718829"/>
                  </a:ext>
                </a:extLst>
              </a:tr>
              <a:tr h="219106">
                <a:tc gridSpan="8"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 (in years): 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30730660"/>
                  </a:ext>
                </a:extLst>
              </a:tr>
            </a:tbl>
          </a:graphicData>
        </a:graphic>
      </p:graphicFrame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76BE7480-A95E-F37F-F661-D8866A7DAD4F}"/>
              </a:ext>
            </a:extLst>
          </p:cNvPr>
          <p:cNvSpPr/>
          <p:nvPr/>
        </p:nvSpPr>
        <p:spPr>
          <a:xfrm>
            <a:off x="4912659" y="6001251"/>
            <a:ext cx="959223" cy="59238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aphicFrame>
        <p:nvGraphicFramePr>
          <p:cNvPr id="7" name="表 6">
            <a:extLst>
              <a:ext uri="{FF2B5EF4-FFF2-40B4-BE49-F238E27FC236}">
                <a16:creationId xmlns:a16="http://schemas.microsoft.com/office/drawing/2014/main" id="{997F9755-261D-5167-F930-BD04F5CB308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68053050"/>
              </p:ext>
            </p:extLst>
          </p:nvPr>
        </p:nvGraphicFramePr>
        <p:xfrm>
          <a:off x="7045133" y="2556346"/>
          <a:ext cx="4854119" cy="5486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51789">
                  <a:extLst>
                    <a:ext uri="{9D8B030D-6E8A-4147-A177-3AD203B41FA5}">
                      <a16:colId xmlns:a16="http://schemas.microsoft.com/office/drawing/2014/main" val="2478681261"/>
                    </a:ext>
                  </a:extLst>
                </a:gridCol>
                <a:gridCol w="561740">
                  <a:extLst>
                    <a:ext uri="{9D8B030D-6E8A-4147-A177-3AD203B41FA5}">
                      <a16:colId xmlns:a16="http://schemas.microsoft.com/office/drawing/2014/main" val="1605347178"/>
                    </a:ext>
                  </a:extLst>
                </a:gridCol>
                <a:gridCol w="606765">
                  <a:extLst>
                    <a:ext uri="{9D8B030D-6E8A-4147-A177-3AD203B41FA5}">
                      <a16:colId xmlns:a16="http://schemas.microsoft.com/office/drawing/2014/main" val="1533135711"/>
                    </a:ext>
                  </a:extLst>
                </a:gridCol>
                <a:gridCol w="606765">
                  <a:extLst>
                    <a:ext uri="{9D8B030D-6E8A-4147-A177-3AD203B41FA5}">
                      <a16:colId xmlns:a16="http://schemas.microsoft.com/office/drawing/2014/main" val="1993072571"/>
                    </a:ext>
                  </a:extLst>
                </a:gridCol>
                <a:gridCol w="606765">
                  <a:extLst>
                    <a:ext uri="{9D8B030D-6E8A-4147-A177-3AD203B41FA5}">
                      <a16:colId xmlns:a16="http://schemas.microsoft.com/office/drawing/2014/main" val="3507692990"/>
                    </a:ext>
                  </a:extLst>
                </a:gridCol>
                <a:gridCol w="606765">
                  <a:extLst>
                    <a:ext uri="{9D8B030D-6E8A-4147-A177-3AD203B41FA5}">
                      <a16:colId xmlns:a16="http://schemas.microsoft.com/office/drawing/2014/main" val="1937407041"/>
                    </a:ext>
                  </a:extLst>
                </a:gridCol>
                <a:gridCol w="564464">
                  <a:extLst>
                    <a:ext uri="{9D8B030D-6E8A-4147-A177-3AD203B41FA5}">
                      <a16:colId xmlns:a16="http://schemas.microsoft.com/office/drawing/2014/main" val="4074745582"/>
                    </a:ext>
                  </a:extLst>
                </a:gridCol>
                <a:gridCol w="649066">
                  <a:extLst>
                    <a:ext uri="{9D8B030D-6E8A-4147-A177-3AD203B41FA5}">
                      <a16:colId xmlns:a16="http://schemas.microsoft.com/office/drawing/2014/main" val="1642147262"/>
                    </a:ext>
                  </a:extLst>
                </a:gridCol>
              </a:tblGrid>
              <a:tr h="219106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gt; 9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95718829"/>
                  </a:ext>
                </a:extLst>
              </a:tr>
              <a:tr h="219106">
                <a:tc gridSpan="8"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 (in years): 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30730660"/>
                  </a:ext>
                </a:extLst>
              </a:tr>
            </a:tbl>
          </a:graphicData>
        </a:graphic>
      </p:graphicFrame>
      <p:graphicFrame>
        <p:nvGraphicFramePr>
          <p:cNvPr id="10" name="表 9">
            <a:extLst>
              <a:ext uri="{FF2B5EF4-FFF2-40B4-BE49-F238E27FC236}">
                <a16:creationId xmlns:a16="http://schemas.microsoft.com/office/drawing/2014/main" id="{B757239D-C5E1-7255-F717-8B5B357132F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67012340"/>
              </p:ext>
            </p:extLst>
          </p:nvPr>
        </p:nvGraphicFramePr>
        <p:xfrm>
          <a:off x="7005000" y="5693128"/>
          <a:ext cx="4854119" cy="5486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51789">
                  <a:extLst>
                    <a:ext uri="{9D8B030D-6E8A-4147-A177-3AD203B41FA5}">
                      <a16:colId xmlns:a16="http://schemas.microsoft.com/office/drawing/2014/main" val="2478681261"/>
                    </a:ext>
                  </a:extLst>
                </a:gridCol>
                <a:gridCol w="561740">
                  <a:extLst>
                    <a:ext uri="{9D8B030D-6E8A-4147-A177-3AD203B41FA5}">
                      <a16:colId xmlns:a16="http://schemas.microsoft.com/office/drawing/2014/main" val="1605347178"/>
                    </a:ext>
                  </a:extLst>
                </a:gridCol>
                <a:gridCol w="606765">
                  <a:extLst>
                    <a:ext uri="{9D8B030D-6E8A-4147-A177-3AD203B41FA5}">
                      <a16:colId xmlns:a16="http://schemas.microsoft.com/office/drawing/2014/main" val="1533135711"/>
                    </a:ext>
                  </a:extLst>
                </a:gridCol>
                <a:gridCol w="606765">
                  <a:extLst>
                    <a:ext uri="{9D8B030D-6E8A-4147-A177-3AD203B41FA5}">
                      <a16:colId xmlns:a16="http://schemas.microsoft.com/office/drawing/2014/main" val="1993072571"/>
                    </a:ext>
                  </a:extLst>
                </a:gridCol>
                <a:gridCol w="606765">
                  <a:extLst>
                    <a:ext uri="{9D8B030D-6E8A-4147-A177-3AD203B41FA5}">
                      <a16:colId xmlns:a16="http://schemas.microsoft.com/office/drawing/2014/main" val="3507692990"/>
                    </a:ext>
                  </a:extLst>
                </a:gridCol>
                <a:gridCol w="606765">
                  <a:extLst>
                    <a:ext uri="{9D8B030D-6E8A-4147-A177-3AD203B41FA5}">
                      <a16:colId xmlns:a16="http://schemas.microsoft.com/office/drawing/2014/main" val="1937407041"/>
                    </a:ext>
                  </a:extLst>
                </a:gridCol>
                <a:gridCol w="564464">
                  <a:extLst>
                    <a:ext uri="{9D8B030D-6E8A-4147-A177-3AD203B41FA5}">
                      <a16:colId xmlns:a16="http://schemas.microsoft.com/office/drawing/2014/main" val="4074745582"/>
                    </a:ext>
                  </a:extLst>
                </a:gridCol>
                <a:gridCol w="649066">
                  <a:extLst>
                    <a:ext uri="{9D8B030D-6E8A-4147-A177-3AD203B41FA5}">
                      <a16:colId xmlns:a16="http://schemas.microsoft.com/office/drawing/2014/main" val="1642147262"/>
                    </a:ext>
                  </a:extLst>
                </a:gridCol>
              </a:tblGrid>
              <a:tr h="219106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gt; 9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95718829"/>
                  </a:ext>
                </a:extLst>
              </a:tr>
              <a:tr h="219106">
                <a:tc gridSpan="8"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 (in years): 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30730660"/>
                  </a:ext>
                </a:extLst>
              </a:tr>
            </a:tbl>
          </a:graphicData>
        </a:graphic>
      </p:graphicFrame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9BB22763-9C54-2E73-73D0-1D0E14FC4266}"/>
              </a:ext>
            </a:extLst>
          </p:cNvPr>
          <p:cNvSpPr/>
          <p:nvPr/>
        </p:nvSpPr>
        <p:spPr>
          <a:xfrm>
            <a:off x="10896307" y="5978693"/>
            <a:ext cx="959223" cy="59238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09953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FB7A054C-45FA-8C23-63F7-35CCB13F47B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82428506"/>
              </p:ext>
            </p:extLst>
          </p:nvPr>
        </p:nvGraphicFramePr>
        <p:xfrm>
          <a:off x="1404011" y="1601813"/>
          <a:ext cx="4640898" cy="32603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" name="テキスト ボックス 1">
            <a:extLst>
              <a:ext uri="{FF2B5EF4-FFF2-40B4-BE49-F238E27FC236}">
                <a16:creationId xmlns:a16="http://schemas.microsoft.com/office/drawing/2014/main" id="{6A153F33-4155-A0CE-1764-D801950FFBF8}"/>
              </a:ext>
            </a:extLst>
          </p:cNvPr>
          <p:cNvSpPr txBox="1"/>
          <p:nvPr/>
        </p:nvSpPr>
        <p:spPr>
          <a:xfrm>
            <a:off x="484618" y="2345019"/>
            <a:ext cx="412708" cy="495300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gular</a:t>
            </a:r>
            <a:endParaRPr lang="en-US" altLang="ja-JP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sits</a:t>
            </a:r>
          </a:p>
        </p:txBody>
      </p:sp>
      <p:sp>
        <p:nvSpPr>
          <p:cNvPr id="4" name="テキスト ボックス 1">
            <a:extLst>
              <a:ext uri="{FF2B5EF4-FFF2-40B4-BE49-F238E27FC236}">
                <a16:creationId xmlns:a16="http://schemas.microsoft.com/office/drawing/2014/main" id="{EE5C76BB-7524-46E6-BB24-32DE3B26E21B}"/>
              </a:ext>
            </a:extLst>
          </p:cNvPr>
          <p:cNvSpPr txBox="1"/>
          <p:nvPr/>
        </p:nvSpPr>
        <p:spPr>
          <a:xfrm>
            <a:off x="1197656" y="2345019"/>
            <a:ext cx="412709" cy="495300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MC</a:t>
            </a:r>
          </a:p>
          <a:p>
            <a:pPr algn="ctr"/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erience</a:t>
            </a:r>
            <a:endParaRPr lang="en-US" altLang="ja-JP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1">
            <a:extLst>
              <a:ext uri="{FF2B5EF4-FFF2-40B4-BE49-F238E27FC236}">
                <a16:creationId xmlns:a16="http://schemas.microsoft.com/office/drawing/2014/main" id="{20E34D9E-E7CD-C390-200A-AB39A15B1277}"/>
              </a:ext>
            </a:extLst>
          </p:cNvPr>
          <p:cNvSpPr txBox="1"/>
          <p:nvPr/>
        </p:nvSpPr>
        <p:spPr>
          <a:xfrm>
            <a:off x="565454" y="2840319"/>
            <a:ext cx="251036" cy="349134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Yes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1">
            <a:extLst>
              <a:ext uri="{FF2B5EF4-FFF2-40B4-BE49-F238E27FC236}">
                <a16:creationId xmlns:a16="http://schemas.microsoft.com/office/drawing/2014/main" id="{6E65645A-E951-A3AD-4DFD-681AB79B3B7F}"/>
              </a:ext>
            </a:extLst>
          </p:cNvPr>
          <p:cNvSpPr txBox="1"/>
          <p:nvPr/>
        </p:nvSpPr>
        <p:spPr>
          <a:xfrm>
            <a:off x="565454" y="3232563"/>
            <a:ext cx="251036" cy="349134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Yes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1">
            <a:extLst>
              <a:ext uri="{FF2B5EF4-FFF2-40B4-BE49-F238E27FC236}">
                <a16:creationId xmlns:a16="http://schemas.microsoft.com/office/drawing/2014/main" id="{DD0C7A61-DFEF-6B00-8AA6-CE3F9AD87B1D}"/>
              </a:ext>
            </a:extLst>
          </p:cNvPr>
          <p:cNvSpPr txBox="1"/>
          <p:nvPr/>
        </p:nvSpPr>
        <p:spPr>
          <a:xfrm>
            <a:off x="565454" y="3624807"/>
            <a:ext cx="251036" cy="349134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1">
            <a:extLst>
              <a:ext uri="{FF2B5EF4-FFF2-40B4-BE49-F238E27FC236}">
                <a16:creationId xmlns:a16="http://schemas.microsoft.com/office/drawing/2014/main" id="{A604D430-E7C8-FE01-4FBB-C36CF10436CD}"/>
              </a:ext>
            </a:extLst>
          </p:cNvPr>
          <p:cNvSpPr txBox="1"/>
          <p:nvPr/>
        </p:nvSpPr>
        <p:spPr>
          <a:xfrm>
            <a:off x="565454" y="4017051"/>
            <a:ext cx="251036" cy="349134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1">
            <a:extLst>
              <a:ext uri="{FF2B5EF4-FFF2-40B4-BE49-F238E27FC236}">
                <a16:creationId xmlns:a16="http://schemas.microsoft.com/office/drawing/2014/main" id="{4092F427-FDF8-9D54-BCF9-00D88286FD2F}"/>
              </a:ext>
            </a:extLst>
          </p:cNvPr>
          <p:cNvSpPr txBox="1"/>
          <p:nvPr/>
        </p:nvSpPr>
        <p:spPr>
          <a:xfrm>
            <a:off x="1278492" y="2840319"/>
            <a:ext cx="251036" cy="349134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1">
            <a:extLst>
              <a:ext uri="{FF2B5EF4-FFF2-40B4-BE49-F238E27FC236}">
                <a16:creationId xmlns:a16="http://schemas.microsoft.com/office/drawing/2014/main" id="{A3ED01B6-C7F6-BF77-F41E-5B82EAAFBF20}"/>
              </a:ext>
            </a:extLst>
          </p:cNvPr>
          <p:cNvSpPr txBox="1"/>
          <p:nvPr/>
        </p:nvSpPr>
        <p:spPr>
          <a:xfrm>
            <a:off x="1278492" y="3232563"/>
            <a:ext cx="251036" cy="349134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Yes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">
            <a:extLst>
              <a:ext uri="{FF2B5EF4-FFF2-40B4-BE49-F238E27FC236}">
                <a16:creationId xmlns:a16="http://schemas.microsoft.com/office/drawing/2014/main" id="{2BC9953D-6FB5-F2F7-2772-D346FE95732E}"/>
              </a:ext>
            </a:extLst>
          </p:cNvPr>
          <p:cNvSpPr txBox="1"/>
          <p:nvPr/>
        </p:nvSpPr>
        <p:spPr>
          <a:xfrm>
            <a:off x="1278492" y="3624807"/>
            <a:ext cx="251036" cy="349134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">
            <a:extLst>
              <a:ext uri="{FF2B5EF4-FFF2-40B4-BE49-F238E27FC236}">
                <a16:creationId xmlns:a16="http://schemas.microsoft.com/office/drawing/2014/main" id="{ABC56186-B44C-5BFE-45B6-D45FD819FBDA}"/>
              </a:ext>
            </a:extLst>
          </p:cNvPr>
          <p:cNvSpPr txBox="1"/>
          <p:nvPr/>
        </p:nvSpPr>
        <p:spPr>
          <a:xfrm>
            <a:off x="1278492" y="4017051"/>
            <a:ext cx="251036" cy="349134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Yes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5519CE5B-541B-B8D8-D789-60A6F10994ED}"/>
              </a:ext>
            </a:extLst>
          </p:cNvPr>
          <p:cNvSpPr txBox="1"/>
          <p:nvPr/>
        </p:nvSpPr>
        <p:spPr>
          <a:xfrm>
            <a:off x="2375965" y="2021853"/>
            <a:ext cx="3132589" cy="64633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ny medical facilities nearby</a:t>
            </a: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asonable number of medical facilities nearby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ew medical facilities nearby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2C6DC006-27C0-3C3C-4B94-3DC754053C9A}"/>
              </a:ext>
            </a:extLst>
          </p:cNvPr>
          <p:cNvSpPr txBox="1"/>
          <p:nvPr/>
        </p:nvSpPr>
        <p:spPr>
          <a:xfrm>
            <a:off x="236093" y="1691419"/>
            <a:ext cx="2872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5DEA958D-01B0-0827-DDD6-7ED1F4AC1EB1}"/>
              </a:ext>
            </a:extLst>
          </p:cNvPr>
          <p:cNvSpPr txBox="1"/>
          <p:nvPr/>
        </p:nvSpPr>
        <p:spPr>
          <a:xfrm>
            <a:off x="6224047" y="1691419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2" name="グラフ 21">
            <a:extLst>
              <a:ext uri="{FF2B5EF4-FFF2-40B4-BE49-F238E27FC236}">
                <a16:creationId xmlns:a16="http://schemas.microsoft.com/office/drawing/2014/main" id="{F28BB73B-DC4B-13D4-C9FE-ED266BD68A8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66103614"/>
              </p:ext>
            </p:extLst>
          </p:nvPr>
        </p:nvGraphicFramePr>
        <p:xfrm>
          <a:off x="6224047" y="1876085"/>
          <a:ext cx="5762625" cy="27990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3" name="テキスト ボックス 1">
            <a:extLst>
              <a:ext uri="{FF2B5EF4-FFF2-40B4-BE49-F238E27FC236}">
                <a16:creationId xmlns:a16="http://schemas.microsoft.com/office/drawing/2014/main" id="{67EB9201-C72C-F03D-675A-9F6B4CCA3DDC}"/>
              </a:ext>
            </a:extLst>
          </p:cNvPr>
          <p:cNvSpPr txBox="1"/>
          <p:nvPr/>
        </p:nvSpPr>
        <p:spPr>
          <a:xfrm>
            <a:off x="6462529" y="2344438"/>
            <a:ext cx="412708" cy="495300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gular</a:t>
            </a:r>
            <a:endParaRPr lang="en-US" altLang="ja-JP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sits</a:t>
            </a:r>
          </a:p>
        </p:txBody>
      </p:sp>
      <p:sp>
        <p:nvSpPr>
          <p:cNvPr id="24" name="テキスト ボックス 1">
            <a:extLst>
              <a:ext uri="{FF2B5EF4-FFF2-40B4-BE49-F238E27FC236}">
                <a16:creationId xmlns:a16="http://schemas.microsoft.com/office/drawing/2014/main" id="{E377D41A-7A94-1955-9B90-B67DFEFC06CC}"/>
              </a:ext>
            </a:extLst>
          </p:cNvPr>
          <p:cNvSpPr txBox="1"/>
          <p:nvPr/>
        </p:nvSpPr>
        <p:spPr>
          <a:xfrm>
            <a:off x="7175567" y="2344438"/>
            <a:ext cx="412709" cy="495300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MC</a:t>
            </a:r>
          </a:p>
          <a:p>
            <a:pPr algn="ctr"/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erience</a:t>
            </a:r>
            <a:endParaRPr lang="en-US" altLang="ja-JP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1">
            <a:extLst>
              <a:ext uri="{FF2B5EF4-FFF2-40B4-BE49-F238E27FC236}">
                <a16:creationId xmlns:a16="http://schemas.microsoft.com/office/drawing/2014/main" id="{BB43367C-CECB-5768-169E-DB52DF0F3144}"/>
              </a:ext>
            </a:extLst>
          </p:cNvPr>
          <p:cNvSpPr txBox="1"/>
          <p:nvPr/>
        </p:nvSpPr>
        <p:spPr>
          <a:xfrm>
            <a:off x="6543365" y="2839738"/>
            <a:ext cx="251036" cy="349134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Yes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1">
            <a:extLst>
              <a:ext uri="{FF2B5EF4-FFF2-40B4-BE49-F238E27FC236}">
                <a16:creationId xmlns:a16="http://schemas.microsoft.com/office/drawing/2014/main" id="{274779D9-2718-9780-E39C-396F49AC9D36}"/>
              </a:ext>
            </a:extLst>
          </p:cNvPr>
          <p:cNvSpPr txBox="1"/>
          <p:nvPr/>
        </p:nvSpPr>
        <p:spPr>
          <a:xfrm>
            <a:off x="6543365" y="3231982"/>
            <a:ext cx="251036" cy="349134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Yes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1">
            <a:extLst>
              <a:ext uri="{FF2B5EF4-FFF2-40B4-BE49-F238E27FC236}">
                <a16:creationId xmlns:a16="http://schemas.microsoft.com/office/drawing/2014/main" id="{A03FA0DD-6C5D-86C0-6D6C-ACC43F055CD8}"/>
              </a:ext>
            </a:extLst>
          </p:cNvPr>
          <p:cNvSpPr txBox="1"/>
          <p:nvPr/>
        </p:nvSpPr>
        <p:spPr>
          <a:xfrm>
            <a:off x="6543365" y="3624226"/>
            <a:ext cx="251036" cy="349134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1">
            <a:extLst>
              <a:ext uri="{FF2B5EF4-FFF2-40B4-BE49-F238E27FC236}">
                <a16:creationId xmlns:a16="http://schemas.microsoft.com/office/drawing/2014/main" id="{B643971A-30BF-75FC-A265-5DE525AA0990}"/>
              </a:ext>
            </a:extLst>
          </p:cNvPr>
          <p:cNvSpPr txBox="1"/>
          <p:nvPr/>
        </p:nvSpPr>
        <p:spPr>
          <a:xfrm>
            <a:off x="6543365" y="4016470"/>
            <a:ext cx="251036" cy="349134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1">
            <a:extLst>
              <a:ext uri="{FF2B5EF4-FFF2-40B4-BE49-F238E27FC236}">
                <a16:creationId xmlns:a16="http://schemas.microsoft.com/office/drawing/2014/main" id="{841A162F-6D00-FE0B-7872-641E64C04D1A}"/>
              </a:ext>
            </a:extLst>
          </p:cNvPr>
          <p:cNvSpPr txBox="1"/>
          <p:nvPr/>
        </p:nvSpPr>
        <p:spPr>
          <a:xfrm>
            <a:off x="7256403" y="2839738"/>
            <a:ext cx="251036" cy="349134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テキスト ボックス 1">
            <a:extLst>
              <a:ext uri="{FF2B5EF4-FFF2-40B4-BE49-F238E27FC236}">
                <a16:creationId xmlns:a16="http://schemas.microsoft.com/office/drawing/2014/main" id="{A43A1AFF-503B-05C1-9228-71CB426611F4}"/>
              </a:ext>
            </a:extLst>
          </p:cNvPr>
          <p:cNvSpPr txBox="1"/>
          <p:nvPr/>
        </p:nvSpPr>
        <p:spPr>
          <a:xfrm>
            <a:off x="7256403" y="3231982"/>
            <a:ext cx="251036" cy="349134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Yes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1">
            <a:extLst>
              <a:ext uri="{FF2B5EF4-FFF2-40B4-BE49-F238E27FC236}">
                <a16:creationId xmlns:a16="http://schemas.microsoft.com/office/drawing/2014/main" id="{2595E8B5-4F1F-1A1C-34D4-469172C5D69A}"/>
              </a:ext>
            </a:extLst>
          </p:cNvPr>
          <p:cNvSpPr txBox="1"/>
          <p:nvPr/>
        </p:nvSpPr>
        <p:spPr>
          <a:xfrm>
            <a:off x="7256403" y="3624226"/>
            <a:ext cx="251036" cy="349134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テキスト ボックス 1">
            <a:extLst>
              <a:ext uri="{FF2B5EF4-FFF2-40B4-BE49-F238E27FC236}">
                <a16:creationId xmlns:a16="http://schemas.microsoft.com/office/drawing/2014/main" id="{A21D58EB-16F6-B050-9E15-1F06E9B1F100}"/>
              </a:ext>
            </a:extLst>
          </p:cNvPr>
          <p:cNvSpPr txBox="1"/>
          <p:nvPr/>
        </p:nvSpPr>
        <p:spPr>
          <a:xfrm>
            <a:off x="7256403" y="4016470"/>
            <a:ext cx="251036" cy="349134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Yes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38A8F88C-6BE0-D670-ED22-233CEF5A2ED3}"/>
              </a:ext>
            </a:extLst>
          </p:cNvPr>
          <p:cNvSpPr txBox="1"/>
          <p:nvPr/>
        </p:nvSpPr>
        <p:spPr>
          <a:xfrm>
            <a:off x="8187032" y="2088347"/>
            <a:ext cx="1700186" cy="47737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>
              <a:lnSpc>
                <a:spcPts val="1500"/>
              </a:lnSpc>
            </a:pP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stantial effort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quired</a:t>
            </a:r>
          </a:p>
          <a:p>
            <a:pPr>
              <a:lnSpc>
                <a:spcPts val="1700"/>
              </a:lnSpc>
            </a:pP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gligible effort required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3361BB77-5032-3B60-C0CA-A00A20FD09EB}"/>
              </a:ext>
            </a:extLst>
          </p:cNvPr>
          <p:cNvSpPr txBox="1"/>
          <p:nvPr/>
        </p:nvSpPr>
        <p:spPr>
          <a:xfrm>
            <a:off x="10109292" y="2088345"/>
            <a:ext cx="1598089" cy="48032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>
              <a:lnSpc>
                <a:spcPts val="1500"/>
              </a:lnSpc>
            </a:pP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nimal effort required</a:t>
            </a:r>
            <a:endParaRPr kumimoji="1" lang="en-US" altLang="ja-JP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ts val="1700"/>
              </a:lnSpc>
            </a:pP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 effort required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31C670E7-3CDF-68EC-8C03-1C53676082C6}"/>
              </a:ext>
            </a:extLst>
          </p:cNvPr>
          <p:cNvSpPr txBox="1"/>
          <p:nvPr/>
        </p:nvSpPr>
        <p:spPr>
          <a:xfrm>
            <a:off x="10918058" y="2517623"/>
            <a:ext cx="7344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.01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00BD13F7-70A8-D8A2-F9CD-DA6CC3F5CDFB}"/>
              </a:ext>
            </a:extLst>
          </p:cNvPr>
          <p:cNvSpPr txBox="1"/>
          <p:nvPr/>
        </p:nvSpPr>
        <p:spPr>
          <a:xfrm>
            <a:off x="4893424" y="2527290"/>
            <a:ext cx="7344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.01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A30445C8-DCEC-DD2A-E18E-75AE2DEFE5BE}"/>
              </a:ext>
            </a:extLst>
          </p:cNvPr>
          <p:cNvSpPr txBox="1"/>
          <p:nvPr/>
        </p:nvSpPr>
        <p:spPr>
          <a:xfrm>
            <a:off x="208348" y="50491"/>
            <a:ext cx="1182251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6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2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erience with online medical care (OMC) and number of nearby medical facilities and effort for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spital visits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results of patients/general survey)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テキスト ボックス 1">
            <a:extLst>
              <a:ext uri="{FF2B5EF4-FFF2-40B4-BE49-F238E27FC236}">
                <a16:creationId xmlns:a16="http://schemas.microsoft.com/office/drawing/2014/main" id="{25446698-C03D-4DA7-A011-873F2ED1990C}"/>
              </a:ext>
            </a:extLst>
          </p:cNvPr>
          <p:cNvSpPr txBox="1"/>
          <p:nvPr/>
        </p:nvSpPr>
        <p:spPr>
          <a:xfrm>
            <a:off x="11512818" y="4124183"/>
            <a:ext cx="4667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%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062753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30C9DC5A-513F-6441-25DC-FE7521BCFE5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87633403"/>
              </p:ext>
            </p:extLst>
          </p:nvPr>
        </p:nvGraphicFramePr>
        <p:xfrm>
          <a:off x="254686" y="1764404"/>
          <a:ext cx="5269813" cy="44649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E32480DB-EAC3-BF56-3055-188C1656FA90}"/>
              </a:ext>
            </a:extLst>
          </p:cNvPr>
          <p:cNvSpPr txBox="1"/>
          <p:nvPr/>
        </p:nvSpPr>
        <p:spPr>
          <a:xfrm>
            <a:off x="95042" y="2013543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E1005B57-0951-BA99-573B-49170BD5304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31153701"/>
              </p:ext>
            </p:extLst>
          </p:nvPr>
        </p:nvGraphicFramePr>
        <p:xfrm>
          <a:off x="5958863" y="1764404"/>
          <a:ext cx="5704176" cy="42500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8DBC2674-1A80-10B6-D021-8B1822B4A134}"/>
              </a:ext>
            </a:extLst>
          </p:cNvPr>
          <p:cNvSpPr txBox="1"/>
          <p:nvPr/>
        </p:nvSpPr>
        <p:spPr>
          <a:xfrm>
            <a:off x="5958863" y="2013543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DF6FACF3-95FC-8801-F382-1E6E8084FF76}"/>
              </a:ext>
            </a:extLst>
          </p:cNvPr>
          <p:cNvSpPr txBox="1"/>
          <p:nvPr/>
        </p:nvSpPr>
        <p:spPr>
          <a:xfrm>
            <a:off x="208348" y="50491"/>
            <a:ext cx="1182251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kumimoji="1" lang="en-US" altLang="ja-JP" sz="16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Current frequency of visits and (b) time required for one-way trip to the hospital for the group with regular visits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0" name="表 9">
            <a:extLst>
              <a:ext uri="{FF2B5EF4-FFF2-40B4-BE49-F238E27FC236}">
                <a16:creationId xmlns:a16="http://schemas.microsoft.com/office/drawing/2014/main" id="{A21C499E-7FB1-49EE-10AF-37EA73299A5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27375892"/>
              </p:ext>
            </p:extLst>
          </p:nvPr>
        </p:nvGraphicFramePr>
        <p:xfrm>
          <a:off x="686676" y="4745127"/>
          <a:ext cx="4669655" cy="139291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33931">
                  <a:extLst>
                    <a:ext uri="{9D8B030D-6E8A-4147-A177-3AD203B41FA5}">
                      <a16:colId xmlns:a16="http://schemas.microsoft.com/office/drawing/2014/main" val="3652479019"/>
                    </a:ext>
                  </a:extLst>
                </a:gridCol>
                <a:gridCol w="933931">
                  <a:extLst>
                    <a:ext uri="{9D8B030D-6E8A-4147-A177-3AD203B41FA5}">
                      <a16:colId xmlns:a16="http://schemas.microsoft.com/office/drawing/2014/main" val="2000502966"/>
                    </a:ext>
                  </a:extLst>
                </a:gridCol>
                <a:gridCol w="933931">
                  <a:extLst>
                    <a:ext uri="{9D8B030D-6E8A-4147-A177-3AD203B41FA5}">
                      <a16:colId xmlns:a16="http://schemas.microsoft.com/office/drawing/2014/main" val="2429453409"/>
                    </a:ext>
                  </a:extLst>
                </a:gridCol>
                <a:gridCol w="933931">
                  <a:extLst>
                    <a:ext uri="{9D8B030D-6E8A-4147-A177-3AD203B41FA5}">
                      <a16:colId xmlns:a16="http://schemas.microsoft.com/office/drawing/2014/main" val="2141935370"/>
                    </a:ext>
                  </a:extLst>
                </a:gridCol>
                <a:gridCol w="933931">
                  <a:extLst>
                    <a:ext uri="{9D8B030D-6E8A-4147-A177-3AD203B41FA5}">
                      <a16:colId xmlns:a16="http://schemas.microsoft.com/office/drawing/2014/main" val="3771811147"/>
                    </a:ext>
                  </a:extLst>
                </a:gridCol>
              </a:tblGrid>
              <a:tr h="714046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nce a week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nce in 2 weeks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nce a month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nce in 2 months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nce in 3 months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29291821"/>
                  </a:ext>
                </a:extLst>
              </a:tr>
              <a:tr h="678867">
                <a:tc>
                  <a:txBody>
                    <a:bodyPr/>
                    <a:lstStyle/>
                    <a:p>
                      <a:pPr algn="ctr"/>
                      <a:endParaRPr kumimoji="1" lang="ja-JP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en-US" altLang="ja-JP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28207220"/>
                  </a:ext>
                </a:extLst>
              </a:tr>
            </a:tbl>
          </a:graphicData>
        </a:graphic>
      </p:graphicFrame>
      <p:graphicFrame>
        <p:nvGraphicFramePr>
          <p:cNvPr id="11" name="表 10">
            <a:extLst>
              <a:ext uri="{FF2B5EF4-FFF2-40B4-BE49-F238E27FC236}">
                <a16:creationId xmlns:a16="http://schemas.microsoft.com/office/drawing/2014/main" id="{7F7F6A6F-B78F-B404-F115-404C3E11F7D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28764814"/>
              </p:ext>
            </p:extLst>
          </p:nvPr>
        </p:nvGraphicFramePr>
        <p:xfrm>
          <a:off x="6543365" y="4745127"/>
          <a:ext cx="4836508" cy="7975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09127">
                  <a:extLst>
                    <a:ext uri="{9D8B030D-6E8A-4147-A177-3AD203B41FA5}">
                      <a16:colId xmlns:a16="http://schemas.microsoft.com/office/drawing/2014/main" val="3652479019"/>
                    </a:ext>
                  </a:extLst>
                </a:gridCol>
                <a:gridCol w="1049763">
                  <a:extLst>
                    <a:ext uri="{9D8B030D-6E8A-4147-A177-3AD203B41FA5}">
                      <a16:colId xmlns:a16="http://schemas.microsoft.com/office/drawing/2014/main" val="2000502966"/>
                    </a:ext>
                  </a:extLst>
                </a:gridCol>
                <a:gridCol w="1368491">
                  <a:extLst>
                    <a:ext uri="{9D8B030D-6E8A-4147-A177-3AD203B41FA5}">
                      <a16:colId xmlns:a16="http://schemas.microsoft.com/office/drawing/2014/main" val="2429453409"/>
                    </a:ext>
                  </a:extLst>
                </a:gridCol>
                <a:gridCol w="1209127">
                  <a:extLst>
                    <a:ext uri="{9D8B030D-6E8A-4147-A177-3AD203B41FA5}">
                      <a16:colId xmlns:a16="http://schemas.microsoft.com/office/drawing/2014/main" val="2141935370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ss than </a:t>
                      </a:r>
                    </a:p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 min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 min </a:t>
                      </a:r>
                    </a:p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 1 h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to 2 h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re than </a:t>
                      </a:r>
                    </a:p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 h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2929182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endParaRPr kumimoji="1" lang="ja-JP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en-US" altLang="ja-JP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25254136"/>
                  </a:ext>
                </a:extLst>
              </a:tr>
            </a:tbl>
          </a:graphicData>
        </a:graphic>
      </p:graphicFrame>
      <p:pic>
        <p:nvPicPr>
          <p:cNvPr id="14" name="図 13">
            <a:extLst>
              <a:ext uri="{FF2B5EF4-FFF2-40B4-BE49-F238E27FC236}">
                <a16:creationId xmlns:a16="http://schemas.microsoft.com/office/drawing/2014/main" id="{27C80025-D6B3-54C8-3048-8C9B17F0923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66458" y="5639585"/>
            <a:ext cx="5705905" cy="419552"/>
          </a:xfrm>
          <a:prstGeom prst="rect">
            <a:avLst/>
          </a:prstGeom>
        </p:spPr>
      </p:pic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194F477C-63B1-1951-D4DB-C7792E9B107D}"/>
              </a:ext>
            </a:extLst>
          </p:cNvPr>
          <p:cNvSpPr txBox="1"/>
          <p:nvPr/>
        </p:nvSpPr>
        <p:spPr>
          <a:xfrm>
            <a:off x="3759706" y="5738602"/>
            <a:ext cx="2418132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out OMC experience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3C59BB73-A726-4D02-E42E-33DD81A2B151}"/>
              </a:ext>
            </a:extLst>
          </p:cNvPr>
          <p:cNvSpPr txBox="1"/>
          <p:nvPr/>
        </p:nvSpPr>
        <p:spPr>
          <a:xfrm>
            <a:off x="6667503" y="5732755"/>
            <a:ext cx="2418132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OMC experience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22D1034-6E0F-085D-6F72-06102AD94F90}"/>
              </a:ext>
            </a:extLst>
          </p:cNvPr>
          <p:cNvSpPr txBox="1"/>
          <p:nvPr/>
        </p:nvSpPr>
        <p:spPr>
          <a:xfrm>
            <a:off x="236093" y="1638869"/>
            <a:ext cx="2872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F087A9B0-AC4F-FE8D-3926-A0DB22022339}"/>
              </a:ext>
            </a:extLst>
          </p:cNvPr>
          <p:cNvSpPr txBox="1"/>
          <p:nvPr/>
        </p:nvSpPr>
        <p:spPr>
          <a:xfrm>
            <a:off x="6224047" y="1638869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DD470F56-2B4F-4D75-A7BF-CCFD02CE7FEF}"/>
              </a:ext>
            </a:extLst>
          </p:cNvPr>
          <p:cNvSpPr txBox="1"/>
          <p:nvPr/>
        </p:nvSpPr>
        <p:spPr>
          <a:xfrm>
            <a:off x="7485677" y="6310189"/>
            <a:ext cx="417736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MC; online medical care. 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4682741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A61E030-AEAB-E92E-487F-99D9FB3C799E}"/>
              </a:ext>
            </a:extLst>
          </p:cNvPr>
          <p:cNvSpPr txBox="1"/>
          <p:nvPr/>
        </p:nvSpPr>
        <p:spPr>
          <a:xfrm>
            <a:off x="208348" y="50491"/>
            <a:ext cx="11822519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ja-JP" sz="16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Patients eligible for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MC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tribution of r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sponses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garding the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ercentage of patients attending their hospital who would benefit from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MC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a) Overall results and (b) stratified results by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MC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actice. Distribution of responses regarding the maximum age at which OMC can be performed alone; (c) Overall results and (d) stratified results by OMC practice.  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E374EA38-DAB4-620D-4349-9C3241335FA9}"/>
              </a:ext>
            </a:extLst>
          </p:cNvPr>
          <p:cNvSpPr txBox="1"/>
          <p:nvPr/>
        </p:nvSpPr>
        <p:spPr>
          <a:xfrm>
            <a:off x="442074" y="1035663"/>
            <a:ext cx="2872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6E83A5A-E3BB-69EE-9468-04BDE033AD0E}"/>
              </a:ext>
            </a:extLst>
          </p:cNvPr>
          <p:cNvSpPr txBox="1"/>
          <p:nvPr/>
        </p:nvSpPr>
        <p:spPr>
          <a:xfrm>
            <a:off x="5939547" y="1035663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5C9AF64B-2E36-0640-1F50-1BD4ED5C8CF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22037056"/>
              </p:ext>
            </p:extLst>
          </p:nvPr>
        </p:nvGraphicFramePr>
        <p:xfrm>
          <a:off x="425324" y="1265275"/>
          <a:ext cx="5066917" cy="251411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DF3D346B-4DDB-10E3-89DA-F55E3FA5404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61632905"/>
              </p:ext>
            </p:extLst>
          </p:nvPr>
        </p:nvGraphicFramePr>
        <p:xfrm>
          <a:off x="6164385" y="1404995"/>
          <a:ext cx="5608319" cy="21897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1CF4EBD5-5FDF-B34F-FF84-8EC9E328DC6E}"/>
              </a:ext>
            </a:extLst>
          </p:cNvPr>
          <p:cNvSpPr txBox="1"/>
          <p:nvPr/>
        </p:nvSpPr>
        <p:spPr>
          <a:xfrm>
            <a:off x="6109491" y="1636966"/>
            <a:ext cx="1267703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Yes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539B990B-0D19-62CF-EF60-2C0F0145C1E4}"/>
              </a:ext>
            </a:extLst>
          </p:cNvPr>
          <p:cNvSpPr txBox="1"/>
          <p:nvPr/>
        </p:nvSpPr>
        <p:spPr>
          <a:xfrm>
            <a:off x="6109491" y="2130529"/>
            <a:ext cx="1267703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Yes/No 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0ED4EDDA-5AD4-AB8A-BA79-A7E32C333320}"/>
              </a:ext>
            </a:extLst>
          </p:cNvPr>
          <p:cNvSpPr txBox="1"/>
          <p:nvPr/>
        </p:nvSpPr>
        <p:spPr>
          <a:xfrm>
            <a:off x="6109491" y="2624092"/>
            <a:ext cx="1267703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90A35013-32E3-7FF0-ECB5-BBBC46648C3A}"/>
              </a:ext>
            </a:extLst>
          </p:cNvPr>
          <p:cNvSpPr txBox="1"/>
          <p:nvPr/>
        </p:nvSpPr>
        <p:spPr>
          <a:xfrm>
            <a:off x="439490" y="3801717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92148902-D6D2-CB3C-CDE1-A6C14D59CA6D}"/>
              </a:ext>
            </a:extLst>
          </p:cNvPr>
          <p:cNvSpPr txBox="1"/>
          <p:nvPr/>
        </p:nvSpPr>
        <p:spPr>
          <a:xfrm>
            <a:off x="5922797" y="3872266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6" name="グラフ 15">
            <a:extLst>
              <a:ext uri="{FF2B5EF4-FFF2-40B4-BE49-F238E27FC236}">
                <a16:creationId xmlns:a16="http://schemas.microsoft.com/office/drawing/2014/main" id="{B2BAC014-31A2-6324-8E76-613ABA4D88C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67181232"/>
              </p:ext>
            </p:extLst>
          </p:nvPr>
        </p:nvGraphicFramePr>
        <p:xfrm>
          <a:off x="425324" y="4132286"/>
          <a:ext cx="5093429" cy="237439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7" name="表 16">
            <a:extLst>
              <a:ext uri="{FF2B5EF4-FFF2-40B4-BE49-F238E27FC236}">
                <a16:creationId xmlns:a16="http://schemas.microsoft.com/office/drawing/2014/main" id="{D0BA9420-CAC8-3A24-B5D2-9AA5DD67CDD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63067783"/>
              </p:ext>
            </p:extLst>
          </p:nvPr>
        </p:nvGraphicFramePr>
        <p:xfrm>
          <a:off x="1054100" y="5937712"/>
          <a:ext cx="4283217" cy="874993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475913">
                  <a:extLst>
                    <a:ext uri="{9D8B030D-6E8A-4147-A177-3AD203B41FA5}">
                      <a16:colId xmlns:a16="http://schemas.microsoft.com/office/drawing/2014/main" val="3422794976"/>
                    </a:ext>
                  </a:extLst>
                </a:gridCol>
                <a:gridCol w="475913">
                  <a:extLst>
                    <a:ext uri="{9D8B030D-6E8A-4147-A177-3AD203B41FA5}">
                      <a16:colId xmlns:a16="http://schemas.microsoft.com/office/drawing/2014/main" val="620188338"/>
                    </a:ext>
                  </a:extLst>
                </a:gridCol>
                <a:gridCol w="475913">
                  <a:extLst>
                    <a:ext uri="{9D8B030D-6E8A-4147-A177-3AD203B41FA5}">
                      <a16:colId xmlns:a16="http://schemas.microsoft.com/office/drawing/2014/main" val="2579939869"/>
                    </a:ext>
                  </a:extLst>
                </a:gridCol>
                <a:gridCol w="475913">
                  <a:extLst>
                    <a:ext uri="{9D8B030D-6E8A-4147-A177-3AD203B41FA5}">
                      <a16:colId xmlns:a16="http://schemas.microsoft.com/office/drawing/2014/main" val="3235398182"/>
                    </a:ext>
                  </a:extLst>
                </a:gridCol>
                <a:gridCol w="475913">
                  <a:extLst>
                    <a:ext uri="{9D8B030D-6E8A-4147-A177-3AD203B41FA5}">
                      <a16:colId xmlns:a16="http://schemas.microsoft.com/office/drawing/2014/main" val="406615951"/>
                    </a:ext>
                  </a:extLst>
                </a:gridCol>
                <a:gridCol w="475913">
                  <a:extLst>
                    <a:ext uri="{9D8B030D-6E8A-4147-A177-3AD203B41FA5}">
                      <a16:colId xmlns:a16="http://schemas.microsoft.com/office/drawing/2014/main" val="3827752822"/>
                    </a:ext>
                  </a:extLst>
                </a:gridCol>
                <a:gridCol w="475913">
                  <a:extLst>
                    <a:ext uri="{9D8B030D-6E8A-4147-A177-3AD203B41FA5}">
                      <a16:colId xmlns:a16="http://schemas.microsoft.com/office/drawing/2014/main" val="1194600762"/>
                    </a:ext>
                  </a:extLst>
                </a:gridCol>
                <a:gridCol w="475913">
                  <a:extLst>
                    <a:ext uri="{9D8B030D-6E8A-4147-A177-3AD203B41FA5}">
                      <a16:colId xmlns:a16="http://schemas.microsoft.com/office/drawing/2014/main" val="4280193212"/>
                    </a:ext>
                  </a:extLst>
                </a:gridCol>
                <a:gridCol w="475913">
                  <a:extLst>
                    <a:ext uri="{9D8B030D-6E8A-4147-A177-3AD203B41FA5}">
                      <a16:colId xmlns:a16="http://schemas.microsoft.com/office/drawing/2014/main" val="1903458294"/>
                    </a:ext>
                  </a:extLst>
                </a:gridCol>
              </a:tblGrid>
              <a:tr h="28800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vert="eaVert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5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vert="eaVert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vert="eaVert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5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vert="eaVert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vert="eaVert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vert="eaVert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0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vert="eaVert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5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vert="eaVert"/>
                </a:tc>
                <a:tc rowSpan="2">
                  <a:txBody>
                    <a:bodyPr/>
                    <a:lstStyle/>
                    <a:p>
                      <a:pPr algn="l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gardless of age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vert="eaVert" anchor="b"/>
                </a:tc>
                <a:extLst>
                  <a:ext uri="{0D108BD9-81ED-4DB2-BD59-A6C34878D82A}">
                    <a16:rowId xmlns:a16="http://schemas.microsoft.com/office/drawing/2014/main" val="2472263343"/>
                  </a:ext>
                </a:extLst>
              </a:tr>
              <a:tr h="586993">
                <a:tc gridSpan="8"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 (in years)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/>
                      <a:endParaRPr kumimoji="1" lang="ja-JP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vert="eaVert" anchor="b"/>
                </a:tc>
                <a:tc hMerge="1">
                  <a:txBody>
                    <a:bodyPr/>
                    <a:lstStyle/>
                    <a:p>
                      <a:pPr algn="l"/>
                      <a:endParaRPr kumimoji="1" lang="ja-JP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vert="eaVert" anchor="b"/>
                </a:tc>
                <a:tc hMerge="1">
                  <a:txBody>
                    <a:bodyPr/>
                    <a:lstStyle/>
                    <a:p>
                      <a:pPr algn="l"/>
                      <a:endParaRPr kumimoji="1" lang="ja-JP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vert="eaVert" anchor="b"/>
                </a:tc>
                <a:tc hMerge="1">
                  <a:txBody>
                    <a:bodyPr/>
                    <a:lstStyle/>
                    <a:p>
                      <a:pPr algn="l"/>
                      <a:endParaRPr kumimoji="1" lang="ja-JP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vert="eaVert" anchor="b"/>
                </a:tc>
                <a:tc hMerge="1">
                  <a:txBody>
                    <a:bodyPr/>
                    <a:lstStyle/>
                    <a:p>
                      <a:pPr algn="l"/>
                      <a:endParaRPr kumimoji="1" lang="ja-JP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vert="eaVert" anchor="b"/>
                </a:tc>
                <a:tc hMerge="1">
                  <a:txBody>
                    <a:bodyPr/>
                    <a:lstStyle/>
                    <a:p>
                      <a:pPr algn="l"/>
                      <a:endParaRPr kumimoji="1" lang="ja-JP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vert="eaVert" anchor="b"/>
                </a:tc>
                <a:tc hMerge="1">
                  <a:txBody>
                    <a:bodyPr/>
                    <a:lstStyle/>
                    <a:p>
                      <a:pPr algn="l"/>
                      <a:endParaRPr kumimoji="1" lang="ja-JP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vert="eaVert" anchor="b"/>
                </a:tc>
                <a:tc vMerge="1">
                  <a:txBody>
                    <a:bodyPr/>
                    <a:lstStyle/>
                    <a:p>
                      <a:pPr algn="l"/>
                      <a:endParaRPr kumimoji="1" lang="ja-JP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vert="eaVert" anchor="b"/>
                </a:tc>
                <a:extLst>
                  <a:ext uri="{0D108BD9-81ED-4DB2-BD59-A6C34878D82A}">
                    <a16:rowId xmlns:a16="http://schemas.microsoft.com/office/drawing/2014/main" val="2821932262"/>
                  </a:ext>
                </a:extLst>
              </a:tr>
            </a:tbl>
          </a:graphicData>
        </a:graphic>
      </p:graphicFrame>
      <p:graphicFrame>
        <p:nvGraphicFramePr>
          <p:cNvPr id="19" name="グラフ 18">
            <a:extLst>
              <a:ext uri="{FF2B5EF4-FFF2-40B4-BE49-F238E27FC236}">
                <a16:creationId xmlns:a16="http://schemas.microsoft.com/office/drawing/2014/main" id="{21B71298-6BBA-558B-37B6-E38EA92BD07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16585166"/>
              </p:ext>
            </p:extLst>
          </p:nvPr>
        </p:nvGraphicFramePr>
        <p:xfrm>
          <a:off x="6252453" y="3920984"/>
          <a:ext cx="5514223" cy="24800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0B2FA269-7177-B730-DE9C-894960861670}"/>
              </a:ext>
            </a:extLst>
          </p:cNvPr>
          <p:cNvSpPr txBox="1"/>
          <p:nvPr/>
        </p:nvSpPr>
        <p:spPr>
          <a:xfrm>
            <a:off x="8495414" y="6558685"/>
            <a:ext cx="369658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Yes/No *; “Yes” for the facility, but “no” for self. 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7458504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D75BE66-CB7C-30CC-8260-C25633412A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6FFE7-A03F-4AA2-A8F2-22E89E0B9218}" type="slidenum">
              <a:rPr kumimoji="1" lang="ja-JP" altLang="en-US" smtClean="0"/>
              <a:t>5</a:t>
            </a:fld>
            <a:endParaRPr kumimoji="1" lang="ja-JP" altLang="en-US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130D1A66-4CB6-D4DB-E6F7-F5283F92195E}"/>
              </a:ext>
            </a:extLst>
          </p:cNvPr>
          <p:cNvSpPr txBox="1"/>
          <p:nvPr/>
        </p:nvSpPr>
        <p:spPr>
          <a:xfrm>
            <a:off x="208348" y="50491"/>
            <a:ext cx="1182251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</a:t>
            </a:r>
            <a:r>
              <a: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.</a:t>
            </a:r>
            <a:r>
              <a: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partments offering OMC based on patient survey results </a:t>
            </a:r>
          </a:p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Departments where online medical care is provided to the group with OMC experience; (b) Departments where online medical care would be acceptable in the group with no OMC experience.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8" name="表 7">
            <a:extLst>
              <a:ext uri="{FF2B5EF4-FFF2-40B4-BE49-F238E27FC236}">
                <a16:creationId xmlns:a16="http://schemas.microsoft.com/office/drawing/2014/main" id="{28703510-0429-15C3-CFB1-B93134C951D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33563588"/>
              </p:ext>
            </p:extLst>
          </p:nvPr>
        </p:nvGraphicFramePr>
        <p:xfrm>
          <a:off x="208347" y="1322114"/>
          <a:ext cx="11895192" cy="1589252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1188000">
                  <a:extLst>
                    <a:ext uri="{9D8B030D-6E8A-4147-A177-3AD203B41FA5}">
                      <a16:colId xmlns:a16="http://schemas.microsoft.com/office/drawing/2014/main" val="1384944710"/>
                    </a:ext>
                  </a:extLst>
                </a:gridCol>
                <a:gridCol w="892266">
                  <a:extLst>
                    <a:ext uri="{9D8B030D-6E8A-4147-A177-3AD203B41FA5}">
                      <a16:colId xmlns:a16="http://schemas.microsoft.com/office/drawing/2014/main" val="2586723824"/>
                    </a:ext>
                  </a:extLst>
                </a:gridCol>
                <a:gridCol w="892266">
                  <a:extLst>
                    <a:ext uri="{9D8B030D-6E8A-4147-A177-3AD203B41FA5}">
                      <a16:colId xmlns:a16="http://schemas.microsoft.com/office/drawing/2014/main" val="849471502"/>
                    </a:ext>
                  </a:extLst>
                </a:gridCol>
                <a:gridCol w="892266">
                  <a:extLst>
                    <a:ext uri="{9D8B030D-6E8A-4147-A177-3AD203B41FA5}">
                      <a16:colId xmlns:a16="http://schemas.microsoft.com/office/drawing/2014/main" val="904551147"/>
                    </a:ext>
                  </a:extLst>
                </a:gridCol>
                <a:gridCol w="892266">
                  <a:extLst>
                    <a:ext uri="{9D8B030D-6E8A-4147-A177-3AD203B41FA5}">
                      <a16:colId xmlns:a16="http://schemas.microsoft.com/office/drawing/2014/main" val="219093612"/>
                    </a:ext>
                  </a:extLst>
                </a:gridCol>
                <a:gridCol w="892266">
                  <a:extLst>
                    <a:ext uri="{9D8B030D-6E8A-4147-A177-3AD203B41FA5}">
                      <a16:colId xmlns:a16="http://schemas.microsoft.com/office/drawing/2014/main" val="3916788027"/>
                    </a:ext>
                  </a:extLst>
                </a:gridCol>
                <a:gridCol w="892266">
                  <a:extLst>
                    <a:ext uri="{9D8B030D-6E8A-4147-A177-3AD203B41FA5}">
                      <a16:colId xmlns:a16="http://schemas.microsoft.com/office/drawing/2014/main" val="1884068194"/>
                    </a:ext>
                  </a:extLst>
                </a:gridCol>
                <a:gridCol w="892266">
                  <a:extLst>
                    <a:ext uri="{9D8B030D-6E8A-4147-A177-3AD203B41FA5}">
                      <a16:colId xmlns:a16="http://schemas.microsoft.com/office/drawing/2014/main" val="1939123899"/>
                    </a:ext>
                  </a:extLst>
                </a:gridCol>
                <a:gridCol w="892266">
                  <a:extLst>
                    <a:ext uri="{9D8B030D-6E8A-4147-A177-3AD203B41FA5}">
                      <a16:colId xmlns:a16="http://schemas.microsoft.com/office/drawing/2014/main" val="3415022886"/>
                    </a:ext>
                  </a:extLst>
                </a:gridCol>
                <a:gridCol w="892266">
                  <a:extLst>
                    <a:ext uri="{9D8B030D-6E8A-4147-A177-3AD203B41FA5}">
                      <a16:colId xmlns:a16="http://schemas.microsoft.com/office/drawing/2014/main" val="3775755986"/>
                    </a:ext>
                  </a:extLst>
                </a:gridCol>
                <a:gridCol w="892266">
                  <a:extLst>
                    <a:ext uri="{9D8B030D-6E8A-4147-A177-3AD203B41FA5}">
                      <a16:colId xmlns:a16="http://schemas.microsoft.com/office/drawing/2014/main" val="795646341"/>
                    </a:ext>
                  </a:extLst>
                </a:gridCol>
                <a:gridCol w="892266">
                  <a:extLst>
                    <a:ext uri="{9D8B030D-6E8A-4147-A177-3AD203B41FA5}">
                      <a16:colId xmlns:a16="http://schemas.microsoft.com/office/drawing/2014/main" val="1987347456"/>
                    </a:ext>
                  </a:extLst>
                </a:gridCol>
                <a:gridCol w="892266">
                  <a:extLst>
                    <a:ext uri="{9D8B030D-6E8A-4147-A177-3AD203B41FA5}">
                      <a16:colId xmlns:a16="http://schemas.microsoft.com/office/drawing/2014/main" val="1803500371"/>
                    </a:ext>
                  </a:extLst>
                </a:gridCol>
              </a:tblGrid>
              <a:tr h="1202616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ernal medicin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rgery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diatric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bstetrics &amp; Gynecology / Reproductive Medicin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ychiatry / Psychosomatic Medicin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rmatology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hthalmology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tolaryngology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rology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thopedic surgery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astic / </a:t>
                      </a:r>
                    </a:p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smetic </a:t>
                      </a:r>
                    </a:p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rgery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ther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02138722"/>
                  </a:ext>
                </a:extLst>
              </a:tr>
              <a:tr h="1933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ith regular visit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.7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3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2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0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1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1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8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0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2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5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9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2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4013083407"/>
                  </a:ext>
                </a:extLst>
              </a:tr>
              <a:tr h="1933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ithout regular visit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7.2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9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7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9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4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6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7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4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0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2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4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7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/>
                </a:tc>
                <a:extLst>
                  <a:ext uri="{0D108BD9-81ED-4DB2-BD59-A6C34878D82A}">
                    <a16:rowId xmlns:a16="http://schemas.microsoft.com/office/drawing/2014/main" val="1494783831"/>
                  </a:ext>
                </a:extLst>
              </a:tr>
            </a:tbl>
          </a:graphicData>
        </a:graphic>
      </p:graphicFrame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6C033484-D4E2-83B5-F958-98F512517C9D}"/>
              </a:ext>
            </a:extLst>
          </p:cNvPr>
          <p:cNvSpPr txBox="1"/>
          <p:nvPr/>
        </p:nvSpPr>
        <p:spPr>
          <a:xfrm>
            <a:off x="236093" y="976718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F483EE95-BF45-E05D-395B-B7DC93C6208B}"/>
              </a:ext>
            </a:extLst>
          </p:cNvPr>
          <p:cNvSpPr txBox="1"/>
          <p:nvPr/>
        </p:nvSpPr>
        <p:spPr>
          <a:xfrm>
            <a:off x="236093" y="3365194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1" name="表 10">
            <a:extLst>
              <a:ext uri="{FF2B5EF4-FFF2-40B4-BE49-F238E27FC236}">
                <a16:creationId xmlns:a16="http://schemas.microsoft.com/office/drawing/2014/main" id="{A8358AC6-2835-E20A-3D0C-20F0474F09B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93833977"/>
              </p:ext>
            </p:extLst>
          </p:nvPr>
        </p:nvGraphicFramePr>
        <p:xfrm>
          <a:off x="208347" y="3946635"/>
          <a:ext cx="11895188" cy="1518928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1122188">
                  <a:extLst>
                    <a:ext uri="{9D8B030D-6E8A-4147-A177-3AD203B41FA5}">
                      <a16:colId xmlns:a16="http://schemas.microsoft.com/office/drawing/2014/main" val="1686408461"/>
                    </a:ext>
                  </a:extLst>
                </a:gridCol>
                <a:gridCol w="897750">
                  <a:extLst>
                    <a:ext uri="{9D8B030D-6E8A-4147-A177-3AD203B41FA5}">
                      <a16:colId xmlns:a16="http://schemas.microsoft.com/office/drawing/2014/main" val="2590285705"/>
                    </a:ext>
                  </a:extLst>
                </a:gridCol>
                <a:gridCol w="897750">
                  <a:extLst>
                    <a:ext uri="{9D8B030D-6E8A-4147-A177-3AD203B41FA5}">
                      <a16:colId xmlns:a16="http://schemas.microsoft.com/office/drawing/2014/main" val="3654532015"/>
                    </a:ext>
                  </a:extLst>
                </a:gridCol>
                <a:gridCol w="897750">
                  <a:extLst>
                    <a:ext uri="{9D8B030D-6E8A-4147-A177-3AD203B41FA5}">
                      <a16:colId xmlns:a16="http://schemas.microsoft.com/office/drawing/2014/main" val="3538063733"/>
                    </a:ext>
                  </a:extLst>
                </a:gridCol>
                <a:gridCol w="897750">
                  <a:extLst>
                    <a:ext uri="{9D8B030D-6E8A-4147-A177-3AD203B41FA5}">
                      <a16:colId xmlns:a16="http://schemas.microsoft.com/office/drawing/2014/main" val="1720313569"/>
                    </a:ext>
                  </a:extLst>
                </a:gridCol>
                <a:gridCol w="897750">
                  <a:extLst>
                    <a:ext uri="{9D8B030D-6E8A-4147-A177-3AD203B41FA5}">
                      <a16:colId xmlns:a16="http://schemas.microsoft.com/office/drawing/2014/main" val="3370765684"/>
                    </a:ext>
                  </a:extLst>
                </a:gridCol>
                <a:gridCol w="897750">
                  <a:extLst>
                    <a:ext uri="{9D8B030D-6E8A-4147-A177-3AD203B41FA5}">
                      <a16:colId xmlns:a16="http://schemas.microsoft.com/office/drawing/2014/main" val="263116267"/>
                    </a:ext>
                  </a:extLst>
                </a:gridCol>
                <a:gridCol w="897750">
                  <a:extLst>
                    <a:ext uri="{9D8B030D-6E8A-4147-A177-3AD203B41FA5}">
                      <a16:colId xmlns:a16="http://schemas.microsoft.com/office/drawing/2014/main" val="3763799430"/>
                    </a:ext>
                  </a:extLst>
                </a:gridCol>
                <a:gridCol w="897750">
                  <a:extLst>
                    <a:ext uri="{9D8B030D-6E8A-4147-A177-3AD203B41FA5}">
                      <a16:colId xmlns:a16="http://schemas.microsoft.com/office/drawing/2014/main" val="3225600896"/>
                    </a:ext>
                  </a:extLst>
                </a:gridCol>
                <a:gridCol w="897750">
                  <a:extLst>
                    <a:ext uri="{9D8B030D-6E8A-4147-A177-3AD203B41FA5}">
                      <a16:colId xmlns:a16="http://schemas.microsoft.com/office/drawing/2014/main" val="2606825899"/>
                    </a:ext>
                  </a:extLst>
                </a:gridCol>
                <a:gridCol w="897750">
                  <a:extLst>
                    <a:ext uri="{9D8B030D-6E8A-4147-A177-3AD203B41FA5}">
                      <a16:colId xmlns:a16="http://schemas.microsoft.com/office/drawing/2014/main" val="1776152581"/>
                    </a:ext>
                  </a:extLst>
                </a:gridCol>
                <a:gridCol w="897750">
                  <a:extLst>
                    <a:ext uri="{9D8B030D-6E8A-4147-A177-3AD203B41FA5}">
                      <a16:colId xmlns:a16="http://schemas.microsoft.com/office/drawing/2014/main" val="690129238"/>
                    </a:ext>
                  </a:extLst>
                </a:gridCol>
                <a:gridCol w="897750">
                  <a:extLst>
                    <a:ext uri="{9D8B030D-6E8A-4147-A177-3AD203B41FA5}">
                      <a16:colId xmlns:a16="http://schemas.microsoft.com/office/drawing/2014/main" val="4275540072"/>
                    </a:ext>
                  </a:extLst>
                </a:gridCol>
              </a:tblGrid>
              <a:tr h="1086928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313" marR="4313" marT="431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ernal medicin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rgery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diatric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bstetrics &amp; Gynecology / Reproductive Medicin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ychiatry / Psychosomatic Medicin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rmatology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hthalmology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tolaryngology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rology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thopedic surgery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astic / </a:t>
                      </a:r>
                    </a:p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smetic </a:t>
                      </a:r>
                    </a:p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rgery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e </a:t>
                      </a:r>
                    </a:p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at apply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23265591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ith regular visit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313" marR="4313" marT="4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.8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6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0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9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.0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2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0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5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5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8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9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.6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347093787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hout regular visit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313" marR="4313" marT="4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.3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9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2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3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3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.6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9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0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7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0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1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3.0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13" marR="4313" marT="4313" marB="0" anchor="ctr"/>
                </a:tc>
                <a:extLst>
                  <a:ext uri="{0D108BD9-81ED-4DB2-BD59-A6C34878D82A}">
                    <a16:rowId xmlns:a16="http://schemas.microsoft.com/office/drawing/2014/main" val="340410969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47223879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702DA34B-FBB6-4119-268A-3800DAE2E3BD}"/>
              </a:ext>
            </a:extLst>
          </p:cNvPr>
          <p:cNvSpPr txBox="1"/>
          <p:nvPr/>
        </p:nvSpPr>
        <p:spPr>
          <a:xfrm>
            <a:off x="208348" y="50491"/>
            <a:ext cx="11822519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</a:t>
            </a:r>
            <a:r>
              <a: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Patient satisfaction rates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OMC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Satisfaction rating on a 4-point scale; (b) Stratified analysis according to age; (c) Stratified analysis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cording to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number of nearby medical facilities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 Stratified analysis </a:t>
            </a:r>
            <a:r>
              <a:rPr lang="en-IN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ed on whether they felt visiting medical facilities required considerable effort.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e) Stratified analysis by whether they felt OMC reduces patient burden. (b), (c), (d), and (e) show the percentage of respondents who selected “very satisfied” or “generally satisfied.”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7" name="表 6">
            <a:extLst>
              <a:ext uri="{FF2B5EF4-FFF2-40B4-BE49-F238E27FC236}">
                <a16:creationId xmlns:a16="http://schemas.microsoft.com/office/drawing/2014/main" id="{85A572AF-58E1-E39B-BB66-AC53D0A52D5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2583490"/>
              </p:ext>
            </p:extLst>
          </p:nvPr>
        </p:nvGraphicFramePr>
        <p:xfrm>
          <a:off x="225099" y="1616792"/>
          <a:ext cx="8397904" cy="914400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1875820">
                  <a:extLst>
                    <a:ext uri="{9D8B030D-6E8A-4147-A177-3AD203B41FA5}">
                      <a16:colId xmlns:a16="http://schemas.microsoft.com/office/drawing/2014/main" val="2032926440"/>
                    </a:ext>
                  </a:extLst>
                </a:gridCol>
                <a:gridCol w="1630521">
                  <a:extLst>
                    <a:ext uri="{9D8B030D-6E8A-4147-A177-3AD203B41FA5}">
                      <a16:colId xmlns:a16="http://schemas.microsoft.com/office/drawing/2014/main" val="3953792906"/>
                    </a:ext>
                  </a:extLst>
                </a:gridCol>
                <a:gridCol w="1630521">
                  <a:extLst>
                    <a:ext uri="{9D8B030D-6E8A-4147-A177-3AD203B41FA5}">
                      <a16:colId xmlns:a16="http://schemas.microsoft.com/office/drawing/2014/main" val="3352469935"/>
                    </a:ext>
                  </a:extLst>
                </a:gridCol>
                <a:gridCol w="1630521">
                  <a:extLst>
                    <a:ext uri="{9D8B030D-6E8A-4147-A177-3AD203B41FA5}">
                      <a16:colId xmlns:a16="http://schemas.microsoft.com/office/drawing/2014/main" val="2041529833"/>
                    </a:ext>
                  </a:extLst>
                </a:gridCol>
                <a:gridCol w="1630521">
                  <a:extLst>
                    <a:ext uri="{9D8B030D-6E8A-4147-A177-3AD203B41FA5}">
                      <a16:colId xmlns:a16="http://schemas.microsoft.com/office/drawing/2014/main" val="4221438499"/>
                    </a:ext>
                  </a:extLst>
                </a:gridCol>
              </a:tblGrid>
              <a:tr h="228600"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ery satisfied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rally satisfied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t very satisfied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t satisfied at all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407557151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21147958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ith RV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3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.7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4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7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684458525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ithout RV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6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.1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9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4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410522609"/>
                  </a:ext>
                </a:extLst>
              </a:tr>
            </a:tbl>
          </a:graphicData>
        </a:graphic>
      </p:graphicFrame>
      <p:graphicFrame>
        <p:nvGraphicFramePr>
          <p:cNvPr id="8" name="表 7">
            <a:extLst>
              <a:ext uri="{FF2B5EF4-FFF2-40B4-BE49-F238E27FC236}">
                <a16:creationId xmlns:a16="http://schemas.microsoft.com/office/drawing/2014/main" id="{EDDD0DB6-0B88-1F7E-B63B-8CAF505D1BB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17863373"/>
              </p:ext>
            </p:extLst>
          </p:nvPr>
        </p:nvGraphicFramePr>
        <p:xfrm>
          <a:off x="225100" y="3134439"/>
          <a:ext cx="3513045" cy="1118870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1066585">
                  <a:extLst>
                    <a:ext uri="{9D8B030D-6E8A-4147-A177-3AD203B41FA5}">
                      <a16:colId xmlns:a16="http://schemas.microsoft.com/office/drawing/2014/main" val="461475860"/>
                    </a:ext>
                  </a:extLst>
                </a:gridCol>
                <a:gridCol w="927109">
                  <a:extLst>
                    <a:ext uri="{9D8B030D-6E8A-4147-A177-3AD203B41FA5}">
                      <a16:colId xmlns:a16="http://schemas.microsoft.com/office/drawing/2014/main" val="2425456823"/>
                    </a:ext>
                  </a:extLst>
                </a:gridCol>
                <a:gridCol w="927109">
                  <a:extLst>
                    <a:ext uri="{9D8B030D-6E8A-4147-A177-3AD203B41FA5}">
                      <a16:colId xmlns:a16="http://schemas.microsoft.com/office/drawing/2014/main" val="2889855148"/>
                    </a:ext>
                  </a:extLst>
                </a:gridCol>
                <a:gridCol w="592242">
                  <a:extLst>
                    <a:ext uri="{9D8B030D-6E8A-4147-A177-3AD203B41FA5}">
                      <a16:colId xmlns:a16="http://schemas.microsoft.com/office/drawing/2014/main" val="1750006383"/>
                    </a:ext>
                  </a:extLst>
                </a:gridCol>
              </a:tblGrid>
              <a:tr h="228600"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 ˂ 60 years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 ≥ 60 years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40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value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95479910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</a:t>
                      </a:r>
                      <a:endParaRPr lang="en-US" altLang="ja-JP" sz="14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</a:t>
                      </a:r>
                      <a:endParaRPr lang="en-US" altLang="ja-JP" sz="14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43056891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ith RV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8.2</a:t>
                      </a:r>
                      <a:endParaRPr lang="en-US" altLang="ja-JP" sz="14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6.9</a:t>
                      </a:r>
                      <a:endParaRPr lang="en-US" altLang="ja-JP" sz="14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66</a:t>
                      </a:r>
                      <a:endParaRPr lang="en-US" altLang="ja-JP" sz="14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504893707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ithout RV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1.4</a:t>
                      </a:r>
                      <a:endParaRPr lang="en-US" altLang="ja-JP" sz="14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8</a:t>
                      </a:r>
                      <a:endParaRPr lang="en-US" altLang="ja-JP" sz="14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3</a:t>
                      </a:r>
                      <a:endParaRPr lang="en-US" altLang="ja-JP" sz="14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760686816"/>
                  </a:ext>
                </a:extLst>
              </a:tr>
            </a:tbl>
          </a:graphicData>
        </a:graphic>
      </p:graphicFrame>
      <p:graphicFrame>
        <p:nvGraphicFramePr>
          <p:cNvPr id="9" name="表 8">
            <a:extLst>
              <a:ext uri="{FF2B5EF4-FFF2-40B4-BE49-F238E27FC236}">
                <a16:creationId xmlns:a16="http://schemas.microsoft.com/office/drawing/2014/main" id="{3BB8C85A-3B88-877B-A0D7-A4F166BC0CD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71710223"/>
              </p:ext>
            </p:extLst>
          </p:nvPr>
        </p:nvGraphicFramePr>
        <p:xfrm>
          <a:off x="3918140" y="3123627"/>
          <a:ext cx="3785947" cy="1347470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1149440">
                  <a:extLst>
                    <a:ext uri="{9D8B030D-6E8A-4147-A177-3AD203B41FA5}">
                      <a16:colId xmlns:a16="http://schemas.microsoft.com/office/drawing/2014/main" val="981506531"/>
                    </a:ext>
                  </a:extLst>
                </a:gridCol>
                <a:gridCol w="999129">
                  <a:extLst>
                    <a:ext uri="{9D8B030D-6E8A-4147-A177-3AD203B41FA5}">
                      <a16:colId xmlns:a16="http://schemas.microsoft.com/office/drawing/2014/main" val="769272771"/>
                    </a:ext>
                  </a:extLst>
                </a:gridCol>
                <a:gridCol w="999129">
                  <a:extLst>
                    <a:ext uri="{9D8B030D-6E8A-4147-A177-3AD203B41FA5}">
                      <a16:colId xmlns:a16="http://schemas.microsoft.com/office/drawing/2014/main" val="3150178632"/>
                    </a:ext>
                  </a:extLst>
                </a:gridCol>
                <a:gridCol w="638249">
                  <a:extLst>
                    <a:ext uri="{9D8B030D-6E8A-4147-A177-3AD203B41FA5}">
                      <a16:colId xmlns:a16="http://schemas.microsoft.com/office/drawing/2014/main" val="196134240"/>
                    </a:ext>
                  </a:extLst>
                </a:gridCol>
              </a:tblGrid>
              <a:tr h="228600"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No. of </a:t>
                      </a:r>
                    </a:p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edical facilities nearby</a:t>
                      </a: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4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value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9464632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ny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ss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vMerge="1">
                  <a:txBody>
                    <a:bodyPr/>
                    <a:lstStyle/>
                    <a:p>
                      <a:endParaRPr dirty="0"/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17234217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25421020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ith RV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8.8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.4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3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479748324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ithout RV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4.7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.9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.01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963499490"/>
                  </a:ext>
                </a:extLst>
              </a:tr>
            </a:tbl>
          </a:graphicData>
        </a:graphic>
      </p:graphicFrame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BFDDB08B-596D-0F3F-44EB-C70B9B5EFCB1}"/>
              </a:ext>
            </a:extLst>
          </p:cNvPr>
          <p:cNvSpPr txBox="1"/>
          <p:nvPr/>
        </p:nvSpPr>
        <p:spPr>
          <a:xfrm>
            <a:off x="208348" y="1373930"/>
            <a:ext cx="2872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43EBA927-63A4-B673-E101-AD82A7A8A31E}"/>
              </a:ext>
            </a:extLst>
          </p:cNvPr>
          <p:cNvSpPr txBox="1"/>
          <p:nvPr/>
        </p:nvSpPr>
        <p:spPr>
          <a:xfrm>
            <a:off x="225098" y="2765107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2C3F18A0-A290-CAAA-860E-8203C71AE3FD}"/>
              </a:ext>
            </a:extLst>
          </p:cNvPr>
          <p:cNvSpPr txBox="1"/>
          <p:nvPr/>
        </p:nvSpPr>
        <p:spPr>
          <a:xfrm>
            <a:off x="3918137" y="2768452"/>
            <a:ext cx="2872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EF237027-CD11-F7E1-D4EA-892F0AE1FF6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50861385"/>
              </p:ext>
            </p:extLst>
          </p:nvPr>
        </p:nvGraphicFramePr>
        <p:xfrm>
          <a:off x="7900285" y="3119278"/>
          <a:ext cx="4073027" cy="1347470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1236599">
                  <a:extLst>
                    <a:ext uri="{9D8B030D-6E8A-4147-A177-3AD203B41FA5}">
                      <a16:colId xmlns:a16="http://schemas.microsoft.com/office/drawing/2014/main" val="461475860"/>
                    </a:ext>
                  </a:extLst>
                </a:gridCol>
                <a:gridCol w="1074891">
                  <a:extLst>
                    <a:ext uri="{9D8B030D-6E8A-4147-A177-3AD203B41FA5}">
                      <a16:colId xmlns:a16="http://schemas.microsoft.com/office/drawing/2014/main" val="2425456823"/>
                    </a:ext>
                  </a:extLst>
                </a:gridCol>
                <a:gridCol w="1074891">
                  <a:extLst>
                    <a:ext uri="{9D8B030D-6E8A-4147-A177-3AD203B41FA5}">
                      <a16:colId xmlns:a16="http://schemas.microsoft.com/office/drawing/2014/main" val="2889855148"/>
                    </a:ext>
                  </a:extLst>
                </a:gridCol>
                <a:gridCol w="686646">
                  <a:extLst>
                    <a:ext uri="{9D8B030D-6E8A-4147-A177-3AD203B41FA5}">
                      <a16:colId xmlns:a16="http://schemas.microsoft.com/office/drawing/2014/main" val="1750006383"/>
                    </a:ext>
                  </a:extLst>
                </a:gridCol>
              </a:tblGrid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altLang="ja-JP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  <a:p>
                      <a:pPr algn="l" fontAlgn="ctr"/>
                      <a:endParaRPr lang="ja-JP" alt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Visiting medical facilities </a:t>
                      </a:r>
                    </a:p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requires considerable effort</a:t>
                      </a: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40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value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2157547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s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No</a:t>
                      </a: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vMerge="1">
                  <a:txBody>
                    <a:bodyPr/>
                    <a:lstStyle/>
                    <a:p>
                      <a:endParaRPr dirty="0"/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95479910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</a:t>
                      </a:r>
                      <a:endParaRPr lang="en-US" altLang="ja-JP" sz="14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</a:t>
                      </a:r>
                      <a:endParaRPr lang="en-US" altLang="ja-JP" sz="14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43056891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ith RV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3.1</a:t>
                      </a: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8.9</a:t>
                      </a: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&lt;.01</a:t>
                      </a: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504893707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ithout RV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7.1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7.9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&lt;.01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760686816"/>
                  </a:ext>
                </a:extLst>
              </a:tr>
            </a:tbl>
          </a:graphicData>
        </a:graphic>
      </p:graphicFrame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67B72C89-0CEB-CC1D-836D-EBD38DBF9A0F}"/>
              </a:ext>
            </a:extLst>
          </p:cNvPr>
          <p:cNvSpPr txBox="1"/>
          <p:nvPr/>
        </p:nvSpPr>
        <p:spPr>
          <a:xfrm>
            <a:off x="7903829" y="2723966"/>
            <a:ext cx="1872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652749DF-A8BC-FB45-A8D0-15539EE63AB5}"/>
              </a:ext>
            </a:extLst>
          </p:cNvPr>
          <p:cNvSpPr txBox="1"/>
          <p:nvPr/>
        </p:nvSpPr>
        <p:spPr>
          <a:xfrm>
            <a:off x="241847" y="4554616"/>
            <a:ext cx="2872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6" name="表 15">
            <a:extLst>
              <a:ext uri="{FF2B5EF4-FFF2-40B4-BE49-F238E27FC236}">
                <a16:creationId xmlns:a16="http://schemas.microsoft.com/office/drawing/2014/main" id="{7AC91AB0-FFD8-0285-FE94-DC94D1074CE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9321949"/>
              </p:ext>
            </p:extLst>
          </p:nvPr>
        </p:nvGraphicFramePr>
        <p:xfrm>
          <a:off x="241847" y="4974298"/>
          <a:ext cx="11741805" cy="1344930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1027209">
                  <a:extLst>
                    <a:ext uri="{9D8B030D-6E8A-4147-A177-3AD203B41FA5}">
                      <a16:colId xmlns:a16="http://schemas.microsoft.com/office/drawing/2014/main" val="2032926440"/>
                    </a:ext>
                  </a:extLst>
                </a:gridCol>
                <a:gridCol w="892883">
                  <a:extLst>
                    <a:ext uri="{9D8B030D-6E8A-4147-A177-3AD203B41FA5}">
                      <a16:colId xmlns:a16="http://schemas.microsoft.com/office/drawing/2014/main" val="3953792906"/>
                    </a:ext>
                  </a:extLst>
                </a:gridCol>
                <a:gridCol w="892883">
                  <a:extLst>
                    <a:ext uri="{9D8B030D-6E8A-4147-A177-3AD203B41FA5}">
                      <a16:colId xmlns:a16="http://schemas.microsoft.com/office/drawing/2014/main" val="3352469935"/>
                    </a:ext>
                  </a:extLst>
                </a:gridCol>
                <a:gridCol w="892883">
                  <a:extLst>
                    <a:ext uri="{9D8B030D-6E8A-4147-A177-3AD203B41FA5}">
                      <a16:colId xmlns:a16="http://schemas.microsoft.com/office/drawing/2014/main" val="2041529833"/>
                    </a:ext>
                  </a:extLst>
                </a:gridCol>
                <a:gridCol w="892883">
                  <a:extLst>
                    <a:ext uri="{9D8B030D-6E8A-4147-A177-3AD203B41FA5}">
                      <a16:colId xmlns:a16="http://schemas.microsoft.com/office/drawing/2014/main" val="4221438499"/>
                    </a:ext>
                  </a:extLst>
                </a:gridCol>
                <a:gridCol w="892883">
                  <a:extLst>
                    <a:ext uri="{9D8B030D-6E8A-4147-A177-3AD203B41FA5}">
                      <a16:colId xmlns:a16="http://schemas.microsoft.com/office/drawing/2014/main" val="3150289115"/>
                    </a:ext>
                  </a:extLst>
                </a:gridCol>
                <a:gridCol w="892883">
                  <a:extLst>
                    <a:ext uri="{9D8B030D-6E8A-4147-A177-3AD203B41FA5}">
                      <a16:colId xmlns:a16="http://schemas.microsoft.com/office/drawing/2014/main" val="1102935063"/>
                    </a:ext>
                  </a:extLst>
                </a:gridCol>
                <a:gridCol w="892883">
                  <a:extLst>
                    <a:ext uri="{9D8B030D-6E8A-4147-A177-3AD203B41FA5}">
                      <a16:colId xmlns:a16="http://schemas.microsoft.com/office/drawing/2014/main" val="1053083612"/>
                    </a:ext>
                  </a:extLst>
                </a:gridCol>
                <a:gridCol w="892883">
                  <a:extLst>
                    <a:ext uri="{9D8B030D-6E8A-4147-A177-3AD203B41FA5}">
                      <a16:colId xmlns:a16="http://schemas.microsoft.com/office/drawing/2014/main" val="3856821615"/>
                    </a:ext>
                  </a:extLst>
                </a:gridCol>
                <a:gridCol w="892883">
                  <a:extLst>
                    <a:ext uri="{9D8B030D-6E8A-4147-A177-3AD203B41FA5}">
                      <a16:colId xmlns:a16="http://schemas.microsoft.com/office/drawing/2014/main" val="839594554"/>
                    </a:ext>
                  </a:extLst>
                </a:gridCol>
                <a:gridCol w="892883">
                  <a:extLst>
                    <a:ext uri="{9D8B030D-6E8A-4147-A177-3AD203B41FA5}">
                      <a16:colId xmlns:a16="http://schemas.microsoft.com/office/drawing/2014/main" val="4059585570"/>
                    </a:ext>
                  </a:extLst>
                </a:gridCol>
                <a:gridCol w="892883">
                  <a:extLst>
                    <a:ext uri="{9D8B030D-6E8A-4147-A177-3AD203B41FA5}">
                      <a16:colId xmlns:a16="http://schemas.microsoft.com/office/drawing/2014/main" val="2395624352"/>
                    </a:ext>
                  </a:extLst>
                </a:gridCol>
                <a:gridCol w="892883">
                  <a:extLst>
                    <a:ext uri="{9D8B030D-6E8A-4147-A177-3AD203B41FA5}">
                      <a16:colId xmlns:a16="http://schemas.microsoft.com/office/drawing/2014/main" val="464086190"/>
                    </a:ext>
                  </a:extLst>
                </a:gridCol>
              </a:tblGrid>
              <a:tr h="178260"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 gridSpan="1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OMC reduces patient burden regarding medical visits</a:t>
                      </a: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4188743194"/>
                  </a:ext>
                </a:extLst>
              </a:tr>
              <a:tr h="178260"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Time burden</a:t>
                      </a: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hysical burden</a:t>
                      </a: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ental burden</a:t>
                      </a: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Financial burden</a:t>
                      </a: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755959375"/>
                  </a:ext>
                </a:extLst>
              </a:tr>
              <a:tr h="178260"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s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value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s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value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s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value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s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value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407557151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</a:t>
                      </a:r>
                      <a:endParaRPr lang="en-US" altLang="ja-JP" sz="14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</a:t>
                      </a:r>
                      <a:endParaRPr lang="en-US" altLang="ja-JP" sz="14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4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</a:t>
                      </a:r>
                      <a:endParaRPr lang="en-US" altLang="ja-JP" sz="14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</a:t>
                      </a:r>
                      <a:endParaRPr lang="en-US" altLang="ja-JP" sz="14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4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</a:t>
                      </a:r>
                      <a:endParaRPr lang="en-US" altLang="ja-JP" sz="14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</a:t>
                      </a:r>
                      <a:endParaRPr lang="en-US" altLang="ja-JP" sz="14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4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</a:t>
                      </a:r>
                      <a:endParaRPr lang="en-US" altLang="ja-JP" sz="14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</a:t>
                      </a:r>
                      <a:endParaRPr lang="en-US" altLang="ja-JP" sz="14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4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21147958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ith RV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2.3</a:t>
                      </a: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5.0</a:t>
                      </a: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&lt;.01</a:t>
                      </a: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3.6</a:t>
                      </a: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6.0</a:t>
                      </a: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&lt;.01</a:t>
                      </a: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6.5</a:t>
                      </a: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7.1</a:t>
                      </a: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&lt;.01</a:t>
                      </a: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2.1</a:t>
                      </a: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3.6</a:t>
                      </a: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&lt;.01</a:t>
                      </a: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684458525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ithout RV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7.0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6.7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&lt;.01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6.5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7.5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&lt;.01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8.9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4.5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&lt;.01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5.5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5.4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&lt;.01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410522609"/>
                  </a:ext>
                </a:extLst>
              </a:tr>
            </a:tbl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551FE3A-F40E-B251-235F-1F728B92A30B}"/>
              </a:ext>
            </a:extLst>
          </p:cNvPr>
          <p:cNvSpPr txBox="1"/>
          <p:nvPr/>
        </p:nvSpPr>
        <p:spPr>
          <a:xfrm>
            <a:off x="9271590" y="6453963"/>
            <a:ext cx="118333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V: regular visits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8090253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E2F589C-9EB6-0338-9D3E-530EA047952F}"/>
              </a:ext>
            </a:extLst>
          </p:cNvPr>
          <p:cNvSpPr txBox="1"/>
          <p:nvPr/>
        </p:nvSpPr>
        <p:spPr>
          <a:xfrm>
            <a:off x="208348" y="50491"/>
            <a:ext cx="1182251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</a:t>
            </a:r>
            <a:r>
              <a: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OMC from the perspective of medical personnels </a:t>
            </a:r>
          </a:p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mplexity of hospital operations in implementing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MC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mpared to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MC;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) Comparison of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 number of patients that can be seen per unit of time (OMC vs. FMC).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466F0568-3A7B-7290-36C7-B348A9785D3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0675327"/>
              </p:ext>
            </p:extLst>
          </p:nvPr>
        </p:nvGraphicFramePr>
        <p:xfrm>
          <a:off x="225098" y="1678242"/>
          <a:ext cx="10756668" cy="1576070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2012038">
                  <a:extLst>
                    <a:ext uri="{9D8B030D-6E8A-4147-A177-3AD203B41FA5}">
                      <a16:colId xmlns:a16="http://schemas.microsoft.com/office/drawing/2014/main" val="2032926440"/>
                    </a:ext>
                  </a:extLst>
                </a:gridCol>
                <a:gridCol w="1748926">
                  <a:extLst>
                    <a:ext uri="{9D8B030D-6E8A-4147-A177-3AD203B41FA5}">
                      <a16:colId xmlns:a16="http://schemas.microsoft.com/office/drawing/2014/main" val="3953792906"/>
                    </a:ext>
                  </a:extLst>
                </a:gridCol>
                <a:gridCol w="1748926">
                  <a:extLst>
                    <a:ext uri="{9D8B030D-6E8A-4147-A177-3AD203B41FA5}">
                      <a16:colId xmlns:a16="http://schemas.microsoft.com/office/drawing/2014/main" val="3352469935"/>
                    </a:ext>
                  </a:extLst>
                </a:gridCol>
                <a:gridCol w="1748926">
                  <a:extLst>
                    <a:ext uri="{9D8B030D-6E8A-4147-A177-3AD203B41FA5}">
                      <a16:colId xmlns:a16="http://schemas.microsoft.com/office/drawing/2014/main" val="2467049707"/>
                    </a:ext>
                  </a:extLst>
                </a:gridCol>
                <a:gridCol w="1748926">
                  <a:extLst>
                    <a:ext uri="{9D8B030D-6E8A-4147-A177-3AD203B41FA5}">
                      <a16:colId xmlns:a16="http://schemas.microsoft.com/office/drawing/2014/main" val="2041529833"/>
                    </a:ext>
                  </a:extLst>
                </a:gridCol>
                <a:gridCol w="1748926">
                  <a:extLst>
                    <a:ext uri="{9D8B030D-6E8A-4147-A177-3AD203B41FA5}">
                      <a16:colId xmlns:a16="http://schemas.microsoft.com/office/drawing/2014/main" val="4221438499"/>
                    </a:ext>
                  </a:extLst>
                </a:gridCol>
              </a:tblGrid>
              <a:tr h="228600"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bviously more complicated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mewhat more complicated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lmost</a:t>
                      </a:r>
                    </a:p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the same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omewhat </a:t>
                      </a:r>
                    </a:p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ore simple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Obviously </a:t>
                      </a:r>
                    </a:p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ore simple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407557151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N (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N (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N (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N (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N (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21147958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5 (24.2)</a:t>
                      </a: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3 (44.6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5 (18.8)</a:t>
                      </a: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4 (7.5)</a:t>
                      </a: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 (4.8)</a:t>
                      </a: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684458525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  Doctor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7 (41.5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 (7.7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6 (24.6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 (13.8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 (12.3)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410522609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  Nurse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 (9.1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5 (45.5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1 (33.3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 (9.1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 (3)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190336187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  Medical clerk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5 (34.9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8 (41.9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 (18.6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 (4.7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 (0)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280598040"/>
                  </a:ext>
                </a:extLst>
              </a:tr>
            </a:tbl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A4D268E-33B8-3CEE-8CA2-B5CFD38AC7C2}"/>
              </a:ext>
            </a:extLst>
          </p:cNvPr>
          <p:cNvSpPr txBox="1"/>
          <p:nvPr/>
        </p:nvSpPr>
        <p:spPr>
          <a:xfrm>
            <a:off x="225098" y="1242995"/>
            <a:ext cx="2872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C902AB43-C779-F2AE-DF2B-1228AF0E716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74688309"/>
              </p:ext>
            </p:extLst>
          </p:nvPr>
        </p:nvGraphicFramePr>
        <p:xfrm>
          <a:off x="208348" y="4186385"/>
          <a:ext cx="7258816" cy="1371600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2012038">
                  <a:extLst>
                    <a:ext uri="{9D8B030D-6E8A-4147-A177-3AD203B41FA5}">
                      <a16:colId xmlns:a16="http://schemas.microsoft.com/office/drawing/2014/main" val="2032926440"/>
                    </a:ext>
                  </a:extLst>
                </a:gridCol>
                <a:gridCol w="1748926">
                  <a:extLst>
                    <a:ext uri="{9D8B030D-6E8A-4147-A177-3AD203B41FA5}">
                      <a16:colId xmlns:a16="http://schemas.microsoft.com/office/drawing/2014/main" val="3953792906"/>
                    </a:ext>
                  </a:extLst>
                </a:gridCol>
                <a:gridCol w="1748926">
                  <a:extLst>
                    <a:ext uri="{9D8B030D-6E8A-4147-A177-3AD203B41FA5}">
                      <a16:colId xmlns:a16="http://schemas.microsoft.com/office/drawing/2014/main" val="3352469935"/>
                    </a:ext>
                  </a:extLst>
                </a:gridCol>
                <a:gridCol w="1748926">
                  <a:extLst>
                    <a:ext uri="{9D8B030D-6E8A-4147-A177-3AD203B41FA5}">
                      <a16:colId xmlns:a16="http://schemas.microsoft.com/office/drawing/2014/main" val="2467049707"/>
                    </a:ext>
                  </a:extLst>
                </a:gridCol>
              </a:tblGrid>
              <a:tr h="228600"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ore than F-to-F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lmost the same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ess than F-to-F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407557151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N (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N (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N (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21147958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6 (14)</a:t>
                      </a: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8 (41.9)</a:t>
                      </a: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2 (44.1)</a:t>
                      </a: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684458525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  Doctor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8 (16.4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7 (42.7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5 (40.9)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410522609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  Nurse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 (9.1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8 (54.5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2 (36.4)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190336187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  Medical clerks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 (11.6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3 (30.2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5 (58.1)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280598040"/>
                  </a:ext>
                </a:extLst>
              </a:tr>
            </a:tbl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BEA69F26-AFC0-E742-B2EB-8E01F42C33DB}"/>
              </a:ext>
            </a:extLst>
          </p:cNvPr>
          <p:cNvSpPr txBox="1"/>
          <p:nvPr/>
        </p:nvSpPr>
        <p:spPr>
          <a:xfrm>
            <a:off x="225098" y="380205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7436604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7541D245-5A39-7E9D-C271-838A24C8896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19071805"/>
              </p:ext>
            </p:extLst>
          </p:nvPr>
        </p:nvGraphicFramePr>
        <p:xfrm>
          <a:off x="-55164" y="1161360"/>
          <a:ext cx="12247164" cy="4351985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6480000">
                  <a:extLst>
                    <a:ext uri="{9D8B030D-6E8A-4147-A177-3AD203B41FA5}">
                      <a16:colId xmlns:a16="http://schemas.microsoft.com/office/drawing/2014/main" val="3089147923"/>
                    </a:ext>
                  </a:extLst>
                </a:gridCol>
                <a:gridCol w="480597">
                  <a:extLst>
                    <a:ext uri="{9D8B030D-6E8A-4147-A177-3AD203B41FA5}">
                      <a16:colId xmlns:a16="http://schemas.microsoft.com/office/drawing/2014/main" val="122121467"/>
                    </a:ext>
                  </a:extLst>
                </a:gridCol>
                <a:gridCol w="480597">
                  <a:extLst>
                    <a:ext uri="{9D8B030D-6E8A-4147-A177-3AD203B41FA5}">
                      <a16:colId xmlns:a16="http://schemas.microsoft.com/office/drawing/2014/main" val="179035160"/>
                    </a:ext>
                  </a:extLst>
                </a:gridCol>
                <a:gridCol w="480597">
                  <a:extLst>
                    <a:ext uri="{9D8B030D-6E8A-4147-A177-3AD203B41FA5}">
                      <a16:colId xmlns:a16="http://schemas.microsoft.com/office/drawing/2014/main" val="1417806838"/>
                    </a:ext>
                  </a:extLst>
                </a:gridCol>
                <a:gridCol w="480597">
                  <a:extLst>
                    <a:ext uri="{9D8B030D-6E8A-4147-A177-3AD203B41FA5}">
                      <a16:colId xmlns:a16="http://schemas.microsoft.com/office/drawing/2014/main" val="3326418471"/>
                    </a:ext>
                  </a:extLst>
                </a:gridCol>
                <a:gridCol w="480597">
                  <a:extLst>
                    <a:ext uri="{9D8B030D-6E8A-4147-A177-3AD203B41FA5}">
                      <a16:colId xmlns:a16="http://schemas.microsoft.com/office/drawing/2014/main" val="3505955526"/>
                    </a:ext>
                  </a:extLst>
                </a:gridCol>
                <a:gridCol w="480597">
                  <a:extLst>
                    <a:ext uri="{9D8B030D-6E8A-4147-A177-3AD203B41FA5}">
                      <a16:colId xmlns:a16="http://schemas.microsoft.com/office/drawing/2014/main" val="497291825"/>
                    </a:ext>
                  </a:extLst>
                </a:gridCol>
                <a:gridCol w="480597">
                  <a:extLst>
                    <a:ext uri="{9D8B030D-6E8A-4147-A177-3AD203B41FA5}">
                      <a16:colId xmlns:a16="http://schemas.microsoft.com/office/drawing/2014/main" val="1554532490"/>
                    </a:ext>
                  </a:extLst>
                </a:gridCol>
                <a:gridCol w="480597">
                  <a:extLst>
                    <a:ext uri="{9D8B030D-6E8A-4147-A177-3AD203B41FA5}">
                      <a16:colId xmlns:a16="http://schemas.microsoft.com/office/drawing/2014/main" val="2910341738"/>
                    </a:ext>
                  </a:extLst>
                </a:gridCol>
                <a:gridCol w="480597">
                  <a:extLst>
                    <a:ext uri="{9D8B030D-6E8A-4147-A177-3AD203B41FA5}">
                      <a16:colId xmlns:a16="http://schemas.microsoft.com/office/drawing/2014/main" val="74023131"/>
                    </a:ext>
                  </a:extLst>
                </a:gridCol>
                <a:gridCol w="480597">
                  <a:extLst>
                    <a:ext uri="{9D8B030D-6E8A-4147-A177-3AD203B41FA5}">
                      <a16:colId xmlns:a16="http://schemas.microsoft.com/office/drawing/2014/main" val="3184582578"/>
                    </a:ext>
                  </a:extLst>
                </a:gridCol>
                <a:gridCol w="480597">
                  <a:extLst>
                    <a:ext uri="{9D8B030D-6E8A-4147-A177-3AD203B41FA5}">
                      <a16:colId xmlns:a16="http://schemas.microsoft.com/office/drawing/2014/main" val="2274216369"/>
                    </a:ext>
                  </a:extLst>
                </a:gridCol>
                <a:gridCol w="480597">
                  <a:extLst>
                    <a:ext uri="{9D8B030D-6E8A-4147-A177-3AD203B41FA5}">
                      <a16:colId xmlns:a16="http://schemas.microsoft.com/office/drawing/2014/main" val="3737352175"/>
                    </a:ext>
                  </a:extLst>
                </a:gridCol>
              </a:tblGrid>
              <a:tr h="240108">
                <a:tc>
                  <a:txBody>
                    <a:bodyPr/>
                    <a:lstStyle/>
                    <a:p>
                      <a:pPr algn="l" fontAlgn="b"/>
                      <a:endParaRPr lang="ja-JP" alt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00" marR="4900" marT="4900" marB="0" anchor="b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L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ctr"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C practice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ob category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ospital category</a:t>
                      </a:r>
                      <a:endParaRPr lang="en-US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inic category</a:t>
                      </a:r>
                      <a:endParaRPr lang="en-US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69163653"/>
                  </a:ext>
                </a:extLst>
              </a:tr>
              <a:tr h="447608">
                <a:tc>
                  <a:txBody>
                    <a:bodyPr/>
                    <a:lstStyle/>
                    <a:p>
                      <a:pPr algn="l" fontAlgn="b"/>
                      <a:endParaRPr lang="ja-JP" alt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00" marR="4900" marT="4900" marB="0" anchor="b"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s/No *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s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octor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rse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erical work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F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RA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thers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A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thers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ctr"/>
                </a:tc>
                <a:extLst>
                  <a:ext uri="{0D108BD9-81ED-4DB2-BD59-A6C34878D82A}">
                    <a16:rowId xmlns:a16="http://schemas.microsoft.com/office/drawing/2014/main" val="3385597515"/>
                  </a:ext>
                </a:extLst>
              </a:tr>
              <a:tr h="190800">
                <a:tc>
                  <a:txBody>
                    <a:bodyPr/>
                    <a:lstStyle/>
                    <a:p>
                      <a:pPr algn="l" fontAlgn="b"/>
                      <a:endParaRPr lang="ja-JP" alt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00" marR="4900" marT="490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39323176"/>
                  </a:ext>
                </a:extLst>
              </a:tr>
              <a:tr h="19080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. OMC increases administrative procedures on the part of medical institutions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000" marR="4740" marT="474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.5 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.1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.9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3.6 </a:t>
                      </a:r>
                      <a:endParaRPr lang="en-US" altLang="ja-JP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.4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.8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.6</a:t>
                      </a:r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.8</a:t>
                      </a:r>
                      <a:endParaRPr lang="en-US" altLang="ja-JP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.0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.3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.3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6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038995881"/>
                  </a:ext>
                </a:extLst>
              </a:tr>
              <a:tr h="19080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. OMC requires more time and effort on the part of physicians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000" marR="4740" marT="47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.6 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.3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4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.7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.2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.3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0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.3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3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.2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4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.8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extLst>
                  <a:ext uri="{0D108BD9-81ED-4DB2-BD59-A6C34878D82A}">
                    <a16:rowId xmlns:a16="http://schemas.microsoft.com/office/drawing/2014/main" val="14903245"/>
                  </a:ext>
                </a:extLst>
              </a:tr>
              <a:tr h="19080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 OMC requires more time and effort on the part of the patient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000" marR="4740" marT="47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.5 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.8 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4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.8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8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.2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.9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.0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.5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8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.1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6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extLst>
                  <a:ext uri="{0D108BD9-81ED-4DB2-BD59-A6C34878D82A}">
                    <a16:rowId xmlns:a16="http://schemas.microsoft.com/office/drawing/2014/main" val="220138123"/>
                  </a:ext>
                </a:extLst>
              </a:tr>
              <a:tr h="19080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. OMC places a heavy financial burden on the medical institution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000" marR="4740" marT="47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.5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.0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8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.0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3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8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.5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.8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.3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.4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.5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.6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extLst>
                  <a:ext uri="{0D108BD9-81ED-4DB2-BD59-A6C34878D82A}">
                    <a16:rowId xmlns:a16="http://schemas.microsoft.com/office/drawing/2014/main" val="2416822721"/>
                  </a:ext>
                </a:extLst>
              </a:tr>
              <a:tr h="19080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. OMC imposes a heavy financial burden on patients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000" marR="4740" marT="47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0 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5 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3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8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7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4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9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0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4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6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1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3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extLst>
                  <a:ext uri="{0D108BD9-81ED-4DB2-BD59-A6C34878D82A}">
                    <a16:rowId xmlns:a16="http://schemas.microsoft.com/office/drawing/2014/main" val="1084063037"/>
                  </a:ext>
                </a:extLst>
              </a:tr>
              <a:tr h="19080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. Difficult for the medical institution to construct a system and communication environment for OMC.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000" marR="4740" marT="47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.2</a:t>
                      </a:r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.8</a:t>
                      </a:r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.4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.2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.7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3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.7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.5</a:t>
                      </a:r>
                      <a:endParaRPr lang="en-US" altLang="ja-JP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.6</a:t>
                      </a:r>
                      <a:endParaRPr lang="en-US" altLang="ja-JP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.5</a:t>
                      </a:r>
                      <a:endParaRPr lang="en-US" altLang="ja-JP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.9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.2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extLst>
                  <a:ext uri="{0D108BD9-81ED-4DB2-BD59-A6C34878D82A}">
                    <a16:rowId xmlns:a16="http://schemas.microsoft.com/office/drawing/2014/main" val="105701626"/>
                  </a:ext>
                </a:extLst>
              </a:tr>
              <a:tr h="19080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. Difficult for patients to download applications and build a communication environment for OMC.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000" marR="4740" marT="47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6.7 </a:t>
                      </a:r>
                      <a:endParaRPr lang="en-US" altLang="ja-JP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7.3 </a:t>
                      </a:r>
                      <a:endParaRPr lang="en-US" altLang="ja-JP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7.8 </a:t>
                      </a:r>
                      <a:endParaRPr lang="en-US" altLang="ja-JP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2.2 </a:t>
                      </a:r>
                      <a:endParaRPr lang="en-US" altLang="ja-JP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1.6 </a:t>
                      </a:r>
                      <a:endParaRPr lang="en-US" altLang="ja-JP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1.0 </a:t>
                      </a:r>
                      <a:endParaRPr lang="en-US" altLang="ja-JP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9.3</a:t>
                      </a:r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1.3</a:t>
                      </a:r>
                      <a:endParaRPr lang="en-US" altLang="ja-JP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5.2</a:t>
                      </a:r>
                      <a:endParaRPr lang="en-US" altLang="ja-JP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9.7</a:t>
                      </a:r>
                      <a:endParaRPr lang="en-US" altLang="ja-JP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8.5</a:t>
                      </a:r>
                      <a:endParaRPr lang="en-US" altLang="ja-JP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1.4</a:t>
                      </a:r>
                      <a:endParaRPr lang="en-US" altLang="ja-JP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61513561"/>
                  </a:ext>
                </a:extLst>
              </a:tr>
              <a:tr h="19080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.</a:t>
                      </a:r>
                      <a:r>
                        <a:rPr lang="en-IN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oncerns regarding the adequacy of the clinical examination during OMC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000" marR="4740" marT="47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.4 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.9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9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.6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1.3 </a:t>
                      </a:r>
                      <a:endParaRPr lang="en-US" altLang="ja-JP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.7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.3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.5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.7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.9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.1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.6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extLst>
                  <a:ext uri="{0D108BD9-81ED-4DB2-BD59-A6C34878D82A}">
                    <a16:rowId xmlns:a16="http://schemas.microsoft.com/office/drawing/2014/main" val="3172621436"/>
                  </a:ext>
                </a:extLst>
              </a:tr>
              <a:tr h="229869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. </a:t>
                      </a:r>
                      <a:r>
                        <a:rPr lang="en-IN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ce-to-face communication is easier than online interaction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000" marR="4740" marT="47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0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.4 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.8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.0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3.5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.8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1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.5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1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.9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.1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.0</a:t>
                      </a:r>
                      <a:endParaRPr lang="en-US" altLang="ja-JP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7174998"/>
                  </a:ext>
                </a:extLst>
              </a:tr>
              <a:tr h="19080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. OMC requires patients to visit hospitals for undergoing tests or procedures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000" marR="4740" marT="47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8.4 </a:t>
                      </a:r>
                      <a:endParaRPr lang="en-US" altLang="ja-JP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.1 </a:t>
                      </a:r>
                      <a:endParaRPr lang="en-US" altLang="ja-JP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6.3 </a:t>
                      </a:r>
                      <a:endParaRPr lang="en-US" altLang="ja-JP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8.4</a:t>
                      </a:r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6.3 </a:t>
                      </a:r>
                      <a:endParaRPr lang="en-US" altLang="ja-JP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1.9</a:t>
                      </a:r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7.9</a:t>
                      </a:r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.5</a:t>
                      </a:r>
                      <a:endParaRPr lang="en-US" altLang="ja-JP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.6</a:t>
                      </a:r>
                      <a:endParaRPr lang="en-US" altLang="ja-JP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8.2</a:t>
                      </a:r>
                      <a:endParaRPr lang="en-US" altLang="ja-JP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6.8</a:t>
                      </a:r>
                      <a:endParaRPr lang="en-US" altLang="ja-JP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1.1</a:t>
                      </a:r>
                      <a:endParaRPr lang="en-US" altLang="ja-JP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38201340"/>
                  </a:ext>
                </a:extLst>
              </a:tr>
              <a:tr h="19080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.</a:t>
                      </a:r>
                      <a:r>
                        <a:rPr lang="en-IN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OMC may not be feasible for a larger proportion of patients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000" marR="4740" marT="47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.7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0 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.3 </a:t>
                      </a:r>
                      <a:endParaRPr lang="en-US" altLang="ja-JP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1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.4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.4 </a:t>
                      </a:r>
                      <a:endParaRPr lang="en-US" altLang="ja-JP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.4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.0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.9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.9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.2</a:t>
                      </a:r>
                      <a:endParaRPr lang="en-US" altLang="ja-JP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3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extLst>
                  <a:ext uri="{0D108BD9-81ED-4DB2-BD59-A6C34878D82A}">
                    <a16:rowId xmlns:a16="http://schemas.microsoft.com/office/drawing/2014/main" val="2203650027"/>
                  </a:ext>
                </a:extLst>
              </a:tr>
              <a:tr h="19080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. Concerns regarding breach of personal information through OMC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000" marR="4740" marT="47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.2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.4 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3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.0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.2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.8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3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.5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.4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0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2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.6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extLst>
                  <a:ext uri="{0D108BD9-81ED-4DB2-BD59-A6C34878D82A}">
                    <a16:rowId xmlns:a16="http://schemas.microsoft.com/office/drawing/2014/main" val="3299738231"/>
                  </a:ext>
                </a:extLst>
              </a:tr>
              <a:tr h="19080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. FMC is preferable to OMC for the education of medical students and young doctors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000" marR="4740" marT="47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0 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9 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5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8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9 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6 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1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5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3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1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6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6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extLst>
                  <a:ext uri="{0D108BD9-81ED-4DB2-BD59-A6C34878D82A}">
                    <a16:rowId xmlns:a16="http://schemas.microsoft.com/office/drawing/2014/main" val="2958756605"/>
                  </a:ext>
                </a:extLst>
              </a:tr>
              <a:tr h="19080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. Lack of awareness regarding OMC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000" marR="4740" marT="47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0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2 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.8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1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8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.3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6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.3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8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3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5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2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extLst>
                  <a:ext uri="{0D108BD9-81ED-4DB2-BD59-A6C34878D82A}">
                    <a16:rowId xmlns:a16="http://schemas.microsoft.com/office/drawing/2014/main" val="156994850"/>
                  </a:ext>
                </a:extLst>
              </a:tr>
              <a:tr h="19080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. </a:t>
                      </a:r>
                      <a:r>
                        <a:rPr lang="en-IN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spite being aware, lack of clarity </a:t>
                      </a:r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hen OMC is appropriate or desired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000" marR="4740" marT="47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.9 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.9 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.7 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.7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7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.6 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7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.3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.8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.5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3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9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extLst>
                  <a:ext uri="{0D108BD9-81ED-4DB2-BD59-A6C34878D82A}">
                    <a16:rowId xmlns:a16="http://schemas.microsoft.com/office/drawing/2014/main" val="1540673251"/>
                  </a:ext>
                </a:extLst>
              </a:tr>
              <a:tr h="19080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 </a:t>
                      </a:r>
                      <a:r>
                        <a:rPr lang="en-IN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ck of information on OMC providers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000" marR="4740" marT="47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0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8 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.8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7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5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.6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0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.3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.6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6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1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9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extLst>
                  <a:ext uri="{0D108BD9-81ED-4DB2-BD59-A6C34878D82A}">
                    <a16:rowId xmlns:a16="http://schemas.microsoft.com/office/drawing/2014/main" val="2288804198"/>
                  </a:ext>
                </a:extLst>
              </a:tr>
              <a:tr h="19080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. Because the level of satisfaction with FMC is high and many people do not need OMC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000" marR="4740" marT="47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.3 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.8 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.3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.7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.9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.5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.4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8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.7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.4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4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.4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extLst>
                  <a:ext uri="{0D108BD9-81ED-4DB2-BD59-A6C34878D82A}">
                    <a16:rowId xmlns:a16="http://schemas.microsoft.com/office/drawing/2014/main" val="2201513134"/>
                  </a:ext>
                </a:extLst>
              </a:tr>
              <a:tr h="19080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. Regardless of the level of satisfaction with FMC, people tend to maintain the status quo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000" marR="4740" marT="47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7 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3 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3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.7 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.6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6 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.6 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.3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.0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3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0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2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00" marR="4900" marT="4900" marB="0" anchor="b"/>
                </a:tc>
                <a:extLst>
                  <a:ext uri="{0D108BD9-81ED-4DB2-BD59-A6C34878D82A}">
                    <a16:rowId xmlns:a16="http://schemas.microsoft.com/office/drawing/2014/main" val="2454147153"/>
                  </a:ext>
                </a:extLst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21B64282-EC36-E0E1-B08D-DE017A2B90F3}"/>
              </a:ext>
            </a:extLst>
          </p:cNvPr>
          <p:cNvSpPr txBox="1"/>
          <p:nvPr/>
        </p:nvSpPr>
        <p:spPr>
          <a:xfrm>
            <a:off x="306598" y="6344850"/>
            <a:ext cx="11885402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RA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core hospital </a:t>
            </a:r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medical services in remote areas; 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F, hospital with specific function; </a:t>
            </a:r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A, clinics for medical services in remote areas; 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-to-F, face-to-face; OMC, </a:t>
            </a:r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line medical care. Yes/No *; “yes” for the facility, but “no” for self. Top three in each category are shown in bold and gray background.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07EBA0DE-9DDA-FCF9-3977-A2192742D599}"/>
              </a:ext>
            </a:extLst>
          </p:cNvPr>
          <p:cNvSpPr txBox="1"/>
          <p:nvPr/>
        </p:nvSpPr>
        <p:spPr>
          <a:xfrm>
            <a:off x="95587" y="329855"/>
            <a:ext cx="951856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4. Factors hindering OMC expansion or adoption 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results of the medical personnels survey)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867216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26</TotalTime>
  <Words>1682</Words>
  <Application>Microsoft Office PowerPoint</Application>
  <PresentationFormat>ワイド画面</PresentationFormat>
  <Paragraphs>677</Paragraphs>
  <Slides>8</Slides>
  <Notes>2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8</vt:i4>
      </vt:variant>
    </vt:vector>
  </HeadingPairs>
  <TitlesOfParts>
    <vt:vector size="13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uka Sugawara-Niihori</dc:creator>
  <cp:lastModifiedBy>Yuka Sugawara-Niihori</cp:lastModifiedBy>
  <cp:revision>39</cp:revision>
  <cp:lastPrinted>2024-05-22T03:18:56Z</cp:lastPrinted>
  <dcterms:created xsi:type="dcterms:W3CDTF">2024-03-27T04:51:28Z</dcterms:created>
  <dcterms:modified xsi:type="dcterms:W3CDTF">2024-09-24T05:57:46Z</dcterms:modified>
</cp:coreProperties>
</file>